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notesSlides/notesSlide3.xml" ContentType="application/vnd.openxmlformats-officedocument.presentationml.notesSlide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drawings/drawing10.xml" ContentType="application/vnd.openxmlformats-officedocument.drawingml.chartshapes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notesMasterIdLst>
    <p:notesMasterId r:id="rId5"/>
  </p:notesMasterIdLst>
  <p:sldIdLst>
    <p:sldId id="260" r:id="rId2"/>
    <p:sldId id="265" r:id="rId3"/>
    <p:sldId id="267" r:id="rId4"/>
  </p:sldIdLst>
  <p:sldSz cx="14400213" cy="1079976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88DE7D8-8E2E-4088-B667-443D721BA08D}" v="27" dt="2026-03-08T17:39:18.2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6197"/>
  </p:normalViewPr>
  <p:slideViewPr>
    <p:cSldViewPr snapToGrid="0" snapToObjects="1">
      <p:cViewPr>
        <p:scale>
          <a:sx n="50" d="100"/>
          <a:sy n="50" d="100"/>
        </p:scale>
        <p:origin x="2526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lena Rudyk" userId="60c459c2-996e-48f7-b018-11285fe7a2eb" providerId="ADAL" clId="{498AAE6A-2918-484D-9BF0-285EC8FA181B}"/>
    <pc:docChg chg="undo custSel modSld">
      <pc:chgData name="Olena Rudyk" userId="60c459c2-996e-48f7-b018-11285fe7a2eb" providerId="ADAL" clId="{498AAE6A-2918-484D-9BF0-285EC8FA181B}" dt="2026-02-14T17:04:06.535" v="93" actId="20577"/>
      <pc:docMkLst>
        <pc:docMk/>
      </pc:docMkLst>
      <pc:sldChg chg="delSp modSp mod">
        <pc:chgData name="Olena Rudyk" userId="60c459c2-996e-48f7-b018-11285fe7a2eb" providerId="ADAL" clId="{498AAE6A-2918-484D-9BF0-285EC8FA181B}" dt="2026-02-14T17:04:06.535" v="93" actId="20577"/>
        <pc:sldMkLst>
          <pc:docMk/>
          <pc:sldMk cId="34210548" sldId="260"/>
        </pc:sldMkLst>
        <pc:spChg chg="mod">
          <ac:chgData name="Olena Rudyk" userId="60c459c2-996e-48f7-b018-11285fe7a2eb" providerId="ADAL" clId="{498AAE6A-2918-484D-9BF0-285EC8FA181B}" dt="2026-02-11T17:26:13.512" v="37" actId="553"/>
          <ac:spMkLst>
            <pc:docMk/>
            <pc:sldMk cId="34210548" sldId="260"/>
            <ac:spMk id="2" creationId="{CC7C091C-59EA-FC39-1A87-3560C71E7F29}"/>
          </ac:spMkLst>
        </pc:spChg>
        <pc:spChg chg="mod ord">
          <ac:chgData name="Olena Rudyk" userId="60c459c2-996e-48f7-b018-11285fe7a2eb" providerId="ADAL" clId="{498AAE6A-2918-484D-9BF0-285EC8FA181B}" dt="2026-02-14T17:04:06.535" v="93" actId="20577"/>
          <ac:spMkLst>
            <pc:docMk/>
            <pc:sldMk cId="34210548" sldId="260"/>
            <ac:spMk id="6" creationId="{D1DF5CC0-4EA9-2754-6194-0D057A6F62E3}"/>
          </ac:spMkLst>
        </pc:spChg>
        <pc:spChg chg="mod">
          <ac:chgData name="Olena Rudyk" userId="60c459c2-996e-48f7-b018-11285fe7a2eb" providerId="ADAL" clId="{498AAE6A-2918-484D-9BF0-285EC8FA181B}" dt="2026-02-11T17:26:32.089" v="72" actId="1035"/>
          <ac:spMkLst>
            <pc:docMk/>
            <pc:sldMk cId="34210548" sldId="260"/>
            <ac:spMk id="7" creationId="{5DBD0518-1365-6DD9-9465-CA053573226F}"/>
          </ac:spMkLst>
        </pc:spChg>
        <pc:spChg chg="mod">
          <ac:chgData name="Olena Rudyk" userId="60c459c2-996e-48f7-b018-11285fe7a2eb" providerId="ADAL" clId="{498AAE6A-2918-484D-9BF0-285EC8FA181B}" dt="2026-02-11T17:26:43.559" v="83" actId="1036"/>
          <ac:spMkLst>
            <pc:docMk/>
            <pc:sldMk cId="34210548" sldId="260"/>
            <ac:spMk id="9" creationId="{53420F68-52AB-DFEB-8540-43C3104819D3}"/>
          </ac:spMkLst>
        </pc:spChg>
        <pc:spChg chg="mod">
          <ac:chgData name="Olena Rudyk" userId="60c459c2-996e-48f7-b018-11285fe7a2eb" providerId="ADAL" clId="{498AAE6A-2918-484D-9BF0-285EC8FA181B}" dt="2026-02-11T17:26:43.559" v="83" actId="1036"/>
          <ac:spMkLst>
            <pc:docMk/>
            <pc:sldMk cId="34210548" sldId="260"/>
            <ac:spMk id="10" creationId="{F35D96FC-EED7-6E48-3B4E-EB712FE1B6A8}"/>
          </ac:spMkLst>
        </pc:spChg>
        <pc:spChg chg="mod">
          <ac:chgData name="Olena Rudyk" userId="60c459c2-996e-48f7-b018-11285fe7a2eb" providerId="ADAL" clId="{498AAE6A-2918-484D-9BF0-285EC8FA181B}" dt="2026-02-11T17:26:43.559" v="83" actId="1036"/>
          <ac:spMkLst>
            <pc:docMk/>
            <pc:sldMk cId="34210548" sldId="260"/>
            <ac:spMk id="14" creationId="{12370AD8-7031-0552-B7E4-F79487F61E1A}"/>
          </ac:spMkLst>
        </pc:spChg>
        <pc:spChg chg="mod">
          <ac:chgData name="Olena Rudyk" userId="60c459c2-996e-48f7-b018-11285fe7a2eb" providerId="ADAL" clId="{498AAE6A-2918-484D-9BF0-285EC8FA181B}" dt="2026-02-11T17:26:43.559" v="83" actId="1036"/>
          <ac:spMkLst>
            <pc:docMk/>
            <pc:sldMk cId="34210548" sldId="260"/>
            <ac:spMk id="26" creationId="{9892570B-672A-AE8E-D908-B7372F117898}"/>
          </ac:spMkLst>
        </pc:spChg>
        <pc:spChg chg="mod">
          <ac:chgData name="Olena Rudyk" userId="60c459c2-996e-48f7-b018-11285fe7a2eb" providerId="ADAL" clId="{498AAE6A-2918-484D-9BF0-285EC8FA181B}" dt="2026-02-11T17:26:43.559" v="83" actId="1036"/>
          <ac:spMkLst>
            <pc:docMk/>
            <pc:sldMk cId="34210548" sldId="260"/>
            <ac:spMk id="29" creationId="{13C53518-33F4-B69F-3F8A-7E915D426ED9}"/>
          </ac:spMkLst>
        </pc:spChg>
        <pc:spChg chg="mod">
          <ac:chgData name="Olena Rudyk" userId="60c459c2-996e-48f7-b018-11285fe7a2eb" providerId="ADAL" clId="{498AAE6A-2918-484D-9BF0-285EC8FA181B}" dt="2026-02-11T17:26:43.559" v="83" actId="1036"/>
          <ac:spMkLst>
            <pc:docMk/>
            <pc:sldMk cId="34210548" sldId="260"/>
            <ac:spMk id="31" creationId="{B5C74E5A-BB4D-6B86-F86E-40ED01117DF9}"/>
          </ac:spMkLst>
        </pc:spChg>
        <pc:spChg chg="mod">
          <ac:chgData name="Olena Rudyk" userId="60c459c2-996e-48f7-b018-11285fe7a2eb" providerId="ADAL" clId="{498AAE6A-2918-484D-9BF0-285EC8FA181B}" dt="2026-02-11T17:24:48.582" v="4" actId="552"/>
          <ac:spMkLst>
            <pc:docMk/>
            <pc:sldMk cId="34210548" sldId="260"/>
            <ac:spMk id="45" creationId="{A5C762D9-F81B-5742-E318-A0045B01458A}"/>
          </ac:spMkLst>
        </pc:spChg>
        <pc:spChg chg="mod">
          <ac:chgData name="Olena Rudyk" userId="60c459c2-996e-48f7-b018-11285fe7a2eb" providerId="ADAL" clId="{498AAE6A-2918-484D-9BF0-285EC8FA181B}" dt="2026-02-11T17:26:28.968" v="64" actId="1036"/>
          <ac:spMkLst>
            <pc:docMk/>
            <pc:sldMk cId="34210548" sldId="260"/>
            <ac:spMk id="81" creationId="{126850BA-E46D-4DE3-415D-2E3BCE690621}"/>
          </ac:spMkLst>
        </pc:spChg>
        <pc:spChg chg="mod">
          <ac:chgData name="Olena Rudyk" userId="60c459c2-996e-48f7-b018-11285fe7a2eb" providerId="ADAL" clId="{498AAE6A-2918-484D-9BF0-285EC8FA181B}" dt="2026-02-11T17:26:28.968" v="64" actId="1036"/>
          <ac:spMkLst>
            <pc:docMk/>
            <pc:sldMk cId="34210548" sldId="260"/>
            <ac:spMk id="85" creationId="{D3B49008-895E-9428-4816-771BF7C82CFE}"/>
          </ac:spMkLst>
        </pc:spChg>
        <pc:grpChg chg="mod">
          <ac:chgData name="Olena Rudyk" userId="60c459c2-996e-48f7-b018-11285fe7a2eb" providerId="ADAL" clId="{498AAE6A-2918-484D-9BF0-285EC8FA181B}" dt="2026-02-11T17:26:06.845" v="36" actId="1076"/>
          <ac:grpSpMkLst>
            <pc:docMk/>
            <pc:sldMk cId="34210548" sldId="260"/>
            <ac:grpSpMk id="73" creationId="{14B1D619-27EA-4A37-0ABA-2648A9F5D884}"/>
          </ac:grpSpMkLst>
        </pc:grpChg>
        <pc:grpChg chg="mod">
          <ac:chgData name="Olena Rudyk" userId="60c459c2-996e-48f7-b018-11285fe7a2eb" providerId="ADAL" clId="{498AAE6A-2918-484D-9BF0-285EC8FA181B}" dt="2026-02-11T17:26:06.845" v="36" actId="1076"/>
          <ac:grpSpMkLst>
            <pc:docMk/>
            <pc:sldMk cId="34210548" sldId="260"/>
            <ac:grpSpMk id="74" creationId="{C5FBD5A3-9CE6-569B-EC2F-09C12301A174}"/>
          </ac:grpSpMkLst>
        </pc:grpChg>
        <pc:grpChg chg="mod">
          <ac:chgData name="Olena Rudyk" userId="60c459c2-996e-48f7-b018-11285fe7a2eb" providerId="ADAL" clId="{498AAE6A-2918-484D-9BF0-285EC8FA181B}" dt="2026-02-11T17:26:06.845" v="36" actId="1076"/>
          <ac:grpSpMkLst>
            <pc:docMk/>
            <pc:sldMk cId="34210548" sldId="260"/>
            <ac:grpSpMk id="78" creationId="{1AAC8892-611B-3FFD-9279-D72802A6B2CD}"/>
          </ac:grpSpMkLst>
        </pc:grpChg>
        <pc:graphicFrameChg chg="mod">
          <ac:chgData name="Olena Rudyk" userId="60c459c2-996e-48f7-b018-11285fe7a2eb" providerId="ADAL" clId="{498AAE6A-2918-484D-9BF0-285EC8FA181B}" dt="2026-02-11T17:25:53.164" v="35" actId="1076"/>
          <ac:graphicFrameMkLst>
            <pc:docMk/>
            <pc:sldMk cId="34210548" sldId="260"/>
            <ac:graphicFrameMk id="35" creationId="{A6E770C1-57CD-DB07-A0FE-EE211DE14FC4}"/>
          </ac:graphicFrameMkLst>
        </pc:graphicFrameChg>
        <pc:graphicFrameChg chg="mod">
          <ac:chgData name="Olena Rudyk" userId="60c459c2-996e-48f7-b018-11285fe7a2eb" providerId="ADAL" clId="{498AAE6A-2918-484D-9BF0-285EC8FA181B}" dt="2026-02-11T17:26:28.968" v="64" actId="1036"/>
          <ac:graphicFrameMkLst>
            <pc:docMk/>
            <pc:sldMk cId="34210548" sldId="260"/>
            <ac:graphicFrameMk id="79" creationId="{FF7B2D4C-7C5D-68DA-421F-2F98BCF756F6}"/>
          </ac:graphicFrameMkLst>
        </pc:graphicFrameChg>
        <pc:graphicFrameChg chg="mod">
          <ac:chgData name="Olena Rudyk" userId="60c459c2-996e-48f7-b018-11285fe7a2eb" providerId="ADAL" clId="{498AAE6A-2918-484D-9BF0-285EC8FA181B}" dt="2026-02-11T17:26:28.968" v="64" actId="1036"/>
          <ac:graphicFrameMkLst>
            <pc:docMk/>
            <pc:sldMk cId="34210548" sldId="260"/>
            <ac:graphicFrameMk id="80" creationId="{39C64C61-082B-7CE8-3456-0E4F74494CBC}"/>
          </ac:graphicFrameMkLst>
        </pc:graphicFrameChg>
      </pc:sldChg>
      <pc:sldChg chg="modSp mod">
        <pc:chgData name="Olena Rudyk" userId="60c459c2-996e-48f7-b018-11285fe7a2eb" providerId="ADAL" clId="{498AAE6A-2918-484D-9BF0-285EC8FA181B}" dt="2026-02-11T17:30:22.363" v="88" actId="1036"/>
        <pc:sldMkLst>
          <pc:docMk/>
          <pc:sldMk cId="2255179181" sldId="265"/>
        </pc:sldMkLst>
        <pc:spChg chg="mod">
          <ac:chgData name="Olena Rudyk" userId="60c459c2-996e-48f7-b018-11285fe7a2eb" providerId="ADAL" clId="{498AAE6A-2918-484D-9BF0-285EC8FA181B}" dt="2026-02-11T17:30:22.363" v="88" actId="1036"/>
          <ac:spMkLst>
            <pc:docMk/>
            <pc:sldMk cId="2255179181" sldId="265"/>
            <ac:spMk id="8" creationId="{21A87EE8-9CFA-C455-D3BA-F929570729DB}"/>
          </ac:spMkLst>
        </pc:spChg>
        <pc:spChg chg="mod">
          <ac:chgData name="Olena Rudyk" userId="60c459c2-996e-48f7-b018-11285fe7a2eb" providerId="ADAL" clId="{498AAE6A-2918-484D-9BF0-285EC8FA181B}" dt="2026-02-11T17:30:22.363" v="88" actId="1036"/>
          <ac:spMkLst>
            <pc:docMk/>
            <pc:sldMk cId="2255179181" sldId="265"/>
            <ac:spMk id="9" creationId="{D8768DD3-CC74-1325-4DEE-9A28B2C9A338}"/>
          </ac:spMkLst>
        </pc:spChg>
        <pc:spChg chg="mod">
          <ac:chgData name="Olena Rudyk" userId="60c459c2-996e-48f7-b018-11285fe7a2eb" providerId="ADAL" clId="{498AAE6A-2918-484D-9BF0-285EC8FA181B}" dt="2026-02-11T17:30:22.363" v="88" actId="1036"/>
          <ac:spMkLst>
            <pc:docMk/>
            <pc:sldMk cId="2255179181" sldId="265"/>
            <ac:spMk id="10" creationId="{9C8CA39C-6125-F6A3-66BC-E3724E65FD85}"/>
          </ac:spMkLst>
        </pc:spChg>
        <pc:spChg chg="mod">
          <ac:chgData name="Olena Rudyk" userId="60c459c2-996e-48f7-b018-11285fe7a2eb" providerId="ADAL" clId="{498AAE6A-2918-484D-9BF0-285EC8FA181B}" dt="2026-02-11T17:30:22.363" v="88" actId="1036"/>
          <ac:spMkLst>
            <pc:docMk/>
            <pc:sldMk cId="2255179181" sldId="265"/>
            <ac:spMk id="14" creationId="{B8117BAC-0240-DA96-1D4B-053CA5D7E8D7}"/>
          </ac:spMkLst>
        </pc:spChg>
        <pc:spChg chg="mod">
          <ac:chgData name="Olena Rudyk" userId="60c459c2-996e-48f7-b018-11285fe7a2eb" providerId="ADAL" clId="{498AAE6A-2918-484D-9BF0-285EC8FA181B}" dt="2026-02-11T17:30:22.363" v="88" actId="1036"/>
          <ac:spMkLst>
            <pc:docMk/>
            <pc:sldMk cId="2255179181" sldId="265"/>
            <ac:spMk id="15" creationId="{46B06F03-F38D-0BEA-A242-2EADF6877DB2}"/>
          </ac:spMkLst>
        </pc:spChg>
        <pc:spChg chg="mod">
          <ac:chgData name="Olena Rudyk" userId="60c459c2-996e-48f7-b018-11285fe7a2eb" providerId="ADAL" clId="{498AAE6A-2918-484D-9BF0-285EC8FA181B}" dt="2026-02-11T17:30:22.363" v="88" actId="1036"/>
          <ac:spMkLst>
            <pc:docMk/>
            <pc:sldMk cId="2255179181" sldId="265"/>
            <ac:spMk id="16" creationId="{2097728E-07B3-9E2A-0E5F-CD953C5CACCC}"/>
          </ac:spMkLst>
        </pc:spChg>
        <pc:graphicFrameChg chg="mod">
          <ac:chgData name="Olena Rudyk" userId="60c459c2-996e-48f7-b018-11285fe7a2eb" providerId="ADAL" clId="{498AAE6A-2918-484D-9BF0-285EC8FA181B}" dt="2026-02-11T17:30:22.363" v="88" actId="1036"/>
          <ac:graphicFrameMkLst>
            <pc:docMk/>
            <pc:sldMk cId="2255179181" sldId="265"/>
            <ac:graphicFrameMk id="3" creationId="{BC9DF592-1C23-32CC-1C8B-1D2160A4D9C0}"/>
          </ac:graphicFrameMkLst>
        </pc:graphicFrameChg>
        <pc:graphicFrameChg chg="mod">
          <ac:chgData name="Olena Rudyk" userId="60c459c2-996e-48f7-b018-11285fe7a2eb" providerId="ADAL" clId="{498AAE6A-2918-484D-9BF0-285EC8FA181B}" dt="2026-02-11T17:30:22.363" v="88" actId="1036"/>
          <ac:graphicFrameMkLst>
            <pc:docMk/>
            <pc:sldMk cId="2255179181" sldId="265"/>
            <ac:graphicFrameMk id="6" creationId="{CBDA3106-7E24-306C-FCFB-6D8E2D211BED}"/>
          </ac:graphicFrameMkLst>
        </pc:graphicFrameChg>
        <pc:graphicFrameChg chg="mod">
          <ac:chgData name="Olena Rudyk" userId="60c459c2-996e-48f7-b018-11285fe7a2eb" providerId="ADAL" clId="{498AAE6A-2918-484D-9BF0-285EC8FA181B}" dt="2026-02-11T17:30:22.363" v="88" actId="1036"/>
          <ac:graphicFrameMkLst>
            <pc:docMk/>
            <pc:sldMk cId="2255179181" sldId="265"/>
            <ac:graphicFrameMk id="11" creationId="{05BE1EF0-6F7D-D094-A079-00CE3D069FAC}"/>
          </ac:graphicFrameMkLst>
        </pc:graphicFrameChg>
      </pc:sldChg>
    </pc:docChg>
  </pc:docChgLst>
  <pc:docChgLst>
    <pc:chgData name="Olena Rudyk" userId="60c459c2-996e-48f7-b018-11285fe7a2eb" providerId="ADAL" clId="{66F37EBD-D82F-4541-8D16-9A871765B2A1}"/>
    <pc:docChg chg="custSel modSld">
      <pc:chgData name="Olena Rudyk" userId="60c459c2-996e-48f7-b018-11285fe7a2eb" providerId="ADAL" clId="{66F37EBD-D82F-4541-8D16-9A871765B2A1}" dt="2026-03-08T17:39:18.248" v="192" actId="164"/>
      <pc:docMkLst>
        <pc:docMk/>
      </pc:docMkLst>
      <pc:sldChg chg="addSp delSp modSp mod">
        <pc:chgData name="Olena Rudyk" userId="60c459c2-996e-48f7-b018-11285fe7a2eb" providerId="ADAL" clId="{66F37EBD-D82F-4541-8D16-9A871765B2A1}" dt="2026-03-08T17:39:12.816" v="191" actId="164"/>
        <pc:sldMkLst>
          <pc:docMk/>
          <pc:sldMk cId="34210548" sldId="260"/>
        </pc:sldMkLst>
        <pc:spChg chg="mod">
          <ac:chgData name="Olena Rudyk" userId="60c459c2-996e-48f7-b018-11285fe7a2eb" providerId="ADAL" clId="{66F37EBD-D82F-4541-8D16-9A871765B2A1}" dt="2026-02-15T11:47:06.531" v="5" actId="164"/>
          <ac:spMkLst>
            <pc:docMk/>
            <pc:sldMk cId="34210548" sldId="260"/>
            <ac:spMk id="2" creationId="{CC7C091C-59EA-FC39-1A87-3560C71E7F29}"/>
          </ac:spMkLst>
        </pc:spChg>
        <pc:spChg chg="mod topLvl">
          <ac:chgData name="Olena Rudyk" userId="60c459c2-996e-48f7-b018-11285fe7a2eb" providerId="ADAL" clId="{66F37EBD-D82F-4541-8D16-9A871765B2A1}" dt="2026-03-08T12:15:17.596" v="62" actId="165"/>
          <ac:spMkLst>
            <pc:docMk/>
            <pc:sldMk cId="34210548" sldId="260"/>
            <ac:spMk id="4" creationId="{1BDAE5DC-2CE6-86CF-56E5-5655F09AC2DB}"/>
          </ac:spMkLst>
        </pc:spChg>
        <pc:spChg chg="mod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7" creationId="{5DBD0518-1365-6DD9-9465-CA053573226F}"/>
          </ac:spMkLst>
        </pc:spChg>
        <pc:spChg chg="mod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10" creationId="{F35D96FC-EED7-6E48-3B4E-EB712FE1B6A8}"/>
          </ac:spMkLst>
        </pc:spChg>
        <pc:spChg chg="mod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11" creationId="{892A4625-79F3-75A8-AF7B-0784DAFCE27C}"/>
          </ac:spMkLst>
        </pc:spChg>
        <pc:spChg chg="mod">
          <ac:chgData name="Olena Rudyk" userId="60c459c2-996e-48f7-b018-11285fe7a2eb" providerId="ADAL" clId="{66F37EBD-D82F-4541-8D16-9A871765B2A1}" dt="2026-02-15T11:47:06.531" v="5" actId="164"/>
          <ac:spMkLst>
            <pc:docMk/>
            <pc:sldMk cId="34210548" sldId="260"/>
            <ac:spMk id="12" creationId="{CA262475-79B4-27FB-AE67-BE56DE1C01C6}"/>
          </ac:spMkLst>
        </pc:spChg>
        <pc:spChg chg="mod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13" creationId="{F7E114AC-5155-F712-9C9C-E10413263E78}"/>
          </ac:spMkLst>
        </pc:spChg>
        <pc:spChg chg="mod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14" creationId="{12370AD8-7031-0552-B7E4-F79487F61E1A}"/>
          </ac:spMkLst>
        </pc:spChg>
        <pc:spChg chg="add del">
          <ac:chgData name="Olena Rudyk" userId="60c459c2-996e-48f7-b018-11285fe7a2eb" providerId="ADAL" clId="{66F37EBD-D82F-4541-8D16-9A871765B2A1}" dt="2026-03-08T12:16:43.708" v="70" actId="478"/>
          <ac:spMkLst>
            <pc:docMk/>
            <pc:sldMk cId="34210548" sldId="260"/>
            <ac:spMk id="15" creationId="{85BE460C-5BAD-815B-D88B-68842FD7A2C3}"/>
          </ac:spMkLst>
        </pc:spChg>
        <pc:spChg chg="mod">
          <ac:chgData name="Olena Rudyk" userId="60c459c2-996e-48f7-b018-11285fe7a2eb" providerId="ADAL" clId="{66F37EBD-D82F-4541-8D16-9A871765B2A1}" dt="2026-03-08T17:37:23.638" v="182" actId="20577"/>
          <ac:spMkLst>
            <pc:docMk/>
            <pc:sldMk cId="34210548" sldId="260"/>
            <ac:spMk id="16" creationId="{DCB7A552-9771-8D4C-0CBB-72B7419994D4}"/>
          </ac:spMkLst>
        </pc:spChg>
        <pc:spChg chg="mod topLvl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22" creationId="{58E92BF3-A60E-3660-15FF-6C4D4E612CA4}"/>
          </ac:spMkLst>
        </pc:spChg>
        <pc:spChg chg="mod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26" creationId="{9892570B-672A-AE8E-D908-B7372F117898}"/>
          </ac:spMkLst>
        </pc:spChg>
        <pc:spChg chg="mod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29" creationId="{13C53518-33F4-B69F-3F8A-7E915D426ED9}"/>
          </ac:spMkLst>
        </pc:spChg>
        <pc:spChg chg="del mod">
          <ac:chgData name="Olena Rudyk" userId="60c459c2-996e-48f7-b018-11285fe7a2eb" providerId="ADAL" clId="{66F37EBD-D82F-4541-8D16-9A871765B2A1}" dt="2026-03-08T12:18:18.411" v="87" actId="478"/>
          <ac:spMkLst>
            <pc:docMk/>
            <pc:sldMk cId="34210548" sldId="260"/>
            <ac:spMk id="30" creationId="{EDB2F140-4B27-DF58-70A8-7E534C2451B8}"/>
          </ac:spMkLst>
        </pc:spChg>
        <pc:spChg chg="mod">
          <ac:chgData name="Olena Rudyk" userId="60c459c2-996e-48f7-b018-11285fe7a2eb" providerId="ADAL" clId="{66F37EBD-D82F-4541-8D16-9A871765B2A1}" dt="2026-02-15T11:47:06.531" v="5" actId="164"/>
          <ac:spMkLst>
            <pc:docMk/>
            <pc:sldMk cId="34210548" sldId="260"/>
            <ac:spMk id="31" creationId="{B5C74E5A-BB4D-6B86-F86E-40ED01117DF9}"/>
          </ac:spMkLst>
        </pc:spChg>
        <pc:spChg chg="mod">
          <ac:chgData name="Olena Rudyk" userId="60c459c2-996e-48f7-b018-11285fe7a2eb" providerId="ADAL" clId="{66F37EBD-D82F-4541-8D16-9A871765B2A1}" dt="2026-03-08T12:19:09.014" v="110" actId="1038"/>
          <ac:spMkLst>
            <pc:docMk/>
            <pc:sldMk cId="34210548" sldId="260"/>
            <ac:spMk id="47" creationId="{39A5BD68-282E-7CB0-C8DF-35B31FC24CAD}"/>
          </ac:spMkLst>
        </pc:spChg>
        <pc:spChg chg="mod">
          <ac:chgData name="Olena Rudyk" userId="60c459c2-996e-48f7-b018-11285fe7a2eb" providerId="ADAL" clId="{66F37EBD-D82F-4541-8D16-9A871765B2A1}" dt="2026-03-08T17:37:33.413" v="186" actId="20577"/>
          <ac:spMkLst>
            <pc:docMk/>
            <pc:sldMk cId="34210548" sldId="260"/>
            <ac:spMk id="48" creationId="{B33393A6-199A-DF28-093E-9AED83454415}"/>
          </ac:spMkLst>
        </pc:spChg>
        <pc:spChg chg="mod">
          <ac:chgData name="Olena Rudyk" userId="60c459c2-996e-48f7-b018-11285fe7a2eb" providerId="ADAL" clId="{66F37EBD-D82F-4541-8D16-9A871765B2A1}" dt="2026-03-08T12:18:45.263" v="99" actId="1038"/>
          <ac:spMkLst>
            <pc:docMk/>
            <pc:sldMk cId="34210548" sldId="260"/>
            <ac:spMk id="49" creationId="{2576A7A9-D05E-EEBA-5181-BADA524989F9}"/>
          </ac:spMkLst>
        </pc:spChg>
        <pc:spChg chg="mod">
          <ac:chgData name="Olena Rudyk" userId="60c459c2-996e-48f7-b018-11285fe7a2eb" providerId="ADAL" clId="{66F37EBD-D82F-4541-8D16-9A871765B2A1}" dt="2026-03-08T17:37:36.375" v="189" actId="20577"/>
          <ac:spMkLst>
            <pc:docMk/>
            <pc:sldMk cId="34210548" sldId="260"/>
            <ac:spMk id="50" creationId="{DE0AE3B4-8193-6D7C-F55F-E69762D6E86A}"/>
          </ac:spMkLst>
        </pc:spChg>
        <pc:spChg chg="mod">
          <ac:chgData name="Olena Rudyk" userId="60c459c2-996e-48f7-b018-11285fe7a2eb" providerId="ADAL" clId="{66F37EBD-D82F-4541-8D16-9A871765B2A1}" dt="2026-03-08T17:37:27.037" v="184" actId="20577"/>
          <ac:spMkLst>
            <pc:docMk/>
            <pc:sldMk cId="34210548" sldId="260"/>
            <ac:spMk id="52" creationId="{6295BD12-8129-52EA-2640-E73C068A402B}"/>
          </ac:spMkLst>
        </pc:spChg>
        <pc:spChg chg="mod">
          <ac:chgData name="Olena Rudyk" userId="60c459c2-996e-48f7-b018-11285fe7a2eb" providerId="ADAL" clId="{66F37EBD-D82F-4541-8D16-9A871765B2A1}" dt="2026-03-08T12:15:17.596" v="62" actId="165"/>
          <ac:spMkLst>
            <pc:docMk/>
            <pc:sldMk cId="34210548" sldId="260"/>
            <ac:spMk id="53" creationId="{7AA92B9C-AA8E-BD4D-E42F-95A222ECFEA7}"/>
          </ac:spMkLst>
        </pc:spChg>
        <pc:spChg chg="mod">
          <ac:chgData name="Olena Rudyk" userId="60c459c2-996e-48f7-b018-11285fe7a2eb" providerId="ADAL" clId="{66F37EBD-D82F-4541-8D16-9A871765B2A1}" dt="2026-03-08T17:37:30.995" v="185" actId="20577"/>
          <ac:spMkLst>
            <pc:docMk/>
            <pc:sldMk cId="34210548" sldId="260"/>
            <ac:spMk id="54" creationId="{864C348C-DC93-84C9-99FC-0B312771F834}"/>
          </ac:spMkLst>
        </pc:spChg>
        <pc:spChg chg="mod topLvl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58" creationId="{B0E3CDAC-2432-53F0-D7FA-85C72864BAD0}"/>
          </ac:spMkLst>
        </pc:spChg>
        <pc:spChg chg="mod topLvl">
          <ac:chgData name="Olena Rudyk" userId="60c459c2-996e-48f7-b018-11285fe7a2eb" providerId="ADAL" clId="{66F37EBD-D82F-4541-8D16-9A871765B2A1}" dt="2026-03-08T12:15:17.596" v="62" actId="165"/>
          <ac:spMkLst>
            <pc:docMk/>
            <pc:sldMk cId="34210548" sldId="260"/>
            <ac:spMk id="61" creationId="{D60B2C43-A5AE-3EC1-EC4D-596696022B19}"/>
          </ac:spMkLst>
        </pc:spChg>
        <pc:spChg chg="mod topLvl">
          <ac:chgData name="Olena Rudyk" userId="60c459c2-996e-48f7-b018-11285fe7a2eb" providerId="ADAL" clId="{66F37EBD-D82F-4541-8D16-9A871765B2A1}" dt="2026-03-08T12:15:17.596" v="62" actId="165"/>
          <ac:spMkLst>
            <pc:docMk/>
            <pc:sldMk cId="34210548" sldId="260"/>
            <ac:spMk id="64" creationId="{541E3D1D-6763-70AC-FE91-882680EEFBA9}"/>
          </ac:spMkLst>
        </pc:spChg>
        <pc:spChg chg="mod topLvl">
          <ac:chgData name="Olena Rudyk" userId="60c459c2-996e-48f7-b018-11285fe7a2eb" providerId="ADAL" clId="{66F37EBD-D82F-4541-8D16-9A871765B2A1}" dt="2026-03-08T12:15:17.596" v="62" actId="165"/>
          <ac:spMkLst>
            <pc:docMk/>
            <pc:sldMk cId="34210548" sldId="260"/>
            <ac:spMk id="65" creationId="{FD4C348D-9AD9-B29A-4B00-4DC2E9344258}"/>
          </ac:spMkLst>
        </pc:spChg>
        <pc:spChg chg="mod">
          <ac:chgData name="Olena Rudyk" userId="60c459c2-996e-48f7-b018-11285fe7a2eb" providerId="ADAL" clId="{66F37EBD-D82F-4541-8D16-9A871765B2A1}" dt="2026-02-15T11:47:06.531" v="5" actId="164"/>
          <ac:spMkLst>
            <pc:docMk/>
            <pc:sldMk cId="34210548" sldId="260"/>
            <ac:spMk id="69" creationId="{BD0DF77F-AD41-5DC3-9254-A0D21BBF600F}"/>
          </ac:spMkLst>
        </pc:spChg>
        <pc:spChg chg="mod">
          <ac:chgData name="Olena Rudyk" userId="60c459c2-996e-48f7-b018-11285fe7a2eb" providerId="ADAL" clId="{66F37EBD-D82F-4541-8D16-9A871765B2A1}" dt="2026-02-15T11:47:06.531" v="5" actId="164"/>
          <ac:spMkLst>
            <pc:docMk/>
            <pc:sldMk cId="34210548" sldId="260"/>
            <ac:spMk id="70" creationId="{83D35886-FE57-F53C-38EC-1F4F9FFE57CF}"/>
          </ac:spMkLst>
        </pc:spChg>
        <pc:spChg chg="mod">
          <ac:chgData name="Olena Rudyk" userId="60c459c2-996e-48f7-b018-11285fe7a2eb" providerId="ADAL" clId="{66F37EBD-D82F-4541-8D16-9A871765B2A1}" dt="2026-03-08T12:19:02.911" v="108" actId="1038"/>
          <ac:spMkLst>
            <pc:docMk/>
            <pc:sldMk cId="34210548" sldId="260"/>
            <ac:spMk id="71" creationId="{B673318D-6B77-0E4B-515B-2C2300209003}"/>
          </ac:spMkLst>
        </pc:spChg>
        <pc:spChg chg="mod">
          <ac:chgData name="Olena Rudyk" userId="60c459c2-996e-48f7-b018-11285fe7a2eb" providerId="ADAL" clId="{66F37EBD-D82F-4541-8D16-9A871765B2A1}" dt="2026-03-08T17:37:38.339" v="190" actId="20577"/>
          <ac:spMkLst>
            <pc:docMk/>
            <pc:sldMk cId="34210548" sldId="260"/>
            <ac:spMk id="72" creationId="{3097DA7B-76AC-B707-F269-6E682A3EEC7D}"/>
          </ac:spMkLst>
        </pc:spChg>
        <pc:spChg chg="mod">
          <ac:chgData name="Olena Rudyk" userId="60c459c2-996e-48f7-b018-11285fe7a2eb" providerId="ADAL" clId="{66F37EBD-D82F-4541-8D16-9A871765B2A1}" dt="2026-03-08T17:39:12.816" v="191" actId="164"/>
          <ac:spMkLst>
            <pc:docMk/>
            <pc:sldMk cId="34210548" sldId="260"/>
            <ac:spMk id="81" creationId="{126850BA-E46D-4DE3-415D-2E3BCE690621}"/>
          </ac:spMkLst>
        </pc:spChg>
        <pc:spChg chg="mod">
          <ac:chgData name="Olena Rudyk" userId="60c459c2-996e-48f7-b018-11285fe7a2eb" providerId="ADAL" clId="{66F37EBD-D82F-4541-8D16-9A871765B2A1}" dt="2026-03-08T12:17:07.071" v="77" actId="1035"/>
          <ac:spMkLst>
            <pc:docMk/>
            <pc:sldMk cId="34210548" sldId="260"/>
            <ac:spMk id="85" creationId="{D3B49008-895E-9428-4816-771BF7C82CFE}"/>
          </ac:spMkLst>
        </pc:spChg>
        <pc:grpChg chg="mod">
          <ac:chgData name="Olena Rudyk" userId="60c459c2-996e-48f7-b018-11285fe7a2eb" providerId="ADAL" clId="{66F37EBD-D82F-4541-8D16-9A871765B2A1}" dt="2026-03-08T11:37:08.788" v="58" actId="1076"/>
          <ac:grpSpMkLst>
            <pc:docMk/>
            <pc:sldMk cId="34210548" sldId="260"/>
            <ac:grpSpMk id="8" creationId="{9BB4AC3D-DFB3-016C-77D5-CB7005DD6E4B}"/>
          </ac:grpSpMkLst>
        </pc:grpChg>
        <pc:graphicFrameChg chg="mod">
          <ac:chgData name="Olena Rudyk" userId="60c459c2-996e-48f7-b018-11285fe7a2eb" providerId="ADAL" clId="{66F37EBD-D82F-4541-8D16-9A871765B2A1}" dt="2026-03-08T12:16:02.832" v="65"/>
          <ac:graphicFrameMkLst>
            <pc:docMk/>
            <pc:sldMk cId="34210548" sldId="260"/>
            <ac:graphicFrameMk id="79" creationId="{FF7B2D4C-7C5D-68DA-421F-2F98BCF756F6}"/>
          </ac:graphicFrameMkLst>
        </pc:graphicFrameChg>
        <pc:graphicFrameChg chg="mod">
          <ac:chgData name="Olena Rudyk" userId="60c459c2-996e-48f7-b018-11285fe7a2eb" providerId="ADAL" clId="{66F37EBD-D82F-4541-8D16-9A871765B2A1}" dt="2026-03-08T12:16:16.199" v="68"/>
          <ac:graphicFrameMkLst>
            <pc:docMk/>
            <pc:sldMk cId="34210548" sldId="260"/>
            <ac:graphicFrameMk id="80" creationId="{39C64C61-082B-7CE8-3456-0E4F74494CBC}"/>
          </ac:graphicFrameMkLst>
        </pc:graphicFrameChg>
        <pc:cxnChg chg="add del mod">
          <ac:chgData name="Olena Rudyk" userId="60c459c2-996e-48f7-b018-11285fe7a2eb" providerId="ADAL" clId="{66F37EBD-D82F-4541-8D16-9A871765B2A1}" dt="2026-03-08T12:17:17.021" v="79" actId="478"/>
          <ac:cxnSpMkLst>
            <pc:docMk/>
            <pc:sldMk cId="34210548" sldId="260"/>
            <ac:cxnSpMk id="21" creationId="{224F89A9-B178-1016-47A7-4686AF81CF44}"/>
          </ac:cxnSpMkLst>
        </pc:cxnChg>
      </pc:sldChg>
      <pc:sldChg chg="addSp delSp modSp mod">
        <pc:chgData name="Olena Rudyk" userId="60c459c2-996e-48f7-b018-11285fe7a2eb" providerId="ADAL" clId="{66F37EBD-D82F-4541-8D16-9A871765B2A1}" dt="2026-03-08T17:39:18.248" v="192" actId="164"/>
        <pc:sldMkLst>
          <pc:docMk/>
          <pc:sldMk cId="2255179181" sldId="265"/>
        </pc:sldMkLst>
        <pc:spChg chg="add mod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4" creationId="{BA6B7C7A-64C3-1EB2-776C-0C344A691665}"/>
          </ac:spMkLst>
        </pc:spChg>
        <pc:spChg chg="mod">
          <ac:chgData name="Olena Rudyk" userId="60c459c2-996e-48f7-b018-11285fe7a2eb" providerId="ADAL" clId="{66F37EBD-D82F-4541-8D16-9A871765B2A1}" dt="2026-03-08T17:37:16.457" v="179" actId="20577"/>
          <ac:spMkLst>
            <pc:docMk/>
            <pc:sldMk cId="2255179181" sldId="265"/>
            <ac:spMk id="8" creationId="{21A87EE8-9CFA-C455-D3BA-F929570729DB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9" creationId="{D8768DD3-CC74-1325-4DEE-9A28B2C9A338}"/>
          </ac:spMkLst>
        </pc:spChg>
        <pc:spChg chg="mod">
          <ac:chgData name="Olena Rudyk" userId="60c459c2-996e-48f7-b018-11285fe7a2eb" providerId="ADAL" clId="{66F37EBD-D82F-4541-8D16-9A871765B2A1}" dt="2026-03-08T17:37:17.761" v="180" actId="20577"/>
          <ac:spMkLst>
            <pc:docMk/>
            <pc:sldMk cId="2255179181" sldId="265"/>
            <ac:spMk id="10" creationId="{9C8CA39C-6125-F6A3-66BC-E3724E65FD85}"/>
          </ac:spMkLst>
        </pc:spChg>
        <pc:spChg chg="mod">
          <ac:chgData name="Olena Rudyk" userId="60c459c2-996e-48f7-b018-11285fe7a2eb" providerId="ADAL" clId="{66F37EBD-D82F-4541-8D16-9A871765B2A1}" dt="2026-03-08T17:37:19.397" v="181" actId="20577"/>
          <ac:spMkLst>
            <pc:docMk/>
            <pc:sldMk cId="2255179181" sldId="265"/>
            <ac:spMk id="14" creationId="{B8117BAC-0240-DA96-1D4B-053CA5D7E8D7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15" creationId="{46B06F03-F38D-0BEA-A242-2EADF6877DB2}"/>
          </ac:spMkLst>
        </pc:spChg>
        <pc:spChg chg="mod">
          <ac:chgData name="Olena Rudyk" userId="60c459c2-996e-48f7-b018-11285fe7a2eb" providerId="ADAL" clId="{66F37EBD-D82F-4541-8D16-9A871765B2A1}" dt="2026-03-08T12:17:52.720" v="84"/>
          <ac:spMkLst>
            <pc:docMk/>
            <pc:sldMk cId="2255179181" sldId="265"/>
            <ac:spMk id="22" creationId="{05CEAB98-5443-DF4A-F355-FCE116FA2851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23" creationId="{49F6F025-55DC-C52F-039E-2834346BE073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24" creationId="{364958AC-DFF2-071A-AF6F-E0B98642B2A3}"/>
          </ac:spMkLst>
        </pc:spChg>
        <pc:spChg chg="mod">
          <ac:chgData name="Olena Rudyk" userId="60c459c2-996e-48f7-b018-11285fe7a2eb" providerId="ADAL" clId="{66F37EBD-D82F-4541-8D16-9A871765B2A1}" dt="2026-03-08T12:17:52.720" v="84"/>
          <ac:spMkLst>
            <pc:docMk/>
            <pc:sldMk cId="2255179181" sldId="265"/>
            <ac:spMk id="25" creationId="{DB46BD66-097B-911B-BCD8-0096770F877F}"/>
          </ac:spMkLst>
        </pc:spChg>
        <pc:spChg chg="mod">
          <ac:chgData name="Olena Rudyk" userId="60c459c2-996e-48f7-b018-11285fe7a2eb" providerId="ADAL" clId="{66F37EBD-D82F-4541-8D16-9A871765B2A1}" dt="2026-03-08T12:17:52.720" v="84"/>
          <ac:spMkLst>
            <pc:docMk/>
            <pc:sldMk cId="2255179181" sldId="265"/>
            <ac:spMk id="29" creationId="{A1DCE460-97AC-AB78-728A-13882576F157}"/>
          </ac:spMkLst>
        </pc:spChg>
        <pc:spChg chg="mod">
          <ac:chgData name="Olena Rudyk" userId="60c459c2-996e-48f7-b018-11285fe7a2eb" providerId="ADAL" clId="{66F37EBD-D82F-4541-8D16-9A871765B2A1}" dt="2026-02-15T11:47:44.644" v="7" actId="164"/>
          <ac:spMkLst>
            <pc:docMk/>
            <pc:sldMk cId="2255179181" sldId="265"/>
            <ac:spMk id="30" creationId="{0FC332F6-2413-1E54-3AD7-718F6449C3BF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31" creationId="{5346920C-F6FF-8D6B-4358-C492B0F7B85F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33" creationId="{CA115160-67CA-4F69-56CE-BDB4931097DD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35" creationId="{E3311AE3-00FB-697E-BD60-33E43E9FFC69}"/>
          </ac:spMkLst>
        </pc:spChg>
        <pc:spChg chg="mod">
          <ac:chgData name="Olena Rudyk" userId="60c459c2-996e-48f7-b018-11285fe7a2eb" providerId="ADAL" clId="{66F37EBD-D82F-4541-8D16-9A871765B2A1}" dt="2026-02-15T11:47:44.644" v="7" actId="164"/>
          <ac:spMkLst>
            <pc:docMk/>
            <pc:sldMk cId="2255179181" sldId="265"/>
            <ac:spMk id="36" creationId="{2C03EAD0-B544-826B-F14A-174F1E4A3AE8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37" creationId="{56BFF7D0-AFCA-E2E6-B983-FEE529D78972}"/>
          </ac:spMkLst>
        </pc:spChg>
        <pc:spChg chg="mod">
          <ac:chgData name="Olena Rudyk" userId="60c459c2-996e-48f7-b018-11285fe7a2eb" providerId="ADAL" clId="{66F37EBD-D82F-4541-8D16-9A871765B2A1}" dt="2026-03-08T16:50:26.164" v="142" actId="165"/>
          <ac:spMkLst>
            <pc:docMk/>
            <pc:sldMk cId="2255179181" sldId="265"/>
            <ac:spMk id="39" creationId="{C0CE62F2-43B0-B3D2-C6BA-42E7D50D50AD}"/>
          </ac:spMkLst>
        </pc:spChg>
        <pc:spChg chg="mod topLvl">
          <ac:chgData name="Olena Rudyk" userId="60c459c2-996e-48f7-b018-11285fe7a2eb" providerId="ADAL" clId="{66F37EBD-D82F-4541-8D16-9A871765B2A1}" dt="2026-03-08T17:39:18.248" v="192" actId="164"/>
          <ac:spMkLst>
            <pc:docMk/>
            <pc:sldMk cId="2255179181" sldId="265"/>
            <ac:spMk id="46" creationId="{E830080B-A5B0-2697-7CFE-A0F0B3F632B8}"/>
          </ac:spMkLst>
        </pc:spChg>
        <pc:spChg chg="mod">
          <ac:chgData name="Olena Rudyk" userId="60c459c2-996e-48f7-b018-11285fe7a2eb" providerId="ADAL" clId="{66F37EBD-D82F-4541-8D16-9A871765B2A1}" dt="2026-02-15T11:47:44.644" v="7" actId="164"/>
          <ac:spMkLst>
            <pc:docMk/>
            <pc:sldMk cId="2255179181" sldId="265"/>
            <ac:spMk id="48" creationId="{121725D8-9995-F517-ACAB-9AA0C222DD40}"/>
          </ac:spMkLst>
        </pc:spChg>
        <pc:spChg chg="mod">
          <ac:chgData name="Olena Rudyk" userId="60c459c2-996e-48f7-b018-11285fe7a2eb" providerId="ADAL" clId="{66F37EBD-D82F-4541-8D16-9A871765B2A1}" dt="2026-02-15T11:47:37.662" v="6" actId="13926"/>
          <ac:spMkLst>
            <pc:docMk/>
            <pc:sldMk cId="2255179181" sldId="265"/>
            <ac:spMk id="455" creationId="{15FF37B8-B53B-F280-181C-8C2B31830051}"/>
          </ac:spMkLst>
        </pc:spChg>
        <pc:graphicFrameChg chg="mod">
          <ac:chgData name="Olena Rudyk" userId="60c459c2-996e-48f7-b018-11285fe7a2eb" providerId="ADAL" clId="{66F37EBD-D82F-4541-8D16-9A871765B2A1}" dt="2026-03-08T12:19:42.506" v="123" actId="1036"/>
          <ac:graphicFrameMkLst>
            <pc:docMk/>
            <pc:sldMk cId="2255179181" sldId="265"/>
            <ac:graphicFrameMk id="3" creationId="{BC9DF592-1C23-32CC-1C8B-1D2160A4D9C0}"/>
          </ac:graphicFrameMkLst>
        </pc:graphicFrameChg>
        <pc:graphicFrameChg chg="mod">
          <ac:chgData name="Olena Rudyk" userId="60c459c2-996e-48f7-b018-11285fe7a2eb" providerId="ADAL" clId="{66F37EBD-D82F-4541-8D16-9A871765B2A1}" dt="2026-03-08T12:17:40.161" v="82"/>
          <ac:graphicFrameMkLst>
            <pc:docMk/>
            <pc:sldMk cId="2255179181" sldId="265"/>
            <ac:graphicFrameMk id="6" creationId="{CBDA3106-7E24-306C-FCFB-6D8E2D211BED}"/>
          </ac:graphicFrameMkLst>
        </pc:graphicFrameChg>
      </pc:sldChg>
      <pc:sldChg chg="addSp modSp mod">
        <pc:chgData name="Olena Rudyk" userId="60c459c2-996e-48f7-b018-11285fe7a2eb" providerId="ADAL" clId="{66F37EBD-D82F-4541-8D16-9A871765B2A1}" dt="2026-03-08T12:20:57.631" v="141" actId="6549"/>
        <pc:sldMkLst>
          <pc:docMk/>
          <pc:sldMk cId="2388955421" sldId="267"/>
        </pc:sldMkLst>
        <pc:spChg chg="mod">
          <ac:chgData name="Olena Rudyk" userId="60c459c2-996e-48f7-b018-11285fe7a2eb" providerId="ADAL" clId="{66F37EBD-D82F-4541-8D16-9A871765B2A1}" dt="2026-02-15T11:50:40.032" v="9" actId="164"/>
          <ac:spMkLst>
            <pc:docMk/>
            <pc:sldMk cId="2388955421" sldId="267"/>
            <ac:spMk id="7" creationId="{8B60BEC5-53DE-45A2-D5D3-CB7DB1BA7339}"/>
          </ac:spMkLst>
        </pc:spChg>
        <pc:spChg chg="mod">
          <ac:chgData name="Olena Rudyk" userId="60c459c2-996e-48f7-b018-11285fe7a2eb" providerId="ADAL" clId="{66F37EBD-D82F-4541-8D16-9A871765B2A1}" dt="2026-02-15T11:50:40.032" v="9" actId="164"/>
          <ac:spMkLst>
            <pc:docMk/>
            <pc:sldMk cId="2388955421" sldId="267"/>
            <ac:spMk id="8" creationId="{E9CA6122-980B-B7FB-F91A-A9FC9296F44E}"/>
          </ac:spMkLst>
        </pc:spChg>
        <pc:spChg chg="mod">
          <ac:chgData name="Olena Rudyk" userId="60c459c2-996e-48f7-b018-11285fe7a2eb" providerId="ADAL" clId="{66F37EBD-D82F-4541-8D16-9A871765B2A1}" dt="2026-02-15T11:50:40.032" v="9" actId="164"/>
          <ac:spMkLst>
            <pc:docMk/>
            <pc:sldMk cId="2388955421" sldId="267"/>
            <ac:spMk id="9" creationId="{3B97C39C-CC53-AC33-D572-78FE75750E84}"/>
          </ac:spMkLst>
        </pc:spChg>
        <pc:spChg chg="mod">
          <ac:chgData name="Olena Rudyk" userId="60c459c2-996e-48f7-b018-11285fe7a2eb" providerId="ADAL" clId="{66F37EBD-D82F-4541-8D16-9A871765B2A1}" dt="2026-03-08T12:20:55.312" v="137" actId="6549"/>
          <ac:spMkLst>
            <pc:docMk/>
            <pc:sldMk cId="2388955421" sldId="267"/>
            <ac:spMk id="29" creationId="{D4B14893-25D9-A13C-4CAD-505E51CE7D6D}"/>
          </ac:spMkLst>
        </pc:spChg>
        <pc:spChg chg="mod">
          <ac:chgData name="Olena Rudyk" userId="60c459c2-996e-48f7-b018-11285fe7a2eb" providerId="ADAL" clId="{66F37EBD-D82F-4541-8D16-9A871765B2A1}" dt="2026-03-08T12:20:57.631" v="141" actId="6549"/>
          <ac:spMkLst>
            <pc:docMk/>
            <pc:sldMk cId="2388955421" sldId="267"/>
            <ac:spMk id="30" creationId="{6BAFA07B-FC11-D9F9-1D0F-3670BAA7FCAA}"/>
          </ac:spMkLst>
        </pc:spChg>
        <pc:spChg chg="mod">
          <ac:chgData name="Olena Rudyk" userId="60c459c2-996e-48f7-b018-11285fe7a2eb" providerId="ADAL" clId="{66F37EBD-D82F-4541-8D16-9A871765B2A1}" dt="2026-03-08T12:20:47.001" v="132" actId="6549"/>
          <ac:spMkLst>
            <pc:docMk/>
            <pc:sldMk cId="2388955421" sldId="267"/>
            <ac:spMk id="31" creationId="{CD1D5FCF-B842-DF32-B681-83B17B3ABA60}"/>
          </ac:spMkLst>
        </pc:spChg>
        <pc:spChg chg="mod">
          <ac:chgData name="Olena Rudyk" userId="60c459c2-996e-48f7-b018-11285fe7a2eb" providerId="ADAL" clId="{66F37EBD-D82F-4541-8D16-9A871765B2A1}" dt="2026-03-08T12:20:49.395" v="133" actId="20577"/>
          <ac:spMkLst>
            <pc:docMk/>
            <pc:sldMk cId="2388955421" sldId="267"/>
            <ac:spMk id="32" creationId="{F7542073-22F3-DA49-D850-105B27F78853}"/>
          </ac:spMkLst>
        </pc:spChg>
        <pc:spChg chg="mod">
          <ac:chgData name="Olena Rudyk" userId="60c459c2-996e-48f7-b018-11285fe7a2eb" providerId="ADAL" clId="{66F37EBD-D82F-4541-8D16-9A871765B2A1}" dt="2026-02-15T11:50:40.032" v="9" actId="164"/>
          <ac:spMkLst>
            <pc:docMk/>
            <pc:sldMk cId="2388955421" sldId="267"/>
            <ac:spMk id="33" creationId="{A8D08CAD-6D9F-DFC3-C4F3-937776315CD0}"/>
          </ac:spMkLst>
        </pc:spChg>
        <pc:spChg chg="mod">
          <ac:chgData name="Olena Rudyk" userId="60c459c2-996e-48f7-b018-11285fe7a2eb" providerId="ADAL" clId="{66F37EBD-D82F-4541-8D16-9A871765B2A1}" dt="2026-02-15T11:50:40.032" v="9" actId="164"/>
          <ac:spMkLst>
            <pc:docMk/>
            <pc:sldMk cId="2388955421" sldId="267"/>
            <ac:spMk id="455" creationId="{5402082B-097F-7B0D-524F-D8C541846D17}"/>
          </ac:spMkLst>
        </pc:spChg>
        <pc:grpChg chg="add mod">
          <ac:chgData name="Olena Rudyk" userId="60c459c2-996e-48f7-b018-11285fe7a2eb" providerId="ADAL" clId="{66F37EBD-D82F-4541-8D16-9A871765B2A1}" dt="2026-02-15T11:50:40.032" v="9" actId="164"/>
          <ac:grpSpMkLst>
            <pc:docMk/>
            <pc:sldMk cId="2388955421" sldId="267"/>
            <ac:grpSpMk id="3" creationId="{7FF17B57-522C-0561-A626-8EA70411A6CB}"/>
          </ac:grpSpMkLst>
        </pc:grpChg>
        <pc:grpChg chg="mod">
          <ac:chgData name="Olena Rudyk" userId="60c459c2-996e-48f7-b018-11285fe7a2eb" providerId="ADAL" clId="{66F37EBD-D82F-4541-8D16-9A871765B2A1}" dt="2026-02-15T11:50:40.032" v="9" actId="164"/>
          <ac:grpSpMkLst>
            <pc:docMk/>
            <pc:sldMk cId="2388955421" sldId="267"/>
            <ac:grpSpMk id="24" creationId="{8E41D06F-6C3A-9C0E-D9CB-19CE44558F79}"/>
          </ac:grpSpMkLst>
        </pc:grpChg>
        <pc:grpChg chg="mod">
          <ac:chgData name="Olena Rudyk" userId="60c459c2-996e-48f7-b018-11285fe7a2eb" providerId="ADAL" clId="{66F37EBD-D82F-4541-8D16-9A871765B2A1}" dt="2026-02-15T11:50:40.032" v="9" actId="164"/>
          <ac:grpSpMkLst>
            <pc:docMk/>
            <pc:sldMk cId="2388955421" sldId="267"/>
            <ac:grpSpMk id="51" creationId="{BBE8C703-F2A1-3E19-FE67-AAE6F52D87F4}"/>
          </ac:grpSpMkLst>
        </pc:grpChg>
        <pc:grpChg chg="mod">
          <ac:chgData name="Olena Rudyk" userId="60c459c2-996e-48f7-b018-11285fe7a2eb" providerId="ADAL" clId="{66F37EBD-D82F-4541-8D16-9A871765B2A1}" dt="2026-02-15T11:50:40.032" v="9" actId="164"/>
          <ac:grpSpMkLst>
            <pc:docMk/>
            <pc:sldMk cId="2388955421" sldId="267"/>
            <ac:grpSpMk id="53" creationId="{FD7E1A25-CEC5-2FA9-0153-51129587D0CB}"/>
          </ac:grpSpMkLst>
        </pc:grpChg>
        <pc:grpChg chg="mod">
          <ac:chgData name="Olena Rudyk" userId="60c459c2-996e-48f7-b018-11285fe7a2eb" providerId="ADAL" clId="{66F37EBD-D82F-4541-8D16-9A871765B2A1}" dt="2026-02-15T11:50:40.032" v="9" actId="164"/>
          <ac:grpSpMkLst>
            <pc:docMk/>
            <pc:sldMk cId="2388955421" sldId="267"/>
            <ac:grpSpMk id="55" creationId="{7EB0E42A-3C11-7512-549A-792E1C5D7233}"/>
          </ac:grpSpMkLst>
        </pc:grpChg>
        <pc:graphicFrameChg chg="mod">
          <ac:chgData name="Olena Rudyk" userId="60c459c2-996e-48f7-b018-11285fe7a2eb" providerId="ADAL" clId="{66F37EBD-D82F-4541-8D16-9A871765B2A1}" dt="2026-03-08T12:20:13.941" v="128" actId="255"/>
          <ac:graphicFrameMkLst>
            <pc:docMk/>
            <pc:sldMk cId="2388955421" sldId="267"/>
            <ac:graphicFrameMk id="13" creationId="{DB1766A2-A398-7C07-2376-1ECF629DF632}"/>
          </ac:graphicFrameMkLst>
        </pc:graphicFrameChg>
        <pc:graphicFrameChg chg="mod">
          <ac:chgData name="Olena Rudyk" userId="60c459c2-996e-48f7-b018-11285fe7a2eb" providerId="ADAL" clId="{66F37EBD-D82F-4541-8D16-9A871765B2A1}" dt="2026-03-08T12:20:23.621" v="130" actId="255"/>
          <ac:graphicFrameMkLst>
            <pc:docMk/>
            <pc:sldMk cId="2388955421" sldId="267"/>
            <ac:graphicFrameMk id="15" creationId="{E51D6D3B-6033-99A7-B37D-A60B60D56DD4}"/>
          </ac:graphicFrameMkLst>
        </pc:graphicFrameChg>
        <pc:graphicFrameChg chg="mod">
          <ac:chgData name="Olena Rudyk" userId="60c459c2-996e-48f7-b018-11285fe7a2eb" providerId="ADAL" clId="{66F37EBD-D82F-4541-8D16-9A871765B2A1}" dt="2026-03-08T12:20:18.931" v="129" actId="255"/>
          <ac:graphicFrameMkLst>
            <pc:docMk/>
            <pc:sldMk cId="2388955421" sldId="267"/>
            <ac:graphicFrameMk id="16" creationId="{A918343F-E549-2534-7D28-A8B87BF702F1}"/>
          </ac:graphicFrameMkLst>
        </pc:graphicFrameChg>
        <pc:graphicFrameChg chg="mod">
          <ac:chgData name="Olena Rudyk" userId="60c459c2-996e-48f7-b018-11285fe7a2eb" providerId="ADAL" clId="{66F37EBD-D82F-4541-8D16-9A871765B2A1}" dt="2026-03-08T12:19:56.051" v="124" actId="255"/>
          <ac:graphicFrameMkLst>
            <pc:docMk/>
            <pc:sldMk cId="2388955421" sldId="267"/>
            <ac:graphicFrameMk id="17" creationId="{6F206A3F-2F30-FA38-735F-D1EFEC48EAD2}"/>
          </ac:graphicFrameMkLst>
        </pc:graphicFrameChg>
        <pc:graphicFrameChg chg="mod">
          <ac:chgData name="Olena Rudyk" userId="60c459c2-996e-48f7-b018-11285fe7a2eb" providerId="ADAL" clId="{66F37EBD-D82F-4541-8D16-9A871765B2A1}" dt="2026-03-08T12:20:01.917" v="125" actId="255"/>
          <ac:graphicFrameMkLst>
            <pc:docMk/>
            <pc:sldMk cId="2388955421" sldId="267"/>
            <ac:graphicFrameMk id="18" creationId="{4664F6E3-039C-0DAF-3C32-124620EBC783}"/>
          </ac:graphicFrameMkLst>
        </pc:graphicFrameChg>
        <pc:graphicFrameChg chg="mod">
          <ac:chgData name="Olena Rudyk" userId="60c459c2-996e-48f7-b018-11285fe7a2eb" providerId="ADAL" clId="{66F37EBD-D82F-4541-8D16-9A871765B2A1}" dt="2026-03-08T12:20:05.831" v="126" actId="255"/>
          <ac:graphicFrameMkLst>
            <pc:docMk/>
            <pc:sldMk cId="2388955421" sldId="267"/>
            <ac:graphicFrameMk id="21" creationId="{39B29F1D-5F31-59A2-C1DF-EECA548B90DE}"/>
          </ac:graphicFrameMkLst>
        </pc:graphicFrameChg>
        <pc:graphicFrameChg chg="mod">
          <ac:chgData name="Olena Rudyk" userId="60c459c2-996e-48f7-b018-11285fe7a2eb" providerId="ADAL" clId="{66F37EBD-D82F-4541-8D16-9A871765B2A1}" dt="2026-03-08T12:20:09.405" v="127" actId="255"/>
          <ac:graphicFrameMkLst>
            <pc:docMk/>
            <pc:sldMk cId="2388955421" sldId="267"/>
            <ac:graphicFrameMk id="23" creationId="{719BC05D-DE7F-35D3-4C6C-7C5BFBCC85C1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Olena\Documents\EXPERIMENTAL%20DATA\Myograph%20data\Data%20analysis\U-46619%20dose-response%20PKA%20mice.xls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oleObject" Target="file:///C:\Users\Olena\Documents\EXPERIMENTAL%20DATA\PKA%20KI%20mice\AngII%20%20in%20PKA%20KI%20mice\AngII%20Echo%20analysis%202016\AngII_3%20weeks_Echo_analysed_COMBINED%20DATA%202%20COHORTS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Olena\Documents\EXPERIMENTAL%20DATA\PKA%20KI%20mice\AngII%20treatment%20cells\PKA%20AngII%20treatments%20Cells%20and%20vessels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Olena\Documents\EXPERIMENTAL%20DATA\PKA%20KI%20mice\AngII%20treatment%20cells\PKA%20AngII%20treatments%20Cells%20and%20vessels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Olena\Documents\EXPERIMENTAL%20DATA\PKA%20KI%20mice\AngII%20%20in%20PKA%20KI%20mice\AngII_3%20weeks_blood%20biochemistry%20analysed.xls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C:\Users\Olena\Documents\EXPERIMENTAL%20DATA\PKA%20KI%20mice\AngII%20%20in%20PKA%20KI%20mice\AngII_3%20weeks_blood%20biochemistry%20analysed.xls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C:\Users\Olena\Documents\EXPERIMENTAL%20DATA\PKA%20KI%20mice\AngII%20%20in%20PKA%20KI%20mice\AngII_3%20weeks_blood%20biochemistry%20analysed.xls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C:\Users\Olena\Documents\EXPERIMENTAL%20DATA\PKA%20KI%20mice\AngII%20%20in%20PKA%20KI%20mice\AngII%20Echo%20analysis%202016\AngII_3%20weeks_Echo_analysed_COMBINED%20DATA%202%20COHORTS.xls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C:\Users\Olena\Documents\EXPERIMENTAL%20DATA\PKA%20KI%20mice\AngII%20%20in%20PKA%20KI%20mice\AngII%20Echo%20analysis%202016\AngII_3%20weeks_Echo_analysed_COMBINED%20DATA%202%20COHORTS.xls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C:\Users\Olena\Documents\EXPERIMENTAL%20DATA\PKA%20KI%20mice\AngII%20%20in%20PKA%20KI%20mice\AngII%20Echo%20analysis%202016\AngII_3%20weeks_Echo_analysed_COMBINED%20DATA%202%20COHORT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00219103898133"/>
          <c:y val="4.1077984910005909E-2"/>
          <c:w val="0.73441208641430356"/>
          <c:h val="0.7746314920473264"/>
        </c:manualLayout>
      </c:layout>
      <c:lineChart>
        <c:grouping val="standard"/>
        <c:varyColors val="0"/>
        <c:ser>
          <c:idx val="0"/>
          <c:order val="0"/>
          <c:tx>
            <c:strRef>
              <c:f>'WT PE'!$B$1</c:f>
              <c:strCache>
                <c:ptCount val="1"/>
                <c:pt idx="0">
                  <c:v>WT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WT PE'!$C$20:$C$28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6.2665623687607631E-3</c:v>
                  </c:pt>
                  <c:pt idx="2">
                    <c:v>1.0596848711498104E-2</c:v>
                  </c:pt>
                  <c:pt idx="3">
                    <c:v>2.7995638633511909E-2</c:v>
                  </c:pt>
                  <c:pt idx="4">
                    <c:v>0.1533648319037032</c:v>
                  </c:pt>
                  <c:pt idx="5">
                    <c:v>0.34447728524918947</c:v>
                  </c:pt>
                  <c:pt idx="6">
                    <c:v>0.30943872918062754</c:v>
                  </c:pt>
                  <c:pt idx="7">
                    <c:v>0.29277882079907408</c:v>
                  </c:pt>
                  <c:pt idx="8">
                    <c:v>0.71762707629032818</c:v>
                  </c:pt>
                </c:numCache>
              </c:numRef>
            </c:plus>
            <c:minus>
              <c:numRef>
                <c:f>'WT PE'!$C$20:$C$28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6.2665623687607631E-3</c:v>
                  </c:pt>
                  <c:pt idx="2">
                    <c:v>1.0596848711498104E-2</c:v>
                  </c:pt>
                  <c:pt idx="3">
                    <c:v>2.7995638633511909E-2</c:v>
                  </c:pt>
                  <c:pt idx="4">
                    <c:v>0.1533648319037032</c:v>
                  </c:pt>
                  <c:pt idx="5">
                    <c:v>0.34447728524918947</c:v>
                  </c:pt>
                  <c:pt idx="6">
                    <c:v>0.30943872918062754</c:v>
                  </c:pt>
                  <c:pt idx="7">
                    <c:v>0.29277882079907408</c:v>
                  </c:pt>
                  <c:pt idx="8">
                    <c:v>0.71762707629032818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WT PE'!$A$20:$A$28</c:f>
              <c:numCache>
                <c:formatCode>General</c:formatCode>
                <c:ptCount val="9"/>
                <c:pt idx="0">
                  <c:v>0</c:v>
                </c:pt>
                <c:pt idx="1">
                  <c:v>-9</c:v>
                </c:pt>
                <c:pt idx="2">
                  <c:v>-8.5</c:v>
                </c:pt>
                <c:pt idx="3">
                  <c:v>-8</c:v>
                </c:pt>
                <c:pt idx="4">
                  <c:v>-7.5</c:v>
                </c:pt>
                <c:pt idx="5">
                  <c:v>-7</c:v>
                </c:pt>
                <c:pt idx="6">
                  <c:v>-6.5</c:v>
                </c:pt>
                <c:pt idx="7">
                  <c:v>-6</c:v>
                </c:pt>
                <c:pt idx="8">
                  <c:v>-5.5</c:v>
                </c:pt>
              </c:numCache>
            </c:numRef>
          </c:cat>
          <c:val>
            <c:numRef>
              <c:f>'WT PE'!$B$20:$B$28</c:f>
              <c:numCache>
                <c:formatCode>0.00</c:formatCode>
                <c:ptCount val="9"/>
                <c:pt idx="0">
                  <c:v>0</c:v>
                </c:pt>
                <c:pt idx="1">
                  <c:v>-1.1966666666666632E-2</c:v>
                </c:pt>
                <c:pt idx="2">
                  <c:v>-9.566666666666588E-3</c:v>
                </c:pt>
                <c:pt idx="3">
                  <c:v>7.2905555555555598E-2</c:v>
                </c:pt>
                <c:pt idx="4">
                  <c:v>0.69090555555555533</c:v>
                </c:pt>
                <c:pt idx="5">
                  <c:v>4.2811722222222208</c:v>
                </c:pt>
                <c:pt idx="6">
                  <c:v>6.6154111111111105</c:v>
                </c:pt>
                <c:pt idx="7">
                  <c:v>8.0230666666666668</c:v>
                </c:pt>
                <c:pt idx="8">
                  <c:v>8.508274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B2C-4CD0-8955-B6A7F2A1684F}"/>
            </c:ext>
          </c:extLst>
        </c:ser>
        <c:ser>
          <c:idx val="1"/>
          <c:order val="1"/>
          <c:tx>
            <c:strRef>
              <c:f>'PKA KI PE'!$B$1</c:f>
              <c:strCache>
                <c:ptCount val="1"/>
                <c:pt idx="0">
                  <c:v>PKA KI</c:v>
                </c:pt>
              </c:strCache>
            </c:strRef>
          </c:tx>
          <c:spPr>
            <a:ln w="9525">
              <a:solidFill>
                <a:srgbClr val="C00000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rgbClr val="C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KA KI PE'!$C$20:$C$28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7.2857679398732039E-3</c:v>
                  </c:pt>
                  <c:pt idx="2">
                    <c:v>8.8701216392300334E-3</c:v>
                  </c:pt>
                  <c:pt idx="3">
                    <c:v>2.7137192869604355E-2</c:v>
                  </c:pt>
                  <c:pt idx="4">
                    <c:v>0.27514902067597374</c:v>
                  </c:pt>
                  <c:pt idx="5">
                    <c:v>0.43320504051807074</c:v>
                  </c:pt>
                  <c:pt idx="6">
                    <c:v>0.42292133887247152</c:v>
                  </c:pt>
                  <c:pt idx="7">
                    <c:v>0.44269127968656186</c:v>
                  </c:pt>
                  <c:pt idx="8">
                    <c:v>0.47494165654553927</c:v>
                  </c:pt>
                </c:numCache>
              </c:numRef>
            </c:plus>
            <c:minus>
              <c:numRef>
                <c:f>'PKA KI PE'!$C$20:$C$28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7.2857679398732039E-3</c:v>
                  </c:pt>
                  <c:pt idx="2">
                    <c:v>8.8701216392300334E-3</c:v>
                  </c:pt>
                  <c:pt idx="3">
                    <c:v>2.7137192869604355E-2</c:v>
                  </c:pt>
                  <c:pt idx="4">
                    <c:v>0.27514902067597374</c:v>
                  </c:pt>
                  <c:pt idx="5">
                    <c:v>0.43320504051807074</c:v>
                  </c:pt>
                  <c:pt idx="6">
                    <c:v>0.42292133887247152</c:v>
                  </c:pt>
                  <c:pt idx="7">
                    <c:v>0.44269127968656186</c:v>
                  </c:pt>
                  <c:pt idx="8">
                    <c:v>0.47494165654553927</c:v>
                  </c:pt>
                </c:numCache>
              </c:numRef>
            </c:minus>
            <c:spPr>
              <a:ln w="3175">
                <a:solidFill>
                  <a:srgbClr val="C00000"/>
                </a:solidFill>
                <a:prstDash val="solid"/>
              </a:ln>
            </c:spPr>
          </c:errBars>
          <c:cat>
            <c:numRef>
              <c:f>'WT PE'!$A$20:$A$28</c:f>
              <c:numCache>
                <c:formatCode>General</c:formatCode>
                <c:ptCount val="9"/>
                <c:pt idx="0">
                  <c:v>0</c:v>
                </c:pt>
                <c:pt idx="1">
                  <c:v>-9</c:v>
                </c:pt>
                <c:pt idx="2">
                  <c:v>-8.5</c:v>
                </c:pt>
                <c:pt idx="3">
                  <c:v>-8</c:v>
                </c:pt>
                <c:pt idx="4">
                  <c:v>-7.5</c:v>
                </c:pt>
                <c:pt idx="5">
                  <c:v>-7</c:v>
                </c:pt>
                <c:pt idx="6">
                  <c:v>-6.5</c:v>
                </c:pt>
                <c:pt idx="7">
                  <c:v>-6</c:v>
                </c:pt>
                <c:pt idx="8">
                  <c:v>-5.5</c:v>
                </c:pt>
              </c:numCache>
            </c:numRef>
          </c:cat>
          <c:val>
            <c:numRef>
              <c:f>'PKA KI PE'!$B$20:$B$28</c:f>
              <c:numCache>
                <c:formatCode>0.00</c:formatCode>
                <c:ptCount val="9"/>
                <c:pt idx="0">
                  <c:v>0</c:v>
                </c:pt>
                <c:pt idx="1">
                  <c:v>-6.9749999999999977E-3</c:v>
                </c:pt>
                <c:pt idx="2">
                  <c:v>2.8300000000000326E-3</c:v>
                </c:pt>
                <c:pt idx="3">
                  <c:v>0.11984999999999997</c:v>
                </c:pt>
                <c:pt idx="4">
                  <c:v>1.343</c:v>
                </c:pt>
                <c:pt idx="5">
                  <c:v>4.7926549999999999</c:v>
                </c:pt>
                <c:pt idx="6">
                  <c:v>6.9981200000000001</c:v>
                </c:pt>
                <c:pt idx="7">
                  <c:v>8.2678700000000003</c:v>
                </c:pt>
                <c:pt idx="8">
                  <c:v>7.5548300000000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B2C-4CD0-8955-B6A7F2A168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2914304"/>
        <c:axId val="122916224"/>
      </c:lineChart>
      <c:catAx>
        <c:axId val="1229143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Log U-46619 (M)</a:t>
                </a:r>
              </a:p>
            </c:rich>
          </c:tx>
          <c:layout>
            <c:manualLayout>
              <c:xMode val="edge"/>
              <c:yMode val="edge"/>
              <c:x val="0.36610255837086098"/>
              <c:y val="0.90878857551407233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>
            <a:solidFill>
              <a:schemeClr val="bg1">
                <a:lumMod val="75000"/>
              </a:schemeClr>
            </a:solidFill>
          </a:ln>
        </c:spPr>
        <c:txPr>
          <a:bodyPr rot="0"/>
          <a:lstStyle/>
          <a:p>
            <a:pPr>
              <a:defRPr sz="1200"/>
            </a:pPr>
            <a:endParaRPr lang="en-US"/>
          </a:p>
        </c:txPr>
        <c:crossAx val="122916224"/>
        <c:crossesAt val="-0.5"/>
        <c:auto val="1"/>
        <c:lblAlgn val="ctr"/>
        <c:lblOffset val="100"/>
        <c:noMultiLvlLbl val="0"/>
      </c:catAx>
      <c:valAx>
        <c:axId val="122916224"/>
        <c:scaling>
          <c:orientation val="minMax"/>
          <c:max val="1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0"/>
                </a:pPr>
                <a:r>
                  <a:rPr lang="en-US" sz="1400" b="0"/>
                  <a:t>Force of constriction (mN)</a:t>
                </a:r>
              </a:p>
            </c:rich>
          </c:tx>
          <c:layout>
            <c:manualLayout>
              <c:xMode val="edge"/>
              <c:yMode val="edge"/>
              <c:x val="8.817762813471984E-3"/>
              <c:y val="0.15153062384405841"/>
            </c:manualLayout>
          </c:layout>
          <c:overlay val="0"/>
        </c:title>
        <c:numFmt formatCode="General" sourceLinked="0"/>
        <c:majorTickMark val="in"/>
        <c:minorTickMark val="none"/>
        <c:tickLblPos val="nextTo"/>
        <c:spPr>
          <a:ln>
            <a:solidFill>
              <a:schemeClr val="bg1">
                <a:lumMod val="75000"/>
              </a:schemeClr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122914304"/>
        <c:crossesAt val="1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20338310789926012"/>
          <c:y val="0.13903421787802886"/>
          <c:w val="0.27947278752114946"/>
          <c:h val="0.11976314809841955"/>
        </c:manualLayout>
      </c:layout>
      <c:overlay val="0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83408871698352"/>
          <c:y val="0.1065074402163932"/>
          <c:w val="0.68416314271507961"/>
          <c:h val="0.78199587800901937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7663-4BB0-9DDF-7DD90E66C26A}"/>
              </c:ext>
            </c:extLst>
          </c:dPt>
          <c:errBars>
            <c:errBarType val="plus"/>
            <c:errValType val="cust"/>
            <c:noEndCap val="0"/>
            <c:plus>
              <c:numRef>
                <c:f>('Combined data and graphs'!$C$67,'Combined data and graphs'!$E$67)</c:f>
                <c:numCache>
                  <c:formatCode>General</c:formatCode>
                  <c:ptCount val="2"/>
                  <c:pt idx="0">
                    <c:v>1.3674309916799552</c:v>
                  </c:pt>
                  <c:pt idx="1">
                    <c:v>1.4639942481888986</c:v>
                  </c:pt>
                </c:numCache>
              </c:numRef>
            </c:plus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'Combined data and graphs'!$B$42:$D$42</c:f>
              <c:strCache>
                <c:ptCount val="2"/>
                <c:pt idx="0">
                  <c:v>Veh</c:v>
                </c:pt>
                <c:pt idx="1">
                  <c:v>AngII </c:v>
                </c:pt>
              </c:strCache>
            </c:strRef>
          </c:cat>
          <c:val>
            <c:numRef>
              <c:f>('Combined data and graphs'!$B$67,'Combined data and graphs'!$D$67)</c:f>
              <c:numCache>
                <c:formatCode>General</c:formatCode>
                <c:ptCount val="2"/>
                <c:pt idx="0">
                  <c:v>26.42642857142857</c:v>
                </c:pt>
                <c:pt idx="1">
                  <c:v>21.247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63-4BB0-9DDF-7DD90E66C26A}"/>
            </c:ext>
          </c:extLst>
        </c:ser>
        <c:ser>
          <c:idx val="1"/>
          <c:order val="1"/>
          <c:tx>
            <c:v>PKA KI</c:v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C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663-4BB0-9DDF-7DD90E66C26A}"/>
              </c:ext>
            </c:extLst>
          </c:dPt>
          <c:errBars>
            <c:errBarType val="plus"/>
            <c:errValType val="cust"/>
            <c:noEndCap val="0"/>
            <c:plus>
              <c:numRef>
                <c:f>('Combined data and graphs'!$C$104,'Combined data and graphs'!$E$104)</c:f>
                <c:numCache>
                  <c:formatCode>General</c:formatCode>
                  <c:ptCount val="2"/>
                  <c:pt idx="0">
                    <c:v>2.0553887925956178</c:v>
                  </c:pt>
                  <c:pt idx="1">
                    <c:v>1.2639510213728054</c:v>
                  </c:pt>
                </c:numCache>
              </c:numRef>
            </c:plus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'Combined data and graphs'!$B$42:$D$42</c:f>
              <c:strCache>
                <c:ptCount val="2"/>
                <c:pt idx="0">
                  <c:v>Veh</c:v>
                </c:pt>
                <c:pt idx="1">
                  <c:v>AngII </c:v>
                </c:pt>
              </c:strCache>
            </c:strRef>
          </c:cat>
          <c:val>
            <c:numRef>
              <c:f>('Combined data and graphs'!$B$104,'Combined data and graphs'!$D$104)</c:f>
              <c:numCache>
                <c:formatCode>General</c:formatCode>
                <c:ptCount val="2"/>
                <c:pt idx="0">
                  <c:v>25.614479166666669</c:v>
                </c:pt>
                <c:pt idx="1">
                  <c:v>18.0761904761904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63-4BB0-9DDF-7DD90E66C2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4931328"/>
        <c:axId val="234932864"/>
      </c:barChart>
      <c:catAx>
        <c:axId val="234931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34932864"/>
        <c:crosses val="autoZero"/>
        <c:auto val="1"/>
        <c:lblAlgn val="ctr"/>
        <c:lblOffset val="100"/>
        <c:noMultiLvlLbl val="0"/>
      </c:catAx>
      <c:valAx>
        <c:axId val="234932864"/>
        <c:scaling>
          <c:orientation val="minMax"/>
          <c:max val="5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200" b="0" i="0" u="none" strike="noStrike" baseline="0">
                    <a:solidFill>
                      <a:sysClr val="windowText" lastClr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>
                    <a:solidFill>
                      <a:sysClr val="windowText" lastClr="000000"/>
                    </a:solidFill>
                  </a:rPr>
                  <a:t>Cardiac output (ml/min)</a:t>
                </a:r>
              </a:p>
            </c:rich>
          </c:tx>
          <c:layout>
            <c:manualLayout>
              <c:xMode val="edge"/>
              <c:yMode val="edge"/>
              <c:x val="5.5977534041073182E-2"/>
              <c:y val="0.23537386812041985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34931328"/>
        <c:crosses val="autoZero"/>
        <c:crossBetween val="between"/>
        <c:majorUnit val="10"/>
      </c:valAx>
    </c:plotArea>
    <c:legend>
      <c:legendPos val="r"/>
      <c:layout>
        <c:manualLayout>
          <c:xMode val="edge"/>
          <c:yMode val="edge"/>
          <c:x val="0.32969071833820429"/>
          <c:y val="0.1061189879860809"/>
          <c:w val="0.18814004730890121"/>
          <c:h val="8.484756046799817E-2"/>
        </c:manualLayout>
      </c:layout>
      <c:overlay val="0"/>
      <c:txPr>
        <a:bodyPr/>
        <a:lstStyle/>
        <a:p>
          <a:pPr>
            <a:defRPr sz="1000" b="0" i="0" u="none" strike="noStrike" baseline="0">
              <a:solidFill>
                <a:srgbClr val="000000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788844001617641"/>
          <c:y val="5.1099391038254748E-2"/>
          <c:w val="0.76586792121115888"/>
          <c:h val="0.7766426253493268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A0F-4D06-B8B4-0318C9DDCD0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A0F-4D06-B8B4-0318C9DDCD09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DA0F-4D06-B8B4-0318C9DDCD09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DA0F-4D06-B8B4-0318C9DDCD09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DA0F-4D06-B8B4-0318C9DDCD09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DA0F-4D06-B8B4-0318C9DDCD09}"/>
              </c:ext>
            </c:extLst>
          </c:dPt>
          <c:errBars>
            <c:errBarType val="both"/>
            <c:errValType val="cust"/>
            <c:noEndCap val="0"/>
            <c:plus>
              <c:numRef>
                <c:f>(SMCs_2_3_18_30min_Yang_1!$C$9,SMCs_2_3_18_30min_Yang_1!$E$9,SMCs_2_3_18_30min_Yang_1!$G$9,SMCs_2_3_18_30min_Yang_1!$I$9,SMCs_2_3_18_30min_Yang_1!$K$9,SMCs_2_3_18_30min_Yang_1!$M$9)</c:f>
                <c:numCache>
                  <c:formatCode>General</c:formatCode>
                  <c:ptCount val="6"/>
                  <c:pt idx="0">
                    <c:v>2.1308823020967691</c:v>
                  </c:pt>
                  <c:pt idx="1">
                    <c:v>0.85606402437799278</c:v>
                  </c:pt>
                  <c:pt idx="2">
                    <c:v>3.3898200967812812E-2</c:v>
                  </c:pt>
                  <c:pt idx="3">
                    <c:v>4.7853205905319038</c:v>
                  </c:pt>
                  <c:pt idx="4">
                    <c:v>2.6121639672131565</c:v>
                  </c:pt>
                  <c:pt idx="5">
                    <c:v>0.13894666402848088</c:v>
                  </c:pt>
                </c:numCache>
              </c:numRef>
            </c:plus>
            <c:minus>
              <c:numRef>
                <c:f>(SMCs_2_3_18_30min_Yang_1!$C$9,SMCs_2_3_18_30min_Yang_1!$E$9,SMCs_2_3_18_30min_Yang_1!$G$9,SMCs_2_3_18_30min_Yang_1!$I$9,SMCs_2_3_18_30min_Yang_1!$K$9,SMCs_2_3_18_30min_Yang_1!$M$9)</c:f>
                <c:numCache>
                  <c:formatCode>General</c:formatCode>
                  <c:ptCount val="6"/>
                  <c:pt idx="0">
                    <c:v>2.1308823020967691</c:v>
                  </c:pt>
                  <c:pt idx="1">
                    <c:v>0.85606402437799278</c:v>
                  </c:pt>
                  <c:pt idx="2">
                    <c:v>3.3898200967812812E-2</c:v>
                  </c:pt>
                  <c:pt idx="3">
                    <c:v>4.7853205905319038</c:v>
                  </c:pt>
                  <c:pt idx="4">
                    <c:v>2.6121639672131565</c:v>
                  </c:pt>
                  <c:pt idx="5">
                    <c:v>0.13894666402848088</c:v>
                  </c:pt>
                </c:numCache>
              </c:numRef>
            </c:minus>
          </c:errBars>
          <c:cat>
            <c:strRef>
              <c:f>(SMCs_2_3_18_30min_Yang_1!$B$2,SMCs_2_3_18_30min_Yang_1!$D$2,SMCs_2_3_18_30min_Yang_1!$F$2,SMCs_2_3_18_30min_Yang_1!$H$2,SMCs_2_3_18_30min_Yang_1!$J$2,SMCs_2_3_18_30min_Yang_1!$L$2)</c:f>
              <c:strCache>
                <c:ptCount val="6"/>
                <c:pt idx="0">
                  <c:v>Vehicle </c:v>
                </c:pt>
                <c:pt idx="1">
                  <c:v>H2O2 100µM</c:v>
                </c:pt>
                <c:pt idx="2">
                  <c:v>AngII 10nM</c:v>
                </c:pt>
                <c:pt idx="3">
                  <c:v>AngII 100nM</c:v>
                </c:pt>
                <c:pt idx="4">
                  <c:v>AngII 1µM</c:v>
                </c:pt>
                <c:pt idx="5">
                  <c:v>AngII 10µM</c:v>
                </c:pt>
              </c:strCache>
            </c:strRef>
          </c:cat>
          <c:val>
            <c:numRef>
              <c:f>(SMCs_2_3_18_30min_Yang_1!$B$9,SMCs_2_3_18_30min_Yang_1!$D$9,SMCs_2_3_18_30min_Yang_1!$F$9,SMCs_2_3_18_30min_Yang_1!$H$9,SMCs_2_3_18_30min_Yang_1!$J$9,SMCs_2_3_18_30min_Yang_1!$L$9)</c:f>
              <c:numCache>
                <c:formatCode>General</c:formatCode>
                <c:ptCount val="6"/>
                <c:pt idx="0">
                  <c:v>7.7141984284647247</c:v>
                </c:pt>
                <c:pt idx="1">
                  <c:v>81.589381201163889</c:v>
                </c:pt>
                <c:pt idx="2">
                  <c:v>12.646628563011991</c:v>
                </c:pt>
                <c:pt idx="3">
                  <c:v>24.51001677155714</c:v>
                </c:pt>
                <c:pt idx="4">
                  <c:v>65.149591231209541</c:v>
                </c:pt>
                <c:pt idx="5">
                  <c:v>84.3812011816124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A0F-4D06-B8B4-0318C9DDCD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5652992"/>
        <c:axId val="275654528"/>
      </c:barChart>
      <c:catAx>
        <c:axId val="275652992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75654528"/>
        <c:crosses val="autoZero"/>
        <c:auto val="1"/>
        <c:lblAlgn val="ctr"/>
        <c:lblOffset val="100"/>
        <c:noMultiLvlLbl val="0"/>
      </c:catAx>
      <c:valAx>
        <c:axId val="275654528"/>
        <c:scaling>
          <c:orientation val="minMax"/>
          <c:max val="1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PKARI</a:t>
                </a:r>
                <a:r>
                  <a:rPr lang="el-GR" sz="12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α </a:t>
                </a:r>
                <a:r>
                  <a:rPr lang="en-GB" sz="12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sz="12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isulfide dimer (%)</a:t>
                </a:r>
                <a:endParaRPr lang="en-GB" sz="120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9874000180184974E-2"/>
              <c:y val="7.2332673892703411E-2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75652992"/>
        <c:crosses val="autoZero"/>
        <c:crossBetween val="between"/>
        <c:majorUnit val="2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0840121191330405"/>
          <c:y val="0.1031286597184473"/>
          <c:w val="0.66558261468039381"/>
          <c:h val="0.7480489999286195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8CDF-485A-B3B6-B009F5B6A4D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8CDF-485A-B3B6-B009F5B6A4D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8CDF-485A-B3B6-B009F5B6A4D4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8CDF-485A-B3B6-B009F5B6A4D4}"/>
              </c:ext>
            </c:extLst>
          </c:dPt>
          <c:errBars>
            <c:errBarType val="both"/>
            <c:errValType val="cust"/>
            <c:noEndCap val="0"/>
            <c:plus>
              <c:numRef>
                <c:f>(SMCs_2_3_18_30min_Me!$C$9,SMCs_2_3_18_30min_Me!$E$9,SMCs_2_3_18_30min_Me!$G$9,SMCs_2_3_18_30min_Me!$I$9,SMCs_2_3_18_30min_Me!$K$9,SMCs_2_3_18_30min_Me!$M$9)</c:f>
                <c:numCache>
                  <c:formatCode>General</c:formatCode>
                  <c:ptCount val="4"/>
                  <c:pt idx="0">
                    <c:v>0.41790464163585</c:v>
                  </c:pt>
                  <c:pt idx="1">
                    <c:v>2.536802969655283</c:v>
                  </c:pt>
                  <c:pt idx="2">
                    <c:v>2.0942164354630997</c:v>
                  </c:pt>
                  <c:pt idx="3">
                    <c:v>3.6348922051604435</c:v>
                  </c:pt>
                </c:numCache>
                <c:extLst/>
              </c:numRef>
            </c:plus>
            <c:minus>
              <c:numRef>
                <c:f>(SMCs_2_3_18_30min_Me!$C$9,SMCs_2_3_18_30min_Me!$E$9,SMCs_2_3_18_30min_Me!$G$9,SMCs_2_3_18_30min_Me!$I$9,SMCs_2_3_18_30min_Me!$K$9,SMCs_2_3_18_30min_Me!$M$9)</c:f>
                <c:numCache>
                  <c:formatCode>General</c:formatCode>
                  <c:ptCount val="4"/>
                  <c:pt idx="0">
                    <c:v>0.41790464163585</c:v>
                  </c:pt>
                  <c:pt idx="1">
                    <c:v>2.536802969655283</c:v>
                  </c:pt>
                  <c:pt idx="2">
                    <c:v>2.0942164354630997</c:v>
                  </c:pt>
                  <c:pt idx="3">
                    <c:v>3.6348922051604435</c:v>
                  </c:pt>
                </c:numCache>
                <c:extLst/>
              </c:numRef>
            </c:minus>
          </c:errBars>
          <c:cat>
            <c:strRef>
              <c:f>(SMCs_2_3_18_30min_Me!$B$2,SMCs_2_3_18_30min_Me!$D$2,SMCs_2_3_18_30min_Me!$F$2,SMCs_2_3_18_30min_Me!$H$2,SMCs_2_3_18_30min_Me!$J$2,SMCs_2_3_18_30min_Me!$L$2)</c:f>
              <c:strCache>
                <c:ptCount val="4"/>
                <c:pt idx="0">
                  <c:v>Vehicle </c:v>
                </c:pt>
                <c:pt idx="1">
                  <c:v>AngII 1nM</c:v>
                </c:pt>
                <c:pt idx="2">
                  <c:v>AngII 10nM</c:v>
                </c:pt>
                <c:pt idx="3">
                  <c:v>AngII 100nM</c:v>
                </c:pt>
              </c:strCache>
              <c:extLst/>
            </c:strRef>
          </c:cat>
          <c:val>
            <c:numRef>
              <c:f>(SMCs_2_3_18_30min_Me!$B$9,SMCs_2_3_18_30min_Me!$D$9,SMCs_2_3_18_30min_Me!$F$9,SMCs_2_3_18_30min_Me!$H$9,SMCs_2_3_18_30min_Me!$J$9,SMCs_2_3_18_30min_Me!$L$9)</c:f>
              <c:numCache>
                <c:formatCode>General</c:formatCode>
                <c:ptCount val="4"/>
                <c:pt idx="0">
                  <c:v>15.981315091242486</c:v>
                </c:pt>
                <c:pt idx="1">
                  <c:v>15.656571780426459</c:v>
                </c:pt>
                <c:pt idx="2">
                  <c:v>19.324110495493798</c:v>
                </c:pt>
                <c:pt idx="3">
                  <c:v>24.5575810283835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8-8CDF-485A-B3B6-B009F5B6A4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6915328"/>
        <c:axId val="276917248"/>
      </c:barChart>
      <c:catAx>
        <c:axId val="276915328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76917248"/>
        <c:crosses val="autoZero"/>
        <c:auto val="1"/>
        <c:lblAlgn val="ctr"/>
        <c:lblOffset val="100"/>
        <c:noMultiLvlLbl val="0"/>
      </c:catAx>
      <c:valAx>
        <c:axId val="276917248"/>
        <c:scaling>
          <c:orientation val="minMax"/>
          <c:max val="3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PKARI</a:t>
                </a:r>
                <a:r>
                  <a:rPr lang="el-GR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α </a:t>
                </a:r>
                <a:r>
                  <a:rPr lang="en-GB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sz="1200" b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sulfide</a:t>
                </a:r>
                <a:r>
                  <a:rPr lang="en-US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 dimer (%)</a:t>
                </a:r>
              </a:p>
            </c:rich>
          </c:tx>
          <c:layout>
            <c:manualLayout>
              <c:xMode val="edge"/>
              <c:yMode val="edge"/>
              <c:x val="0.10583256952931155"/>
              <c:y val="0.101742355491424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76915328"/>
        <c:crosses val="autoZero"/>
        <c:crossBetween val="between"/>
        <c:majorUnit val="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779387669607196"/>
          <c:y val="4.6058523117901227E-2"/>
          <c:w val="0.72507294146371237"/>
          <c:h val="0.8576531322051388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E1AC-4C6B-8945-17A1C693C44D}"/>
              </c:ext>
            </c:extLst>
          </c:dPt>
          <c:errBars>
            <c:errBarType val="both"/>
            <c:errValType val="cust"/>
            <c:noEndCap val="0"/>
            <c:plus>
              <c:numRef>
                <c:f>(Analysis!$C$8,Analysis!$E$8)</c:f>
                <c:numCache>
                  <c:formatCode>General</c:formatCode>
                  <c:ptCount val="2"/>
                  <c:pt idx="0">
                    <c:v>2.6034165586355504</c:v>
                  </c:pt>
                  <c:pt idx="1">
                    <c:v>1.3149778198382918</c:v>
                  </c:pt>
                </c:numCache>
              </c:numRef>
            </c:plus>
            <c:minus>
              <c:numRef>
                <c:f>(Analysis!$C$8,Analysis!$E$8)</c:f>
                <c:numCache>
                  <c:formatCode>General</c:formatCode>
                  <c:ptCount val="2"/>
                  <c:pt idx="0">
                    <c:v>2.6034165586355504</c:v>
                  </c:pt>
                  <c:pt idx="1">
                    <c:v>1.3149778198382918</c:v>
                  </c:pt>
                </c:numCache>
              </c:numRef>
            </c:minus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(Analysis!$B$18,Analysis!$D$18)</c:f>
              <c:strCache>
                <c:ptCount val="2"/>
                <c:pt idx="0">
                  <c:v>Vehicle</c:v>
                </c:pt>
                <c:pt idx="1">
                  <c:v>AngII</c:v>
                </c:pt>
              </c:strCache>
            </c:strRef>
          </c:cat>
          <c:val>
            <c:numRef>
              <c:f>(Analysis!$B$8,Analysis!$D$8)</c:f>
              <c:numCache>
                <c:formatCode>General</c:formatCode>
                <c:ptCount val="2"/>
                <c:pt idx="0">
                  <c:v>15.333333333333334</c:v>
                </c:pt>
                <c:pt idx="1">
                  <c:v>25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1AC-4C6B-8945-17A1C693C44D}"/>
            </c:ext>
          </c:extLst>
        </c:ser>
        <c:ser>
          <c:idx val="1"/>
          <c:order val="1"/>
          <c:tx>
            <c:strRef>
              <c:f>Analysis!$B$19</c:f>
              <c:strCache>
                <c:ptCount val="1"/>
                <c:pt idx="0">
                  <c:v>PKA KI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C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1AC-4C6B-8945-17A1C693C44D}"/>
              </c:ext>
            </c:extLst>
          </c:dPt>
          <c:errBars>
            <c:errBarType val="both"/>
            <c:errValType val="cust"/>
            <c:noEndCap val="0"/>
            <c:plus>
              <c:numRef>
                <c:f>(Analysis!$C$25,Analysis!$E$25)</c:f>
                <c:numCache>
                  <c:formatCode>General</c:formatCode>
                  <c:ptCount val="2"/>
                  <c:pt idx="0">
                    <c:v>1.3149778198382918</c:v>
                  </c:pt>
                  <c:pt idx="1">
                    <c:v>2.0412414523193152</c:v>
                  </c:pt>
                </c:numCache>
              </c:numRef>
            </c:plus>
            <c:minus>
              <c:numRef>
                <c:f>(Analysis!$C$25,Analysis!$E$25)</c:f>
                <c:numCache>
                  <c:formatCode>General</c:formatCode>
                  <c:ptCount val="2"/>
                  <c:pt idx="0">
                    <c:v>1.3149778198382918</c:v>
                  </c:pt>
                  <c:pt idx="1">
                    <c:v>2.0412414523193152</c:v>
                  </c:pt>
                </c:numCache>
              </c:numRef>
            </c:minus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(Analysis!$B$18,Analysis!$D$18)</c:f>
              <c:strCache>
                <c:ptCount val="2"/>
                <c:pt idx="0">
                  <c:v>Vehicle</c:v>
                </c:pt>
                <c:pt idx="1">
                  <c:v>AngII</c:v>
                </c:pt>
              </c:strCache>
            </c:strRef>
          </c:cat>
          <c:val>
            <c:numRef>
              <c:f>(Analysis!$B$25,Analysis!$D$25)</c:f>
              <c:numCache>
                <c:formatCode>General</c:formatCode>
                <c:ptCount val="2"/>
                <c:pt idx="0">
                  <c:v>15.25</c:v>
                </c:pt>
                <c:pt idx="1">
                  <c:v>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1AC-4C6B-8945-17A1C693C4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4962048"/>
        <c:axId val="225021952"/>
      </c:barChart>
      <c:catAx>
        <c:axId val="224962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5021952"/>
        <c:crosses val="autoZero"/>
        <c:auto val="1"/>
        <c:lblAlgn val="ctr"/>
        <c:lblOffset val="100"/>
        <c:noMultiLvlLbl val="0"/>
      </c:catAx>
      <c:valAx>
        <c:axId val="225021952"/>
        <c:scaling>
          <c:orientation val="minMax"/>
          <c:max val="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UN (mg/dl)</a:t>
                </a:r>
              </a:p>
            </c:rich>
          </c:tx>
          <c:layout>
            <c:manualLayout>
              <c:xMode val="edge"/>
              <c:yMode val="edge"/>
              <c:x val="7.0973510673968902E-3"/>
              <c:y val="0.3188076833203440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4962048"/>
        <c:crosses val="autoZero"/>
        <c:crossBetween val="between"/>
        <c:majorUnit val="10"/>
        <c:minorUnit val="10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31744064461477822"/>
          <c:y val="5.0291953746638446E-2"/>
          <c:w val="0.22357685316454207"/>
          <c:h val="8.4299261353940669E-2"/>
        </c:manualLayout>
      </c:layout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56702069218092"/>
          <c:y val="6.5054183147422714E-2"/>
          <c:w val="0.75213481316554243"/>
          <c:h val="0.840964002721767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51EB-4E8E-A0E5-D7EC2AE8B87B}"/>
              </c:ext>
            </c:extLst>
          </c:dPt>
          <c:errBars>
            <c:errBarType val="both"/>
            <c:errValType val="cust"/>
            <c:noEndCap val="0"/>
            <c:plus>
              <c:numRef>
                <c:f>(Analysis!$C$16,Analysis!$E$16)</c:f>
                <c:numCache>
                  <c:formatCode>General</c:formatCode>
                  <c:ptCount val="2"/>
                  <c:pt idx="0">
                    <c:v>0.90000000000000135</c:v>
                  </c:pt>
                  <c:pt idx="1">
                    <c:v>1.2254250963101192</c:v>
                  </c:pt>
                </c:numCache>
              </c:numRef>
            </c:plus>
            <c:minus>
              <c:numRef>
                <c:f>(Analysis!$C$16,Analysis!$E$16)</c:f>
                <c:numCache>
                  <c:formatCode>General</c:formatCode>
                  <c:ptCount val="2"/>
                  <c:pt idx="0">
                    <c:v>0.90000000000000135</c:v>
                  </c:pt>
                  <c:pt idx="1">
                    <c:v>1.2254250963101192</c:v>
                  </c:pt>
                </c:numCache>
              </c:numRef>
            </c:minus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(Analysis!$B$18,Analysis!$D$18)</c:f>
              <c:strCache>
                <c:ptCount val="2"/>
                <c:pt idx="0">
                  <c:v>Vehicle</c:v>
                </c:pt>
                <c:pt idx="1">
                  <c:v>AngII</c:v>
                </c:pt>
              </c:strCache>
            </c:strRef>
          </c:cat>
          <c:val>
            <c:numRef>
              <c:f>(Analysis!$B$16,Analysis!$D$16)</c:f>
              <c:numCache>
                <c:formatCode>General</c:formatCode>
                <c:ptCount val="2"/>
                <c:pt idx="0">
                  <c:v>9.4</c:v>
                </c:pt>
                <c:pt idx="1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EB-4E8E-A0E5-D7EC2AE8B87B}"/>
            </c:ext>
          </c:extLst>
        </c:ser>
        <c:ser>
          <c:idx val="1"/>
          <c:order val="1"/>
          <c:tx>
            <c:strRef>
              <c:f>Analysis!$B$19</c:f>
              <c:strCache>
                <c:ptCount val="1"/>
                <c:pt idx="0">
                  <c:v>PKA KI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C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1EB-4E8E-A0E5-D7EC2AE8B87B}"/>
              </c:ext>
            </c:extLst>
          </c:dPt>
          <c:errBars>
            <c:errBarType val="both"/>
            <c:errValType val="cust"/>
            <c:noEndCap val="0"/>
            <c:plus>
              <c:numRef>
                <c:f>(Analysis!$C$33,Analysis!$E$33)</c:f>
                <c:numCache>
                  <c:formatCode>General</c:formatCode>
                  <c:ptCount val="2"/>
                  <c:pt idx="0">
                    <c:v>0.35590260840104382</c:v>
                  </c:pt>
                  <c:pt idx="1">
                    <c:v>0.45643546458763873</c:v>
                  </c:pt>
                </c:numCache>
              </c:numRef>
            </c:plus>
            <c:minus>
              <c:numRef>
                <c:f>(Analysis!$C$33,Analysis!$E$33)</c:f>
                <c:numCache>
                  <c:formatCode>General</c:formatCode>
                  <c:ptCount val="2"/>
                  <c:pt idx="0">
                    <c:v>0.35590260840104382</c:v>
                  </c:pt>
                  <c:pt idx="1">
                    <c:v>0.45643546458763873</c:v>
                  </c:pt>
                </c:numCache>
              </c:numRef>
            </c:minus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(Analysis!$B$18,Analysis!$D$18)</c:f>
              <c:strCache>
                <c:ptCount val="2"/>
                <c:pt idx="0">
                  <c:v>Vehicle</c:v>
                </c:pt>
                <c:pt idx="1">
                  <c:v>AngII</c:v>
                </c:pt>
              </c:strCache>
            </c:strRef>
          </c:cat>
          <c:val>
            <c:numRef>
              <c:f>(Analysis!$B$33,Analysis!$D$33)</c:f>
              <c:numCache>
                <c:formatCode>General</c:formatCode>
                <c:ptCount val="2"/>
                <c:pt idx="0">
                  <c:v>9.1</c:v>
                </c:pt>
                <c:pt idx="1">
                  <c:v>1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1EB-4E8E-A0E5-D7EC2AE8B8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5739904"/>
        <c:axId val="225751424"/>
      </c:barChart>
      <c:catAx>
        <c:axId val="225739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5751424"/>
        <c:crosses val="autoZero"/>
        <c:auto val="1"/>
        <c:lblAlgn val="ctr"/>
        <c:lblOffset val="100"/>
        <c:noMultiLvlLbl val="0"/>
      </c:catAx>
      <c:valAx>
        <c:axId val="225751424"/>
        <c:scaling>
          <c:orientation val="minMax"/>
          <c:max val="2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moglobin (g/dl)</a:t>
                </a:r>
              </a:p>
            </c:rich>
          </c:tx>
          <c:layout>
            <c:manualLayout>
              <c:xMode val="edge"/>
              <c:yMode val="edge"/>
              <c:x val="1.2921372987374757E-2"/>
              <c:y val="0.2732077251481407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5739904"/>
        <c:crosses val="autoZero"/>
        <c:crossBetween val="between"/>
        <c:majorUnit val="5"/>
        <c:minorUnit val="5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30968799733985264"/>
          <c:y val="6.7630308623974206E-2"/>
          <c:w val="0.27878051483889588"/>
          <c:h val="8.4299261353940669E-2"/>
        </c:manualLayout>
      </c:layout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954617591405727"/>
          <c:y val="6.4831184027693139E-2"/>
          <c:w val="0.69018922053347986"/>
          <c:h val="0.82910010027885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F193-4E16-B050-8BF00404C459}"/>
              </c:ext>
            </c:extLst>
          </c:dPt>
          <c:errBars>
            <c:errBarType val="both"/>
            <c:errValType val="cust"/>
            <c:noEndCap val="0"/>
            <c:plus>
              <c:numRef>
                <c:f>(Analysis!$C$10,Analysis!$E$10)</c:f>
                <c:numCache>
                  <c:formatCode>General</c:formatCode>
                  <c:ptCount val="2"/>
                  <c:pt idx="0">
                    <c:v>2.6666666666666621</c:v>
                  </c:pt>
                  <c:pt idx="1">
                    <c:v>3.5910769044025406</c:v>
                  </c:pt>
                </c:numCache>
              </c:numRef>
            </c:plus>
            <c:minus>
              <c:numRef>
                <c:f>(Analysis!$C$10,Analysis!$E$10)</c:f>
                <c:numCache>
                  <c:formatCode>General</c:formatCode>
                  <c:ptCount val="2"/>
                  <c:pt idx="0">
                    <c:v>2.6666666666666621</c:v>
                  </c:pt>
                  <c:pt idx="1">
                    <c:v>3.5910769044025406</c:v>
                  </c:pt>
                </c:numCache>
              </c:numRef>
            </c:minus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(Analysis!$B$18,Analysis!$D$18)</c:f>
              <c:strCache>
                <c:ptCount val="2"/>
                <c:pt idx="0">
                  <c:v>Vehicle</c:v>
                </c:pt>
                <c:pt idx="1">
                  <c:v>AngII</c:v>
                </c:pt>
              </c:strCache>
            </c:strRef>
          </c:cat>
          <c:val>
            <c:numRef>
              <c:f>(Analysis!$B$10,Analysis!$D$10)</c:f>
              <c:numCache>
                <c:formatCode>General</c:formatCode>
                <c:ptCount val="2"/>
                <c:pt idx="0">
                  <c:v>27.666666666666668</c:v>
                </c:pt>
                <c:pt idx="1">
                  <c:v>38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93-4E16-B050-8BF00404C459}"/>
            </c:ext>
          </c:extLst>
        </c:ser>
        <c:ser>
          <c:idx val="1"/>
          <c:order val="1"/>
          <c:tx>
            <c:strRef>
              <c:f>Analysis!$B$19</c:f>
              <c:strCache>
                <c:ptCount val="1"/>
                <c:pt idx="0">
                  <c:v>PKA KI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C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193-4E16-B050-8BF00404C459}"/>
              </c:ext>
            </c:extLst>
          </c:dPt>
          <c:errBars>
            <c:errBarType val="both"/>
            <c:errValType val="cust"/>
            <c:noEndCap val="0"/>
            <c:plus>
              <c:numRef>
                <c:f>(Analysis!$C$27,Analysis!$E$27)</c:f>
                <c:numCache>
                  <c:formatCode>General</c:formatCode>
                  <c:ptCount val="2"/>
                  <c:pt idx="0">
                    <c:v>1.0307764064044151</c:v>
                  </c:pt>
                  <c:pt idx="1">
                    <c:v>1.3149778198382918</c:v>
                  </c:pt>
                </c:numCache>
              </c:numRef>
            </c:plus>
            <c:minus>
              <c:numRef>
                <c:f>(Analysis!$C$27,Analysis!$E$27)</c:f>
                <c:numCache>
                  <c:formatCode>General</c:formatCode>
                  <c:ptCount val="2"/>
                  <c:pt idx="0">
                    <c:v>1.0307764064044151</c:v>
                  </c:pt>
                  <c:pt idx="1">
                    <c:v>1.3149778198382918</c:v>
                  </c:pt>
                </c:numCache>
              </c:numRef>
            </c:minus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(Analysis!$B$18,Analysis!$D$18)</c:f>
              <c:strCache>
                <c:ptCount val="2"/>
                <c:pt idx="0">
                  <c:v>Vehicle</c:v>
                </c:pt>
                <c:pt idx="1">
                  <c:v>AngII</c:v>
                </c:pt>
              </c:strCache>
            </c:strRef>
          </c:cat>
          <c:val>
            <c:numRef>
              <c:f>(Analysis!$B$27,Analysis!$D$27)</c:f>
              <c:numCache>
                <c:formatCode>General</c:formatCode>
                <c:ptCount val="2"/>
                <c:pt idx="0">
                  <c:v>26.75</c:v>
                </c:pt>
                <c:pt idx="1">
                  <c:v>36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193-4E16-B050-8BF00404C4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5628544"/>
        <c:axId val="225630080"/>
      </c:barChart>
      <c:catAx>
        <c:axId val="225628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5630080"/>
        <c:crosses val="autoZero"/>
        <c:auto val="1"/>
        <c:lblAlgn val="ctr"/>
        <c:lblOffset val="100"/>
        <c:noMultiLvlLbl val="0"/>
      </c:catAx>
      <c:valAx>
        <c:axId val="225630080"/>
        <c:scaling>
          <c:orientation val="minMax"/>
          <c:max val="7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matocrit (% PCU)</a:t>
                </a:r>
              </a:p>
            </c:rich>
          </c:tx>
          <c:layout>
            <c:manualLayout>
              <c:xMode val="edge"/>
              <c:yMode val="edge"/>
              <c:x val="2.3372285917655435E-3"/>
              <c:y val="0.23535993724745724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5628544"/>
        <c:crosses val="autoZero"/>
        <c:crossBetween val="between"/>
        <c:majorUnit val="10"/>
        <c:minorUnit val="10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27583451965669176"/>
          <c:y val="5.1345026926905152E-2"/>
          <c:w val="0.237230356544093"/>
          <c:h val="0.10081101564432106"/>
        </c:manualLayout>
      </c:layout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773371218505943"/>
          <c:y val="0.13609645182088173"/>
          <c:w val="0.65946050460668815"/>
          <c:h val="0.74159617939050304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8467-4152-8EFE-199659E0B381}"/>
              </c:ext>
            </c:extLst>
          </c:dPt>
          <c:errBars>
            <c:errBarType val="plus"/>
            <c:errValType val="cust"/>
            <c:noEndCap val="0"/>
            <c:plus>
              <c:numRef>
                <c:f>('Combined data and graphs'!$C$65,'Combined data and graphs'!$E$65)</c:f>
                <c:numCache>
                  <c:formatCode>General</c:formatCode>
                  <c:ptCount val="2"/>
                  <c:pt idx="0">
                    <c:v>1.7274083224506167</c:v>
                  </c:pt>
                  <c:pt idx="1">
                    <c:v>2.4547521419428429</c:v>
                  </c:pt>
                </c:numCache>
              </c:numRef>
            </c:plus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'Combined data and graphs'!$B$42:$D$42</c:f>
              <c:strCache>
                <c:ptCount val="2"/>
                <c:pt idx="0">
                  <c:v>Veh</c:v>
                </c:pt>
                <c:pt idx="1">
                  <c:v>AngII </c:v>
                </c:pt>
              </c:strCache>
            </c:strRef>
          </c:cat>
          <c:val>
            <c:numRef>
              <c:f>('Combined data and graphs'!$B$65,'Combined data and graphs'!$D$65)</c:f>
              <c:numCache>
                <c:formatCode>General</c:formatCode>
                <c:ptCount val="2"/>
                <c:pt idx="0">
                  <c:v>63.186190476190475</c:v>
                </c:pt>
                <c:pt idx="1">
                  <c:v>50.40224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67-4152-8EFE-199659E0B381}"/>
            </c:ext>
          </c:extLst>
        </c:ser>
        <c:ser>
          <c:idx val="1"/>
          <c:order val="1"/>
          <c:tx>
            <c:v>PKA KI</c:v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C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8467-4152-8EFE-199659E0B381}"/>
              </c:ext>
            </c:extLst>
          </c:dPt>
          <c:errBars>
            <c:errBarType val="plus"/>
            <c:errValType val="cust"/>
            <c:noEndCap val="0"/>
            <c:plus>
              <c:numRef>
                <c:f>('Combined data and graphs'!$C$102,'Combined data and graphs'!$E$102)</c:f>
                <c:numCache>
                  <c:formatCode>General</c:formatCode>
                  <c:ptCount val="2"/>
                  <c:pt idx="0">
                    <c:v>1.3855217110194811</c:v>
                  </c:pt>
                  <c:pt idx="1">
                    <c:v>3.9828387319949869</c:v>
                  </c:pt>
                </c:numCache>
              </c:numRef>
            </c:plus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'Combined data and graphs'!$B$42:$D$42</c:f>
              <c:strCache>
                <c:ptCount val="2"/>
                <c:pt idx="0">
                  <c:v>Veh</c:v>
                </c:pt>
                <c:pt idx="1">
                  <c:v>AngII </c:v>
                </c:pt>
              </c:strCache>
            </c:strRef>
          </c:cat>
          <c:val>
            <c:numRef>
              <c:f>('Combined data and graphs'!$B$102,'Combined data and graphs'!$D$102)</c:f>
              <c:numCache>
                <c:formatCode>General</c:formatCode>
                <c:ptCount val="2"/>
                <c:pt idx="0">
                  <c:v>59.670416666666668</c:v>
                </c:pt>
                <c:pt idx="1">
                  <c:v>49.108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67-4152-8EFE-199659E0B3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3035648"/>
        <c:axId val="233037184"/>
      </c:barChart>
      <c:catAx>
        <c:axId val="233035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33037184"/>
        <c:crosses val="autoZero"/>
        <c:auto val="1"/>
        <c:lblAlgn val="ctr"/>
        <c:lblOffset val="100"/>
        <c:noMultiLvlLbl val="0"/>
      </c:catAx>
      <c:valAx>
        <c:axId val="233037184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200" b="0" i="0" u="none" strike="noStrike" baseline="0">
                    <a:solidFill>
                      <a:sysClr val="windowText" lastClr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dirty="0">
                    <a:solidFill>
                      <a:sysClr val="windowText" lastClr="000000"/>
                    </a:solidFill>
                  </a:rPr>
                  <a:t>Ejection Fraction (%)</a:t>
                </a:r>
              </a:p>
            </c:rich>
          </c:tx>
          <c:layout>
            <c:manualLayout>
              <c:xMode val="edge"/>
              <c:yMode val="edge"/>
              <c:x val="6.2935438626858534E-2"/>
              <c:y val="0.23128329856722707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33035648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2984598486449061"/>
          <c:y val="0.13286963363971852"/>
          <c:w val="0.25086928631974975"/>
          <c:h val="0.10037711133738929"/>
        </c:manualLayout>
      </c:layout>
      <c:overlay val="0"/>
      <c:txPr>
        <a:bodyPr/>
        <a:lstStyle/>
        <a:p>
          <a:pPr>
            <a:defRPr sz="1000" b="0" i="0" u="none" strike="noStrike" baseline="0">
              <a:solidFill>
                <a:srgbClr val="000000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952423594289542"/>
          <c:y val="9.5028620867452618E-2"/>
          <c:w val="0.68569808792454778"/>
          <c:h val="0.76429265107476752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/>
            </a:solidFill>
            <a:ln w="952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48BF-47AD-886A-76BE5CFDE064}"/>
              </c:ext>
            </c:extLst>
          </c:dPt>
          <c:errBars>
            <c:errBarType val="plus"/>
            <c:errValType val="cust"/>
            <c:noEndCap val="0"/>
            <c:plus>
              <c:numRef>
                <c:f>('Combined data and graphs'!$C$64,'Combined data and graphs'!$E$64)</c:f>
                <c:numCache>
                  <c:formatCode>General</c:formatCode>
                  <c:ptCount val="2"/>
                  <c:pt idx="0">
                    <c:v>2.6195425686721272</c:v>
                  </c:pt>
                  <c:pt idx="1">
                    <c:v>2.7961631831184355</c:v>
                  </c:pt>
                </c:numCache>
              </c:numRef>
            </c:plus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</c:spPr>
          </c:errBars>
          <c:cat>
            <c:strRef>
              <c:f>'Combined data and graphs'!$B$42:$D$42</c:f>
              <c:strCache>
                <c:ptCount val="2"/>
                <c:pt idx="0">
                  <c:v>Veh</c:v>
                </c:pt>
                <c:pt idx="1">
                  <c:v>AngII </c:v>
                </c:pt>
              </c:strCache>
            </c:strRef>
          </c:cat>
          <c:val>
            <c:numRef>
              <c:f>('Combined data and graphs'!$B$64,'Combined data and graphs'!$D$64)</c:f>
              <c:numCache>
                <c:formatCode>General</c:formatCode>
                <c:ptCount val="2"/>
                <c:pt idx="0">
                  <c:v>51.328809523809532</c:v>
                </c:pt>
                <c:pt idx="1">
                  <c:v>37.87541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BF-47AD-886A-76BE5CFDE064}"/>
            </c:ext>
          </c:extLst>
        </c:ser>
        <c:ser>
          <c:idx val="1"/>
          <c:order val="1"/>
          <c:tx>
            <c:v>PKA KI</c:v>
          </c:tx>
          <c:spPr>
            <a:solidFill>
              <a:srgbClr val="C00000"/>
            </a:solidFill>
            <a:ln w="9525">
              <a:solidFill>
                <a:srgbClr val="C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9525">
                <a:solidFill>
                  <a:srgbClr val="C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8BF-47AD-886A-76BE5CFDE064}"/>
              </c:ext>
            </c:extLst>
          </c:dPt>
          <c:errBars>
            <c:errBarType val="plus"/>
            <c:errValType val="cust"/>
            <c:noEndCap val="0"/>
            <c:plus>
              <c:numRef>
                <c:f>('Combined data and graphs'!$C$101,'Combined data and graphs'!$E$101)</c:f>
                <c:numCache>
                  <c:formatCode>General</c:formatCode>
                  <c:ptCount val="2"/>
                  <c:pt idx="0">
                    <c:v>3.1706318053957103</c:v>
                  </c:pt>
                  <c:pt idx="1">
                    <c:v>1.9144249732178364</c:v>
                  </c:pt>
                </c:numCache>
              </c:numRef>
            </c:plus>
            <c:spPr>
              <a:solidFill>
                <a:schemeClr val="bg1">
                  <a:lumMod val="95000"/>
                </a:schemeClr>
              </a:solidFill>
              <a:ln w="9525">
                <a:solidFill>
                  <a:schemeClr val="tx1"/>
                </a:solidFill>
              </a:ln>
            </c:spPr>
          </c:errBars>
          <c:cat>
            <c:strRef>
              <c:f>'Combined data and graphs'!$B$42:$D$42</c:f>
              <c:strCache>
                <c:ptCount val="2"/>
                <c:pt idx="0">
                  <c:v>Veh</c:v>
                </c:pt>
                <c:pt idx="1">
                  <c:v>AngII </c:v>
                </c:pt>
              </c:strCache>
            </c:strRef>
          </c:cat>
          <c:val>
            <c:numRef>
              <c:f>('Combined data and graphs'!$B$101,'Combined data and graphs'!$D$101)</c:f>
              <c:numCache>
                <c:formatCode>General</c:formatCode>
                <c:ptCount val="2"/>
                <c:pt idx="0">
                  <c:v>49.165625000000006</c:v>
                </c:pt>
                <c:pt idx="1">
                  <c:v>31.8938095238095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BF-47AD-886A-76BE5CFDE0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2939904"/>
        <c:axId val="232941440"/>
      </c:barChart>
      <c:catAx>
        <c:axId val="232939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32941440"/>
        <c:crosses val="autoZero"/>
        <c:auto val="1"/>
        <c:lblAlgn val="ctr"/>
        <c:lblOffset val="100"/>
        <c:noMultiLvlLbl val="0"/>
      </c:catAx>
      <c:valAx>
        <c:axId val="232941440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200" b="0" i="0" u="none" strike="noStrike" baseline="0">
                    <a:solidFill>
                      <a:sysClr val="windowText" lastClr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dirty="0">
                    <a:solidFill>
                      <a:sysClr val="windowText" lastClr="000000"/>
                    </a:solidFill>
                  </a:rPr>
                  <a:t>Stroke volume (</a:t>
                </a:r>
                <a:r>
                  <a:rPr lang="en-GB" sz="1200" dirty="0" err="1">
                    <a:solidFill>
                      <a:sysClr val="windowText" lastClr="000000"/>
                    </a:solidFill>
                  </a:rPr>
                  <a:t>ul</a:t>
                </a:r>
                <a:r>
                  <a:rPr lang="en-GB" sz="1200" dirty="0">
                    <a:solidFill>
                      <a:sysClr val="windowText" lastClr="000000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1.2331855898572386E-2"/>
              <c:y val="0.24418721764028914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32939904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27656966706179459"/>
          <c:y val="0.10021638205146439"/>
          <c:w val="0.19827388243136274"/>
          <c:h val="8.7875203719855632E-2"/>
        </c:manualLayout>
      </c:layout>
      <c:overlay val="0"/>
      <c:txPr>
        <a:bodyPr/>
        <a:lstStyle/>
        <a:p>
          <a:pPr>
            <a:defRPr sz="1000" b="0" i="0" u="none" strike="noStrike" baseline="0">
              <a:solidFill>
                <a:srgbClr val="000000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869109784755026"/>
          <c:y val="0.11730553625332825"/>
          <c:w val="0.66333543661993744"/>
          <c:h val="0.7528256061416313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5CD7-4FA9-AE2B-7714101F7BDC}"/>
              </c:ext>
            </c:extLst>
          </c:dPt>
          <c:errBars>
            <c:errBarType val="plus"/>
            <c:errValType val="cust"/>
            <c:noEndCap val="0"/>
            <c:plus>
              <c:numRef>
                <c:f>('Combined data and graphs'!$C$66,'Combined data and graphs'!$E$66)</c:f>
                <c:numCache>
                  <c:formatCode>General</c:formatCode>
                  <c:ptCount val="2"/>
                  <c:pt idx="0">
                    <c:v>1.2539929196890969</c:v>
                  </c:pt>
                  <c:pt idx="1">
                    <c:v>1.4835563810365568</c:v>
                  </c:pt>
                </c:numCache>
              </c:numRef>
            </c:plus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'Combined data and graphs'!$B$42:$D$42</c:f>
              <c:strCache>
                <c:ptCount val="2"/>
                <c:pt idx="0">
                  <c:v>Veh</c:v>
                </c:pt>
                <c:pt idx="1">
                  <c:v>AngII </c:v>
                </c:pt>
              </c:strCache>
            </c:strRef>
          </c:cat>
          <c:val>
            <c:numRef>
              <c:f>('Combined data and graphs'!$B$66,'Combined data and graphs'!$D$66)</c:f>
              <c:numCache>
                <c:formatCode>General</c:formatCode>
                <c:ptCount val="2"/>
                <c:pt idx="0">
                  <c:v>34.055476190476192</c:v>
                </c:pt>
                <c:pt idx="1">
                  <c:v>25.5511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D7-4FA9-AE2B-7714101F7BDC}"/>
            </c:ext>
          </c:extLst>
        </c:ser>
        <c:ser>
          <c:idx val="1"/>
          <c:order val="1"/>
          <c:tx>
            <c:v>PKA KI</c:v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C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5CD7-4FA9-AE2B-7714101F7BDC}"/>
              </c:ext>
            </c:extLst>
          </c:dPt>
          <c:errBars>
            <c:errBarType val="plus"/>
            <c:errValType val="cust"/>
            <c:noEndCap val="0"/>
            <c:plus>
              <c:numRef>
                <c:f>('Combined data and graphs'!$C$103,'Combined data and graphs'!$E$103)</c:f>
                <c:numCache>
                  <c:formatCode>General</c:formatCode>
                  <c:ptCount val="2"/>
                  <c:pt idx="0">
                    <c:v>0.95301620183099744</c:v>
                  </c:pt>
                  <c:pt idx="1">
                    <c:v>2.4255790738579108</c:v>
                  </c:pt>
                </c:numCache>
              </c:numRef>
            </c:plus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'Combined data and graphs'!$B$42:$D$42</c:f>
              <c:strCache>
                <c:ptCount val="2"/>
                <c:pt idx="0">
                  <c:v>Veh</c:v>
                </c:pt>
                <c:pt idx="1">
                  <c:v>AngII </c:v>
                </c:pt>
              </c:strCache>
            </c:strRef>
          </c:cat>
          <c:val>
            <c:numRef>
              <c:f>('Combined data and graphs'!$B$103,'Combined data and graphs'!$D$103)</c:f>
              <c:numCache>
                <c:formatCode>General</c:formatCode>
                <c:ptCount val="2"/>
                <c:pt idx="0">
                  <c:v>31.577500000000004</c:v>
                </c:pt>
                <c:pt idx="1">
                  <c:v>24.7759523809523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CD7-4FA9-AE2B-7714101F7B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3344384"/>
        <c:axId val="233514112"/>
      </c:barChart>
      <c:catAx>
        <c:axId val="233344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33514112"/>
        <c:crosses val="autoZero"/>
        <c:auto val="1"/>
        <c:lblAlgn val="ctr"/>
        <c:lblOffset val="100"/>
        <c:noMultiLvlLbl val="0"/>
      </c:catAx>
      <c:valAx>
        <c:axId val="233514112"/>
        <c:scaling>
          <c:orientation val="minMax"/>
          <c:max val="6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200" b="0" i="0" u="none" strike="noStrike" baseline="0">
                    <a:solidFill>
                      <a:sysClr val="windowText" lastClr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dirty="0">
                    <a:solidFill>
                      <a:sysClr val="windowText" lastClr="000000"/>
                    </a:solidFill>
                  </a:rPr>
                  <a:t>Fractional shortening (%)</a:t>
                </a:r>
              </a:p>
            </c:rich>
          </c:tx>
          <c:layout>
            <c:manualLayout>
              <c:xMode val="edge"/>
              <c:yMode val="edge"/>
              <c:x val="4.9625572853926582E-2"/>
              <c:y val="0.19503090262332481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33344384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30002654224543512"/>
          <c:y val="0.12103985781573209"/>
          <c:w val="0.20490944837849842"/>
          <c:h val="8.6087935053910394E-2"/>
        </c:manualLayout>
      </c:layout>
      <c:overlay val="0"/>
      <c:txPr>
        <a:bodyPr/>
        <a:lstStyle/>
        <a:p>
          <a:pPr>
            <a:defRPr sz="1000" b="0" i="0" u="none" strike="noStrike" baseline="0">
              <a:solidFill>
                <a:srgbClr val="000000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</cdr:x>
      <cdr:y>0.61066</cdr:y>
    </cdr:from>
    <cdr:to>
      <cdr:x>0.58375</cdr:x>
      <cdr:y>0.677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095059E2-7C43-84D9-2AA9-F655173A38F3}"/>
            </a:ext>
          </a:extLst>
        </cdr:cNvPr>
        <cdr:cNvSpPr txBox="1"/>
      </cdr:nvSpPr>
      <cdr:spPr>
        <a:xfrm xmlns:a="http://schemas.openxmlformats.org/drawingml/2006/main">
          <a:off x="1753506" y="2283164"/>
          <a:ext cx="293729" cy="2484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800" kern="1200" dirty="0"/>
            <a:t>*</a:t>
          </a: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3714</cdr:x>
      <cdr:y>0.3647</cdr:y>
    </cdr:from>
    <cdr:to>
      <cdr:x>0.69511</cdr:x>
      <cdr:y>0.43137</cdr:y>
    </cdr:to>
    <cdr:sp macro="" textlink="">
      <cdr:nvSpPr>
        <cdr:cNvPr id="2" name="Left Brace 1"/>
        <cdr:cNvSpPr/>
      </cdr:nvSpPr>
      <cdr:spPr>
        <a:xfrm xmlns:a="http://schemas.openxmlformats.org/drawingml/2006/main" rot="5400000">
          <a:off x="1581318" y="824775"/>
          <a:ext cx="224226" cy="1027996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48798</cdr:x>
      <cdr:y>0.28551</cdr:y>
    </cdr:from>
    <cdr:to>
      <cdr:x>0.62486</cdr:x>
      <cdr:y>0.37046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549663" y="960280"/>
          <a:ext cx="434682" cy="2857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  <cdr:relSizeAnchor xmlns:cdr="http://schemas.openxmlformats.org/drawingml/2006/chartDrawing">
    <cdr:from>
      <cdr:x>0.47117</cdr:x>
      <cdr:y>0.26104</cdr:y>
    </cdr:from>
    <cdr:to>
      <cdr:x>0.78928</cdr:x>
      <cdr:y>0.29458</cdr:y>
    </cdr:to>
    <cdr:sp macro="" textlink="">
      <cdr:nvSpPr>
        <cdr:cNvPr id="4" name="Left Brace 3"/>
        <cdr:cNvSpPr/>
      </cdr:nvSpPr>
      <cdr:spPr>
        <a:xfrm xmlns:a="http://schemas.openxmlformats.org/drawingml/2006/main" rot="5400000">
          <a:off x="1944956" y="429288"/>
          <a:ext cx="112832" cy="1010212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664</cdr:x>
      <cdr:y>0.18997</cdr:y>
    </cdr:from>
    <cdr:to>
      <cdr:x>0.64563</cdr:x>
      <cdr:y>0.28585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1798701" y="638939"/>
          <a:ext cx="251607" cy="3224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277</cdr:x>
      <cdr:y>0.18836</cdr:y>
    </cdr:from>
    <cdr:to>
      <cdr:x>0.73454</cdr:x>
      <cdr:y>0.21189</cdr:y>
    </cdr:to>
    <cdr:sp macro="" textlink="">
      <cdr:nvSpPr>
        <cdr:cNvPr id="2" name="Right Brace 1"/>
        <cdr:cNvSpPr/>
      </cdr:nvSpPr>
      <cdr:spPr>
        <a:xfrm xmlns:a="http://schemas.openxmlformats.org/drawingml/2006/main" rot="16200000">
          <a:off x="1778786" y="-440476"/>
          <a:ext cx="60248" cy="1905609"/>
        </a:xfrm>
        <a:prstGeom xmlns:a="http://schemas.openxmlformats.org/drawingml/2006/main" prst="rightBrace">
          <a:avLst/>
        </a:prstGeom>
        <a:ln xmlns:a="http://schemas.openxmlformats.org/drawingml/2006/main" w="63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23024</cdr:x>
      <cdr:y>0.13866</cdr:y>
    </cdr:from>
    <cdr:to>
      <cdr:x>0.87185</cdr:x>
      <cdr:y>0.16238</cdr:y>
    </cdr:to>
    <cdr:sp macro="" textlink="">
      <cdr:nvSpPr>
        <cdr:cNvPr id="3" name="Right Brace 2"/>
        <cdr:cNvSpPr/>
      </cdr:nvSpPr>
      <cdr:spPr>
        <a:xfrm xmlns:a="http://schemas.openxmlformats.org/drawingml/2006/main" rot="16200000">
          <a:off x="2041428" y="-820810"/>
          <a:ext cx="60721" cy="2412308"/>
        </a:xfrm>
        <a:prstGeom xmlns:a="http://schemas.openxmlformats.org/drawingml/2006/main" prst="rightBrace">
          <a:avLst/>
        </a:prstGeom>
        <a:ln xmlns:a="http://schemas.openxmlformats.org/drawingml/2006/main" w="63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22083</cdr:x>
      <cdr:y>0.25339</cdr:y>
    </cdr:from>
    <cdr:to>
      <cdr:x>0.60433</cdr:x>
      <cdr:y>0.27554</cdr:y>
    </cdr:to>
    <cdr:sp macro="" textlink="">
      <cdr:nvSpPr>
        <cdr:cNvPr id="4" name="Right Brace 3"/>
        <cdr:cNvSpPr/>
      </cdr:nvSpPr>
      <cdr:spPr>
        <a:xfrm xmlns:a="http://schemas.openxmlformats.org/drawingml/2006/main" rot="16200000">
          <a:off x="1522847" y="-43882"/>
          <a:ext cx="56723" cy="1441871"/>
        </a:xfrm>
        <a:prstGeom xmlns:a="http://schemas.openxmlformats.org/drawingml/2006/main" prst="rightBrace">
          <a:avLst/>
        </a:prstGeom>
        <a:ln xmlns:a="http://schemas.openxmlformats.org/drawingml/2006/main" w="63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1218</cdr:x>
      <cdr:y>0.03222</cdr:y>
    </cdr:from>
    <cdr:to>
      <cdr:x>0.59608</cdr:x>
      <cdr:y>0.11779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925663" y="82487"/>
          <a:ext cx="315474" cy="2190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  <cdr:relSizeAnchor xmlns:cdr="http://schemas.openxmlformats.org/drawingml/2006/chartDrawing">
    <cdr:from>
      <cdr:x>0.4436</cdr:x>
      <cdr:y>0.0345</cdr:y>
    </cdr:from>
    <cdr:to>
      <cdr:x>0.52751</cdr:x>
      <cdr:y>0.12007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1667832" y="88319"/>
          <a:ext cx="315474" cy="2190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  <cdr:relSizeAnchor xmlns:cdr="http://schemas.openxmlformats.org/drawingml/2006/chartDrawing">
    <cdr:from>
      <cdr:x>0.36471</cdr:x>
      <cdr:y>0.03576</cdr:y>
    </cdr:from>
    <cdr:to>
      <cdr:x>0.44861</cdr:x>
      <cdr:y>0.12133</cdr:y>
    </cdr:to>
    <cdr:sp macro="" textlink="">
      <cdr:nvSpPr>
        <cdr:cNvPr id="7" name="TextBox 1"/>
        <cdr:cNvSpPr txBox="1"/>
      </cdr:nvSpPr>
      <cdr:spPr>
        <a:xfrm xmlns:a="http://schemas.openxmlformats.org/drawingml/2006/main">
          <a:off x="1371209" y="91540"/>
          <a:ext cx="315474" cy="2190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38577</cdr:x>
      <cdr:y>0.15396</cdr:y>
    </cdr:from>
    <cdr:to>
      <cdr:x>0.8863</cdr:x>
      <cdr:y>0.19768</cdr:y>
    </cdr:to>
    <cdr:sp macro="" textlink="">
      <cdr:nvSpPr>
        <cdr:cNvPr id="2" name="Right Brace 1"/>
        <cdr:cNvSpPr/>
      </cdr:nvSpPr>
      <cdr:spPr>
        <a:xfrm xmlns:a="http://schemas.openxmlformats.org/drawingml/2006/main" rot="16200000">
          <a:off x="2142634" y="-416720"/>
          <a:ext cx="111474" cy="1730024"/>
        </a:xfrm>
        <a:prstGeom xmlns:a="http://schemas.openxmlformats.org/drawingml/2006/main" prst="rightBrace">
          <a:avLst/>
        </a:prstGeom>
        <a:ln xmlns:a="http://schemas.openxmlformats.org/drawingml/2006/main" w="63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9757</cdr:x>
      <cdr:y>0.03618</cdr:y>
    </cdr:from>
    <cdr:to>
      <cdr:x>0.71053</cdr:x>
      <cdr:y>0.12638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2065415" y="92250"/>
          <a:ext cx="390433" cy="2299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33325</cdr:x>
      <cdr:y>0.37494</cdr:y>
    </cdr:from>
    <cdr:to>
      <cdr:x>0.68219</cdr:x>
      <cdr:y>0.41599</cdr:y>
    </cdr:to>
    <cdr:sp macro="" textlink="">
      <cdr:nvSpPr>
        <cdr:cNvPr id="2" name="Left Brace 1"/>
        <cdr:cNvSpPr/>
      </cdr:nvSpPr>
      <cdr:spPr>
        <a:xfrm xmlns:a="http://schemas.openxmlformats.org/drawingml/2006/main" rot="5400000">
          <a:off x="1320165" y="696596"/>
          <a:ext cx="121566" cy="949079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46651</cdr:x>
      <cdr:y>0.29432</cdr:y>
    </cdr:from>
    <cdr:to>
      <cdr:x>0.52315</cdr:x>
      <cdr:y>0.35607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268868" y="871595"/>
          <a:ext cx="154028" cy="1828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  <cdr:relSizeAnchor xmlns:cdr="http://schemas.openxmlformats.org/drawingml/2006/chartDrawing">
    <cdr:from>
      <cdr:x>0.444</cdr:x>
      <cdr:y>0.28141</cdr:y>
    </cdr:from>
    <cdr:to>
      <cdr:x>0.79394</cdr:x>
      <cdr:y>0.32066</cdr:y>
    </cdr:to>
    <cdr:sp macro="" textlink="">
      <cdr:nvSpPr>
        <cdr:cNvPr id="4" name="Left Brace 3"/>
        <cdr:cNvSpPr/>
      </cdr:nvSpPr>
      <cdr:spPr>
        <a:xfrm xmlns:a="http://schemas.openxmlformats.org/drawingml/2006/main" rot="5400000">
          <a:off x="1625401" y="415584"/>
          <a:ext cx="116262" cy="951818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5357</cdr:x>
      <cdr:y>0.19684</cdr:y>
    </cdr:from>
    <cdr:to>
      <cdr:x>0.77948</cdr:x>
      <cdr:y>0.25858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1457035" y="582926"/>
          <a:ext cx="663067" cy="1828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37017</cdr:x>
      <cdr:y>0.37225</cdr:y>
    </cdr:from>
    <cdr:to>
      <cdr:x>0.7386</cdr:x>
      <cdr:y>0.41631</cdr:y>
    </cdr:to>
    <cdr:sp macro="" textlink="">
      <cdr:nvSpPr>
        <cdr:cNvPr id="2" name="Left Brace 1"/>
        <cdr:cNvSpPr/>
      </cdr:nvSpPr>
      <cdr:spPr>
        <a:xfrm xmlns:a="http://schemas.openxmlformats.org/drawingml/2006/main" rot="5400000">
          <a:off x="1259507" y="739900"/>
          <a:ext cx="131883" cy="880872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43052</cdr:x>
      <cdr:y>0.30698</cdr:y>
    </cdr:from>
    <cdr:to>
      <cdr:x>0.74138</cdr:x>
      <cdr:y>0.36873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029296" y="918984"/>
          <a:ext cx="743223" cy="1848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800" dirty="0">
              <a:latin typeface="Arial" panose="020B0604020202020204" pitchFamily="34" charset="0"/>
              <a:cs typeface="Arial" panose="020B0604020202020204" pitchFamily="34" charset="0"/>
            </a:rPr>
            <a:t>p=0.0712</a:t>
          </a:r>
        </a:p>
      </cdr:txBody>
    </cdr:sp>
  </cdr:relSizeAnchor>
  <cdr:relSizeAnchor xmlns:cdr="http://schemas.openxmlformats.org/drawingml/2006/chartDrawing">
    <cdr:from>
      <cdr:x>0.46504</cdr:x>
      <cdr:y>0.25646</cdr:y>
    </cdr:from>
    <cdr:to>
      <cdr:x>0.82012</cdr:x>
      <cdr:y>0.3085</cdr:y>
    </cdr:to>
    <cdr:sp macro="" textlink="">
      <cdr:nvSpPr>
        <cdr:cNvPr id="4" name="Left Brace 3"/>
        <cdr:cNvSpPr/>
      </cdr:nvSpPr>
      <cdr:spPr>
        <a:xfrm xmlns:a="http://schemas.openxmlformats.org/drawingml/2006/main" rot="5400000">
          <a:off x="1458412" y="421178"/>
          <a:ext cx="155794" cy="848935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53402</cdr:x>
      <cdr:y>0.18276</cdr:y>
    </cdr:from>
    <cdr:to>
      <cdr:x>0.74815</cdr:x>
      <cdr:y>0.2445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1276767" y="547115"/>
          <a:ext cx="511935" cy="18482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36337</cdr:x>
      <cdr:y>0.33131</cdr:y>
    </cdr:from>
    <cdr:to>
      <cdr:x>0.6908</cdr:x>
      <cdr:y>0.3769</cdr:y>
    </cdr:to>
    <cdr:sp macro="" textlink="">
      <cdr:nvSpPr>
        <cdr:cNvPr id="2" name="Left Brace 1"/>
        <cdr:cNvSpPr/>
      </cdr:nvSpPr>
      <cdr:spPr>
        <a:xfrm xmlns:a="http://schemas.openxmlformats.org/drawingml/2006/main" rot="5400000">
          <a:off x="1655614" y="573249"/>
          <a:ext cx="142866" cy="1072825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4452</cdr:x>
      <cdr:y>0.26163</cdr:y>
    </cdr:from>
    <cdr:to>
      <cdr:x>0.50183</cdr:x>
      <cdr:y>0.32338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458726" y="819862"/>
          <a:ext cx="185554" cy="1935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800" dirty="0">
              <a:latin typeface="Arial" panose="020B0604020202020204" pitchFamily="34" charset="0"/>
              <a:cs typeface="Arial" panose="020B0604020202020204" pitchFamily="34" charset="0"/>
            </a:rPr>
            <a:t>p=0.07</a:t>
          </a:r>
        </a:p>
      </cdr:txBody>
    </cdr:sp>
  </cdr:relSizeAnchor>
  <cdr:relSizeAnchor xmlns:cdr="http://schemas.openxmlformats.org/drawingml/2006/chartDrawing">
    <cdr:from>
      <cdr:x>0.45155</cdr:x>
      <cdr:y>0.2166</cdr:y>
    </cdr:from>
    <cdr:to>
      <cdr:x>0.77898</cdr:x>
      <cdr:y>0.26219</cdr:y>
    </cdr:to>
    <cdr:sp macro="" textlink="">
      <cdr:nvSpPr>
        <cdr:cNvPr id="4" name="Left Brace 3"/>
        <cdr:cNvSpPr/>
      </cdr:nvSpPr>
      <cdr:spPr>
        <a:xfrm xmlns:a="http://schemas.openxmlformats.org/drawingml/2006/main" rot="5400000">
          <a:off x="1944548" y="213756"/>
          <a:ext cx="142866" cy="1072857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55373</cdr:x>
      <cdr:y>0.12564</cdr:y>
    </cdr:from>
    <cdr:to>
      <cdr:x>0.61036</cdr:x>
      <cdr:y>0.18738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1814338" y="393710"/>
          <a:ext cx="185554" cy="1934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</a:p>
      </cdr:txBody>
    </cdr:sp>
  </cdr:relSizeAnchor>
  <cdr:relSizeAnchor xmlns:cdr="http://schemas.openxmlformats.org/drawingml/2006/chartDrawing">
    <cdr:from>
      <cdr:x>0.4452</cdr:x>
      <cdr:y>0.26163</cdr:y>
    </cdr:from>
    <cdr:to>
      <cdr:x>0.50183</cdr:x>
      <cdr:y>0.32338</cdr:y>
    </cdr:to>
    <cdr:sp macro="" textlink="">
      <cdr:nvSpPr>
        <cdr:cNvPr id="7" name="TextBox 2"/>
        <cdr:cNvSpPr txBox="1"/>
      </cdr:nvSpPr>
      <cdr:spPr>
        <a:xfrm xmlns:a="http://schemas.openxmlformats.org/drawingml/2006/main">
          <a:off x="1458726" y="819862"/>
          <a:ext cx="185554" cy="1935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800" dirty="0">
              <a:latin typeface="Arial" panose="020B0604020202020204" pitchFamily="34" charset="0"/>
              <a:cs typeface="Arial" panose="020B0604020202020204" pitchFamily="34" charset="0"/>
            </a:rPr>
            <a:t>p=0.07</a:t>
          </a:r>
        </a:p>
      </cdr:txBody>
    </cdr:sp>
  </cdr:relSizeAnchor>
  <cdr:relSizeAnchor xmlns:cdr="http://schemas.openxmlformats.org/drawingml/2006/chartDrawing">
    <cdr:from>
      <cdr:x>0.55373</cdr:x>
      <cdr:y>0.12564</cdr:y>
    </cdr:from>
    <cdr:to>
      <cdr:x>0.61036</cdr:x>
      <cdr:y>0.18738</cdr:y>
    </cdr:to>
    <cdr:sp macro="" textlink="">
      <cdr:nvSpPr>
        <cdr:cNvPr id="9" name="TextBox 2"/>
        <cdr:cNvSpPr txBox="1"/>
      </cdr:nvSpPr>
      <cdr:spPr>
        <a:xfrm xmlns:a="http://schemas.openxmlformats.org/drawingml/2006/main">
          <a:off x="1814338" y="393710"/>
          <a:ext cx="185554" cy="1934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36678</cdr:x>
      <cdr:y>0.33116</cdr:y>
    </cdr:from>
    <cdr:to>
      <cdr:x>0.69672</cdr:x>
      <cdr:y>0.37644</cdr:y>
    </cdr:to>
    <cdr:sp macro="" textlink="">
      <cdr:nvSpPr>
        <cdr:cNvPr id="2" name="Left Brace 1"/>
        <cdr:cNvSpPr/>
      </cdr:nvSpPr>
      <cdr:spPr>
        <a:xfrm xmlns:a="http://schemas.openxmlformats.org/drawingml/2006/main" rot="5400000">
          <a:off x="1591528" y="726124"/>
          <a:ext cx="159305" cy="1036930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47842</cdr:x>
      <cdr:y>0.2654</cdr:y>
    </cdr:from>
    <cdr:to>
      <cdr:x>0.55693</cdr:x>
      <cdr:y>0.35542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503591" y="933611"/>
          <a:ext cx="246742" cy="3166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</a:p>
      </cdr:txBody>
    </cdr:sp>
  </cdr:relSizeAnchor>
  <cdr:relSizeAnchor xmlns:cdr="http://schemas.openxmlformats.org/drawingml/2006/chartDrawing">
    <cdr:from>
      <cdr:x>0.47842</cdr:x>
      <cdr:y>0.24175</cdr:y>
    </cdr:from>
    <cdr:to>
      <cdr:x>0.78807</cdr:x>
      <cdr:y>0.29452</cdr:y>
    </cdr:to>
    <cdr:sp macro="" textlink="">
      <cdr:nvSpPr>
        <cdr:cNvPr id="4" name="Left Brace 3"/>
        <cdr:cNvSpPr/>
      </cdr:nvSpPr>
      <cdr:spPr>
        <a:xfrm xmlns:a="http://schemas.openxmlformats.org/drawingml/2006/main" rot="5400000">
          <a:off x="1897366" y="456656"/>
          <a:ext cx="185624" cy="973175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8339</cdr:x>
      <cdr:y>0.17398</cdr:y>
    </cdr:from>
    <cdr:to>
      <cdr:x>0.66189</cdr:x>
      <cdr:y>0.27559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1833491" y="612023"/>
          <a:ext cx="246710" cy="3574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35011</cdr:x>
      <cdr:y>0.34635</cdr:y>
    </cdr:from>
    <cdr:to>
      <cdr:x>0.64989</cdr:x>
      <cdr:y>0.39379</cdr:y>
    </cdr:to>
    <cdr:sp macro="" textlink="">
      <cdr:nvSpPr>
        <cdr:cNvPr id="2" name="Left Brace 1"/>
        <cdr:cNvSpPr/>
      </cdr:nvSpPr>
      <cdr:spPr>
        <a:xfrm xmlns:a="http://schemas.openxmlformats.org/drawingml/2006/main" rot="5400000">
          <a:off x="1464996" y="895822"/>
          <a:ext cx="174487" cy="930630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43432</cdr:x>
      <cdr:y>0.2646</cdr:y>
    </cdr:from>
    <cdr:to>
      <cdr:x>0.51582</cdr:x>
      <cdr:y>0.35491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348331" y="956318"/>
          <a:ext cx="253015" cy="3264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</a:p>
      </cdr:txBody>
    </cdr:sp>
  </cdr:relSizeAnchor>
  <cdr:relSizeAnchor xmlns:cdr="http://schemas.openxmlformats.org/drawingml/2006/chartDrawing">
    <cdr:from>
      <cdr:x>0.44862</cdr:x>
      <cdr:y>0.22088</cdr:y>
    </cdr:from>
    <cdr:to>
      <cdr:x>0.74839</cdr:x>
      <cdr:y>0.26833</cdr:y>
    </cdr:to>
    <cdr:sp macro="" textlink="">
      <cdr:nvSpPr>
        <cdr:cNvPr id="4" name="Left Brace 3"/>
        <cdr:cNvSpPr/>
      </cdr:nvSpPr>
      <cdr:spPr>
        <a:xfrm xmlns:a="http://schemas.openxmlformats.org/drawingml/2006/main" rot="5400000">
          <a:off x="1599440" y="242507"/>
          <a:ext cx="127852" cy="833123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361</cdr:x>
      <cdr:y>0.14298</cdr:y>
    </cdr:from>
    <cdr:to>
      <cdr:x>0.61759</cdr:x>
      <cdr:y>0.24494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1664320" y="516761"/>
          <a:ext cx="252984" cy="3685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34036</cdr:x>
      <cdr:y>0.35502</cdr:y>
    </cdr:from>
    <cdr:to>
      <cdr:x>0.66406</cdr:x>
      <cdr:y>0.39964</cdr:y>
    </cdr:to>
    <cdr:sp macro="" textlink="">
      <cdr:nvSpPr>
        <cdr:cNvPr id="2" name="Left Brace 1"/>
        <cdr:cNvSpPr/>
      </cdr:nvSpPr>
      <cdr:spPr>
        <a:xfrm xmlns:a="http://schemas.openxmlformats.org/drawingml/2006/main" rot="5400000">
          <a:off x="1471353" y="824760"/>
          <a:ext cx="156581" cy="998800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43053</cdr:x>
      <cdr:y>0.28443</cdr:y>
    </cdr:from>
    <cdr:to>
      <cdr:x>0.58141</cdr:x>
      <cdr:y>0.33065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328457" y="998152"/>
          <a:ext cx="465562" cy="1621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</a:p>
      </cdr:txBody>
    </cdr:sp>
  </cdr:relSizeAnchor>
  <cdr:relSizeAnchor xmlns:cdr="http://schemas.openxmlformats.org/drawingml/2006/chartDrawing">
    <cdr:from>
      <cdr:x>0.44904</cdr:x>
      <cdr:y>0.24275</cdr:y>
    </cdr:from>
    <cdr:to>
      <cdr:x>0.74979</cdr:x>
      <cdr:y>0.29373</cdr:y>
    </cdr:to>
    <cdr:sp macro="" textlink="">
      <cdr:nvSpPr>
        <cdr:cNvPr id="4" name="Left Brace 3"/>
        <cdr:cNvSpPr/>
      </cdr:nvSpPr>
      <cdr:spPr>
        <a:xfrm xmlns:a="http://schemas.openxmlformats.org/drawingml/2006/main" rot="5400000">
          <a:off x="1760132" y="477302"/>
          <a:ext cx="178901" cy="928008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5747</cdr:x>
      <cdr:y>0.17888</cdr:y>
    </cdr:from>
    <cdr:to>
      <cdr:x>0.63479</cdr:x>
      <cdr:y>0.27476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1720145" y="627747"/>
          <a:ext cx="238582" cy="3364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E3CCE7-822B-4D1F-A5E2-DBA0B206C6CE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857250"/>
            <a:ext cx="30861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3B1890-5B75-498E-8019-979462A965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31144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1pPr>
    <a:lvl2pPr marL="583616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2pPr>
    <a:lvl3pPr marL="1167232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3pPr>
    <a:lvl4pPr marL="1750847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4pPr>
    <a:lvl5pPr marL="2334463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5pPr>
    <a:lvl6pPr marL="2918079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6pPr>
    <a:lvl7pPr marL="3501695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7pPr>
    <a:lvl8pPr marL="4085311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8pPr>
    <a:lvl9pPr marL="4668926" algn="l" defTabSz="1167232" rtl="0" eaLnBrk="1" latinLnBrk="0" hangingPunct="1">
      <a:defRPr sz="153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3B1890-5B75-498E-8019-979462A9654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3184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299A75-0DB8-B480-7DFB-4406333C75D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840AC7D-5414-1C8A-F489-AD3947D6840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3028950" y="857250"/>
            <a:ext cx="3086100" cy="2314575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CE67C34-9E7B-E0C4-347A-DC049CCC066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01DBB5A-A5FD-5D49-B445-DDDA8789A20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3B1890-5B75-498E-8019-979462A9654F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10702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ABB1D75-CBD3-6982-C12C-FDC7F751F7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F4E0C24-426B-7698-0D9A-16EB7ADBBCE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3028950" y="857250"/>
            <a:ext cx="3086100" cy="2314575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30D279DA-4B76-0BA0-D464-BDF5E614C59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A7494A-8A06-24E9-00D4-23D3B48977C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3B1890-5B75-498E-8019-979462A9654F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53932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1767462"/>
            <a:ext cx="12240181" cy="375991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5672376"/>
            <a:ext cx="10800160" cy="2607442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7074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8567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574987"/>
            <a:ext cx="3105046" cy="9152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574987"/>
            <a:ext cx="9135135" cy="9152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3985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0152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2692444"/>
            <a:ext cx="12420184" cy="449240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7227345"/>
            <a:ext cx="12420184" cy="2362447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3412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2874937"/>
            <a:ext cx="6120091" cy="68523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2874937"/>
            <a:ext cx="6120091" cy="68523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365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574990"/>
            <a:ext cx="12420184" cy="20874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2647443"/>
            <a:ext cx="6091964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3944914"/>
            <a:ext cx="6091964" cy="58023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2647443"/>
            <a:ext cx="6121966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3944914"/>
            <a:ext cx="6121966" cy="58023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06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393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303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19984"/>
            <a:ext cx="4644444" cy="251994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1554968"/>
            <a:ext cx="7290108" cy="767483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239929"/>
            <a:ext cx="4644444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209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19984"/>
            <a:ext cx="4644444" cy="251994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1554968"/>
            <a:ext cx="7290108" cy="767483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239929"/>
            <a:ext cx="4644444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68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574990"/>
            <a:ext cx="12420184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2874937"/>
            <a:ext cx="12420184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0009783"/>
            <a:ext cx="324004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A0EDA-7507-E048-96A1-7B4062FF9A73}" type="datetimeFigureOut">
              <a:rPr lang="en-GB" smtClean="0"/>
              <a:t>09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0009783"/>
            <a:ext cx="4860072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0009783"/>
            <a:ext cx="324004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02CC4-7931-4540-9424-C112DB83C0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019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chart" Target="../charts/chart1.xml"/><Relationship Id="rId21" Type="http://schemas.openxmlformats.org/officeDocument/2006/relationships/oleObject" Target="../embeddings/oleObject9.bin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oleObject" Target="../embeddings/oleObject7.bin"/><Relationship Id="rId25" Type="http://schemas.openxmlformats.org/officeDocument/2006/relationships/oleObject" Target="../embeddings/oleObject11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24" Type="http://schemas.openxmlformats.org/officeDocument/2006/relationships/image" Target="../media/image11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23" Type="http://schemas.openxmlformats.org/officeDocument/2006/relationships/oleObject" Target="../embeddings/oleObject10.bin"/><Relationship Id="rId10" Type="http://schemas.openxmlformats.org/officeDocument/2006/relationships/oleObject" Target="../embeddings/oleObject4.bin"/><Relationship Id="rId19" Type="http://schemas.openxmlformats.org/officeDocument/2006/relationships/oleObject" Target="../embeddings/oleObject8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Relationship Id="rId22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image" Target="../media/image19.png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12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11" Type="http://schemas.openxmlformats.org/officeDocument/2006/relationships/image" Target="../media/image18.png"/><Relationship Id="rId5" Type="http://schemas.openxmlformats.org/officeDocument/2006/relationships/oleObject" Target="../embeddings/oleObject13.bin"/><Relationship Id="rId10" Type="http://schemas.openxmlformats.org/officeDocument/2006/relationships/image" Target="../media/image17.png"/><Relationship Id="rId4" Type="http://schemas.openxmlformats.org/officeDocument/2006/relationships/image" Target="../media/image13.emf"/><Relationship Id="rId9" Type="http://schemas.openxmlformats.org/officeDocument/2006/relationships/image" Target="../media/image16.png"/><Relationship Id="rId1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chart" Target="../charts/chart8.xml"/><Relationship Id="rId3" Type="http://schemas.openxmlformats.org/officeDocument/2006/relationships/oleObject" Target="../embeddings/oleObject15.bin"/><Relationship Id="rId7" Type="http://schemas.openxmlformats.org/officeDocument/2006/relationships/image" Target="../media/image23.png"/><Relationship Id="rId12" Type="http://schemas.openxmlformats.org/officeDocument/2006/relationships/chart" Target="../charts/chart7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11" Type="http://schemas.openxmlformats.org/officeDocument/2006/relationships/chart" Target="../charts/chart6.xml"/><Relationship Id="rId5" Type="http://schemas.openxmlformats.org/officeDocument/2006/relationships/image" Target="../media/image21.png"/><Relationship Id="rId15" Type="http://schemas.openxmlformats.org/officeDocument/2006/relationships/chart" Target="../charts/chart10.xml"/><Relationship Id="rId10" Type="http://schemas.openxmlformats.org/officeDocument/2006/relationships/chart" Target="../charts/chart5.xml"/><Relationship Id="rId4" Type="http://schemas.openxmlformats.org/officeDocument/2006/relationships/image" Target="../media/image20.emf"/><Relationship Id="rId9" Type="http://schemas.openxmlformats.org/officeDocument/2006/relationships/chart" Target="../charts/chart4.xml"/><Relationship Id="rId1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E43BF629-CBCE-1B59-8BE4-FAECF8851D21}"/>
              </a:ext>
            </a:extLst>
          </p:cNvPr>
          <p:cNvGrpSpPr/>
          <p:nvPr/>
        </p:nvGrpSpPr>
        <p:grpSpPr>
          <a:xfrm>
            <a:off x="-20172" y="-5427"/>
            <a:ext cx="14432256" cy="10738880"/>
            <a:chOff x="-20172" y="-5427"/>
            <a:chExt cx="14432256" cy="1073888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BDAE5DC-2CE6-86CF-56E5-5655F09AC2DB}"/>
                </a:ext>
              </a:extLst>
            </p:cNvPr>
            <p:cNvSpPr txBox="1"/>
            <p:nvPr/>
          </p:nvSpPr>
          <p:spPr>
            <a:xfrm>
              <a:off x="11598619" y="-5427"/>
              <a:ext cx="281346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</a:t>
              </a:r>
              <a:endParaRPr lang="en-GB" dirty="0"/>
            </a:p>
          </p:txBody>
        </p:sp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06BD8584-6CE5-92EA-4313-DC9E5D94342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61090981"/>
                </p:ext>
              </p:extLst>
            </p:nvPr>
          </p:nvGraphicFramePr>
          <p:xfrm>
            <a:off x="6423508" y="502733"/>
            <a:ext cx="3507012" cy="37388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8" name="Object 17">
              <a:extLst>
                <a:ext uri="{FF2B5EF4-FFF2-40B4-BE49-F238E27FC236}">
                  <a16:creationId xmlns:a16="http://schemas.microsoft.com/office/drawing/2014/main" id="{91950BB1-7410-C3C3-45D0-9234A4E0EE4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5590043"/>
                </p:ext>
              </p:extLst>
            </p:nvPr>
          </p:nvGraphicFramePr>
          <p:xfrm>
            <a:off x="9654199" y="789272"/>
            <a:ext cx="4498975" cy="2959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982021" imgH="2617960" progId="Prism10.Document">
                    <p:embed/>
                  </p:oleObj>
                </mc:Choice>
                <mc:Fallback>
                  <p:oleObj name="Prism 10" r:id="rId4" imgW="3982021" imgH="2617960" progId="Prism10.Document">
                    <p:embed/>
                    <p:pic>
                      <p:nvPicPr>
                        <p:cNvPr id="18" name="Object 17">
                          <a:extLst>
                            <a:ext uri="{FF2B5EF4-FFF2-40B4-BE49-F238E27FC236}">
                              <a16:creationId xmlns:a16="http://schemas.microsoft.com/office/drawing/2014/main" id="{91950BB1-7410-C3C3-45D0-9234A4E0EE4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9654199" y="789272"/>
                          <a:ext cx="4498975" cy="2959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Object 18">
              <a:extLst>
                <a:ext uri="{FF2B5EF4-FFF2-40B4-BE49-F238E27FC236}">
                  <a16:creationId xmlns:a16="http://schemas.microsoft.com/office/drawing/2014/main" id="{20061A6D-A7FF-E3D1-FD09-999A329E478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47548602"/>
                </p:ext>
              </p:extLst>
            </p:nvPr>
          </p:nvGraphicFramePr>
          <p:xfrm>
            <a:off x="-20172" y="5456682"/>
            <a:ext cx="2843213" cy="22701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887568" imgH="2291660" progId="Prism10.Document">
                    <p:embed/>
                  </p:oleObj>
                </mc:Choice>
                <mc:Fallback>
                  <p:oleObj name="Prism 10" r:id="rId6" imgW="2887568" imgH="2291660" progId="Prism10.Document">
                    <p:embed/>
                    <p:pic>
                      <p:nvPicPr>
                        <p:cNvPr id="19" name="Object 18">
                          <a:extLst>
                            <a:ext uri="{FF2B5EF4-FFF2-40B4-BE49-F238E27FC236}">
                              <a16:creationId xmlns:a16="http://schemas.microsoft.com/office/drawing/2014/main" id="{20061A6D-A7FF-E3D1-FD09-999A329E478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-20172" y="5456682"/>
                          <a:ext cx="2843213" cy="22701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Object 19">
              <a:extLst>
                <a:ext uri="{FF2B5EF4-FFF2-40B4-BE49-F238E27FC236}">
                  <a16:creationId xmlns:a16="http://schemas.microsoft.com/office/drawing/2014/main" id="{92D7A44D-8505-6DC8-C587-7AEB567C780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75080993"/>
                </p:ext>
              </p:extLst>
            </p:nvPr>
          </p:nvGraphicFramePr>
          <p:xfrm>
            <a:off x="2411547" y="5454697"/>
            <a:ext cx="2773363" cy="2149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2815901" imgH="2184694" progId="Prism10.Document">
                    <p:embed/>
                  </p:oleObj>
                </mc:Choice>
                <mc:Fallback>
                  <p:oleObj name="Prism 10" r:id="rId8" imgW="2815901" imgH="2184694" progId="Prism10.Document">
                    <p:embed/>
                    <p:pic>
                      <p:nvPicPr>
                        <p:cNvPr id="20" name="Object 19">
                          <a:extLst>
                            <a:ext uri="{FF2B5EF4-FFF2-40B4-BE49-F238E27FC236}">
                              <a16:creationId xmlns:a16="http://schemas.microsoft.com/office/drawing/2014/main" id="{92D7A44D-8505-6DC8-C587-7AEB567C780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411547" y="5454697"/>
                          <a:ext cx="2773363" cy="21494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8E92BF3-A60E-3660-15FF-6C4D4E612CA4}"/>
                </a:ext>
              </a:extLst>
            </p:cNvPr>
            <p:cNvSpPr txBox="1"/>
            <p:nvPr/>
          </p:nvSpPr>
          <p:spPr>
            <a:xfrm>
              <a:off x="9692130" y="117262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5C762D9-F81B-5742-E318-A0045B01458A}"/>
                </a:ext>
              </a:extLst>
            </p:cNvPr>
            <p:cNvSpPr txBox="1"/>
            <p:nvPr/>
          </p:nvSpPr>
          <p:spPr>
            <a:xfrm>
              <a:off x="74977" y="117262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DBD0518-1365-6DD9-9465-CA053573226F}"/>
                </a:ext>
              </a:extLst>
            </p:cNvPr>
            <p:cNvSpPr txBox="1"/>
            <p:nvPr/>
          </p:nvSpPr>
          <p:spPr>
            <a:xfrm>
              <a:off x="74977" y="2520455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D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A262475-79B4-27FB-AE67-BE56DE1C01C6}"/>
                </a:ext>
              </a:extLst>
            </p:cNvPr>
            <p:cNvSpPr txBox="1"/>
            <p:nvPr/>
          </p:nvSpPr>
          <p:spPr>
            <a:xfrm>
              <a:off x="10349247" y="307808"/>
              <a:ext cx="1431443" cy="328210"/>
            </a:xfrm>
            <a:prstGeom prst="rect">
              <a:avLst/>
            </a:prstGeom>
            <a:noFill/>
          </p:spPr>
          <p:txBody>
            <a:bodyPr wrap="none" lIns="111677" tIns="55838" rIns="111677" bIns="55838" rtlCol="0">
              <a:spAutoFit/>
            </a:bodyPr>
            <a:lstStyle/>
            <a:p>
              <a:r>
                <a:rPr lang="en-GB" sz="1400" i="1" dirty="0">
                  <a:solidFill>
                    <a:srgbClr val="002060"/>
                  </a:solidFill>
                  <a:latin typeface="Myriad Pro"/>
                </a:rPr>
                <a:t>Carotid arterie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7E114AC-5155-F712-9C9C-E10413263E78}"/>
                </a:ext>
              </a:extLst>
            </p:cNvPr>
            <p:cNvSpPr txBox="1"/>
            <p:nvPr/>
          </p:nvSpPr>
          <p:spPr>
            <a:xfrm>
              <a:off x="7056942" y="307808"/>
              <a:ext cx="1467863" cy="328210"/>
            </a:xfrm>
            <a:prstGeom prst="rect">
              <a:avLst/>
            </a:prstGeom>
            <a:noFill/>
          </p:spPr>
          <p:txBody>
            <a:bodyPr wrap="none" lIns="111677" tIns="55838" rIns="111677" bIns="55838" rtlCol="0">
              <a:spAutoFit/>
            </a:bodyPr>
            <a:lstStyle/>
            <a:p>
              <a:r>
                <a:rPr lang="en-GB" sz="1400" i="1" dirty="0">
                  <a:solidFill>
                    <a:srgbClr val="002060"/>
                  </a:solidFill>
                  <a:latin typeface="Myriad Pro"/>
                </a:rPr>
                <a:t>Thoracic aortae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2370AD8-7031-0552-B7E4-F79487F61E1A}"/>
                </a:ext>
              </a:extLst>
            </p:cNvPr>
            <p:cNvSpPr txBox="1"/>
            <p:nvPr/>
          </p:nvSpPr>
          <p:spPr>
            <a:xfrm>
              <a:off x="738435" y="7513357"/>
              <a:ext cx="981359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/>
                <a:t>WT  </a:t>
              </a:r>
              <a:r>
                <a:rPr lang="en-GB" sz="1400" dirty="0">
                  <a:solidFill>
                    <a:srgbClr val="C00000"/>
                  </a:solidFill>
                </a:rPr>
                <a:t>PKA KI</a:t>
              </a:r>
            </a:p>
            <a:p>
              <a:pPr algn="ctr"/>
              <a:r>
                <a:rPr lang="en-GB" sz="1400" dirty="0"/>
                <a:t>Young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CB7A552-9771-8D4C-0CBB-72B7419994D4}"/>
                </a:ext>
              </a:extLst>
            </p:cNvPr>
            <p:cNvSpPr txBox="1"/>
            <p:nvPr/>
          </p:nvSpPr>
          <p:spPr>
            <a:xfrm>
              <a:off x="1608986" y="7513357"/>
              <a:ext cx="1021433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/>
                <a:t>WT   </a:t>
              </a:r>
              <a:r>
                <a:rPr lang="en-GB" sz="1400" dirty="0">
                  <a:solidFill>
                    <a:srgbClr val="C00000"/>
                  </a:solidFill>
                </a:rPr>
                <a:t>PKA KI</a:t>
              </a:r>
            </a:p>
            <a:p>
              <a:pPr algn="ctr"/>
              <a:r>
                <a:rPr lang="en-GB" sz="1400" dirty="0">
                  <a:highlight>
                    <a:srgbClr val="C0C0C0"/>
                  </a:highlight>
                </a:rPr>
                <a:t>Mid-aged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892570B-672A-AE8E-D908-B7372F117898}"/>
                </a:ext>
              </a:extLst>
            </p:cNvPr>
            <p:cNvSpPr txBox="1"/>
            <p:nvPr/>
          </p:nvSpPr>
          <p:spPr>
            <a:xfrm>
              <a:off x="3084433" y="7513357"/>
              <a:ext cx="981359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/>
                <a:t>WT  </a:t>
              </a:r>
              <a:r>
                <a:rPr lang="en-GB" sz="1400" dirty="0">
                  <a:solidFill>
                    <a:srgbClr val="C00000"/>
                  </a:solidFill>
                </a:rPr>
                <a:t>PKA KI</a:t>
              </a:r>
            </a:p>
            <a:p>
              <a:pPr algn="ctr"/>
              <a:r>
                <a:rPr lang="en-GB" sz="1400" dirty="0"/>
                <a:t>Young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3C53518-33F4-B69F-3F8A-7E915D426ED9}"/>
                </a:ext>
              </a:extLst>
            </p:cNvPr>
            <p:cNvSpPr txBox="1"/>
            <p:nvPr/>
          </p:nvSpPr>
          <p:spPr>
            <a:xfrm>
              <a:off x="3968632" y="7513357"/>
              <a:ext cx="1021433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/>
                <a:t>WT   </a:t>
              </a:r>
              <a:r>
                <a:rPr lang="en-GB" sz="1400" dirty="0">
                  <a:solidFill>
                    <a:srgbClr val="C00000"/>
                  </a:solidFill>
                </a:rPr>
                <a:t>PKA KI</a:t>
              </a:r>
            </a:p>
            <a:p>
              <a:pPr algn="ctr"/>
              <a:r>
                <a:rPr lang="en-GB" sz="1400" dirty="0">
                  <a:highlight>
                    <a:srgbClr val="C0C0C0"/>
                  </a:highlight>
                </a:rPr>
                <a:t>Mid-aged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5C74E5A-BB4D-6B86-F86E-40ED01117DF9}"/>
                </a:ext>
              </a:extLst>
            </p:cNvPr>
            <p:cNvSpPr txBox="1"/>
            <p:nvPr/>
          </p:nvSpPr>
          <p:spPr>
            <a:xfrm>
              <a:off x="6221386" y="7513357"/>
              <a:ext cx="1021433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/>
                <a:t>WT   </a:t>
              </a:r>
              <a:r>
                <a:rPr lang="en-GB" sz="1400" dirty="0">
                  <a:solidFill>
                    <a:srgbClr val="C00000"/>
                  </a:solidFill>
                </a:rPr>
                <a:t>PKA KI</a:t>
              </a:r>
            </a:p>
            <a:p>
              <a:pPr algn="ctr"/>
              <a:r>
                <a:rPr lang="en-GB" sz="1400" dirty="0">
                  <a:highlight>
                    <a:srgbClr val="C0C0C0"/>
                  </a:highlight>
                </a:rPr>
                <a:t>Mid-age</a:t>
              </a:r>
            </a:p>
          </p:txBody>
        </p: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6F3FACFC-F79E-7DD6-2306-DF588D6FDE45}"/>
                </a:ext>
              </a:extLst>
            </p:cNvPr>
            <p:cNvGrpSpPr/>
            <p:nvPr/>
          </p:nvGrpSpPr>
          <p:grpSpPr>
            <a:xfrm>
              <a:off x="4976716" y="5399053"/>
              <a:ext cx="2824162" cy="2619007"/>
              <a:chOff x="7145338" y="5497513"/>
              <a:chExt cx="2824162" cy="2619007"/>
            </a:xfrm>
          </p:grpSpPr>
          <p:graphicFrame>
            <p:nvGraphicFramePr>
              <p:cNvPr id="23" name="Object 22">
                <a:extLst>
                  <a:ext uri="{FF2B5EF4-FFF2-40B4-BE49-F238E27FC236}">
                    <a16:creationId xmlns:a16="http://schemas.microsoft.com/office/drawing/2014/main" id="{1FB4DFC6-A317-DD37-EE3E-502F00A4AE5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86974790"/>
                  </p:ext>
                </p:extLst>
              </p:nvPr>
            </p:nvGraphicFramePr>
            <p:xfrm>
              <a:off x="7145338" y="5497513"/>
              <a:ext cx="2824162" cy="23796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0" imgW="2869201" imgH="2416634" progId="Prism10.Document">
                      <p:embed/>
                    </p:oleObj>
                  </mc:Choice>
                  <mc:Fallback>
                    <p:oleObj name="Prism 10" r:id="rId10" imgW="2869201" imgH="2416634" progId="Prism10.Document">
                      <p:embed/>
                      <p:pic>
                        <p:nvPicPr>
                          <p:cNvPr id="23" name="Object 22">
                            <a:extLst>
                              <a:ext uri="{FF2B5EF4-FFF2-40B4-BE49-F238E27FC236}">
                                <a16:creationId xmlns:a16="http://schemas.microsoft.com/office/drawing/2014/main" id="{1FB4DFC6-A317-DD37-EE3E-502F00A4AE5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7145338" y="5497513"/>
                            <a:ext cx="2824162" cy="23796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2A90969A-D817-CD60-67B5-3CDED2B9A38D}"/>
                  </a:ext>
                </a:extLst>
              </p:cNvPr>
              <p:cNvSpPr txBox="1"/>
              <p:nvPr/>
            </p:nvSpPr>
            <p:spPr>
              <a:xfrm>
                <a:off x="7884426" y="7593300"/>
                <a:ext cx="981359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/>
                  <a:t>Young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6295BD12-8129-52EA-2640-E73C068A402B}"/>
                  </a:ext>
                </a:extLst>
              </p:cNvPr>
              <p:cNvSpPr txBox="1"/>
              <p:nvPr/>
            </p:nvSpPr>
            <p:spPr>
              <a:xfrm>
                <a:off x="8754977" y="7593300"/>
                <a:ext cx="1021433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>
                    <a:highlight>
                      <a:srgbClr val="C0C0C0"/>
                    </a:highlight>
                  </a:rPr>
                  <a:t>Mid-aged</a:t>
                </a:r>
              </a:p>
            </p:txBody>
          </p: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86675820-A747-7E3B-A41B-AE840F27D058}"/>
                </a:ext>
              </a:extLst>
            </p:cNvPr>
            <p:cNvGrpSpPr/>
            <p:nvPr/>
          </p:nvGrpSpPr>
          <p:grpSpPr>
            <a:xfrm>
              <a:off x="7388986" y="5463076"/>
              <a:ext cx="2763838" cy="2554984"/>
              <a:chOff x="9557608" y="5561536"/>
              <a:chExt cx="2763838" cy="2554984"/>
            </a:xfrm>
          </p:grpSpPr>
          <p:graphicFrame>
            <p:nvGraphicFramePr>
              <p:cNvPr id="24" name="Object 23">
                <a:extLst>
                  <a:ext uri="{FF2B5EF4-FFF2-40B4-BE49-F238E27FC236}">
                    <a16:creationId xmlns:a16="http://schemas.microsoft.com/office/drawing/2014/main" id="{088EBE1D-6FBB-4235-AB14-65CCFB6B2B9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73153505"/>
                  </p:ext>
                </p:extLst>
              </p:nvPr>
            </p:nvGraphicFramePr>
            <p:xfrm>
              <a:off x="9557608" y="5561536"/>
              <a:ext cx="2763838" cy="21447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2" imgW="2806898" imgH="2184694" progId="Prism10.Document">
                      <p:embed/>
                    </p:oleObj>
                  </mc:Choice>
                  <mc:Fallback>
                    <p:oleObj name="Prism 10" r:id="rId12" imgW="2806898" imgH="2184694" progId="Prism10.Document">
                      <p:embed/>
                      <p:pic>
                        <p:nvPicPr>
                          <p:cNvPr id="24" name="Object 23">
                            <a:extLst>
                              <a:ext uri="{FF2B5EF4-FFF2-40B4-BE49-F238E27FC236}">
                                <a16:creationId xmlns:a16="http://schemas.microsoft.com/office/drawing/2014/main" id="{088EBE1D-6FBB-4235-AB14-65CCFB6B2B9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9557608" y="5561536"/>
                            <a:ext cx="2763838" cy="21447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7AA92B9C-AA8E-BD4D-E42F-95A222ECFEA7}"/>
                  </a:ext>
                </a:extLst>
              </p:cNvPr>
              <p:cNvSpPr txBox="1"/>
              <p:nvPr/>
            </p:nvSpPr>
            <p:spPr>
              <a:xfrm>
                <a:off x="10230424" y="7593300"/>
                <a:ext cx="981359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/>
                  <a:t>Young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864C348C-DC93-84C9-99FC-0B312771F834}"/>
                  </a:ext>
                </a:extLst>
              </p:cNvPr>
              <p:cNvSpPr txBox="1"/>
              <p:nvPr/>
            </p:nvSpPr>
            <p:spPr>
              <a:xfrm>
                <a:off x="11114623" y="7593300"/>
                <a:ext cx="1021433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>
                    <a:highlight>
                      <a:srgbClr val="C0C0C0"/>
                    </a:highlight>
                  </a:rPr>
                  <a:t>Mid-aged</a:t>
                </a:r>
              </a:p>
            </p:txBody>
          </p:sp>
        </p:grp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0E3CDAC-2432-53F0-D7FA-85C72864BAD0}"/>
                </a:ext>
              </a:extLst>
            </p:cNvPr>
            <p:cNvSpPr txBox="1"/>
            <p:nvPr/>
          </p:nvSpPr>
          <p:spPr>
            <a:xfrm>
              <a:off x="6413557" y="117262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C7C091C-59EA-FC39-1A87-3560C71E7F29}"/>
                </a:ext>
              </a:extLst>
            </p:cNvPr>
            <p:cNvSpPr txBox="1"/>
            <p:nvPr/>
          </p:nvSpPr>
          <p:spPr>
            <a:xfrm>
              <a:off x="74977" y="4961494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E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44912D1-694C-C939-7CA0-01EDC89A4A26}"/>
                </a:ext>
              </a:extLst>
            </p:cNvPr>
            <p:cNvSpPr txBox="1"/>
            <p:nvPr/>
          </p:nvSpPr>
          <p:spPr>
            <a:xfrm>
              <a:off x="1430558" y="223682"/>
              <a:ext cx="1482674" cy="328210"/>
            </a:xfrm>
            <a:prstGeom prst="rect">
              <a:avLst/>
            </a:prstGeom>
            <a:noFill/>
          </p:spPr>
          <p:txBody>
            <a:bodyPr wrap="none" lIns="111677" tIns="55838" rIns="111677" bIns="55838" rtlCol="0">
              <a:spAutoFit/>
            </a:bodyPr>
            <a:lstStyle/>
            <a:p>
              <a:r>
                <a:rPr lang="en-GB" sz="1400" dirty="0">
                  <a:latin typeface="Myriad Pro"/>
                </a:rPr>
                <a:t>Rat aortic SMCs</a:t>
              </a:r>
            </a:p>
          </p:txBody>
        </p:sp>
        <p:graphicFrame>
          <p:nvGraphicFramePr>
            <p:cNvPr id="46" name="Object 45">
              <a:extLst>
                <a:ext uri="{FF2B5EF4-FFF2-40B4-BE49-F238E27FC236}">
                  <a16:creationId xmlns:a16="http://schemas.microsoft.com/office/drawing/2014/main" id="{7EE89141-A537-6F48-AE96-48E44976F65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02269082"/>
                </p:ext>
              </p:extLst>
            </p:nvPr>
          </p:nvGraphicFramePr>
          <p:xfrm>
            <a:off x="3593954" y="135269"/>
            <a:ext cx="2862744" cy="253596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4" imgW="3928046" imgH="2797871" progId="Prism10.Document">
                    <p:embed/>
                  </p:oleObj>
                </mc:Choice>
                <mc:Fallback>
                  <p:oleObj name="Prism 10" r:id="rId14" imgW="3928046" imgH="2797871" progId="Prism10.Document">
                    <p:embed/>
                    <p:pic>
                      <p:nvPicPr>
                        <p:cNvPr id="46" name="Object 45">
                          <a:extLst>
                            <a:ext uri="{FF2B5EF4-FFF2-40B4-BE49-F238E27FC236}">
                              <a16:creationId xmlns:a16="http://schemas.microsoft.com/office/drawing/2014/main" id="{7EE89141-A537-6F48-AE96-48E44976F65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3593954" y="135269"/>
                          <a:ext cx="2862744" cy="253596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CAC14E24-8F2D-C36D-3BC7-FD1EECBC4EAC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 l="51389" t="19924" r="18556" b="47258"/>
            <a:stretch>
              <a:fillRect/>
            </a:stretch>
          </p:blipFill>
          <p:spPr>
            <a:xfrm>
              <a:off x="1235616" y="745572"/>
              <a:ext cx="1845352" cy="1431588"/>
            </a:xfrm>
            <a:prstGeom prst="rect">
              <a:avLst/>
            </a:prstGeom>
          </p:spPr>
        </p:pic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60B2C43-A5AE-3EC1-EC4D-596696022B19}"/>
                </a:ext>
              </a:extLst>
            </p:cNvPr>
            <p:cNvSpPr txBox="1"/>
            <p:nvPr/>
          </p:nvSpPr>
          <p:spPr>
            <a:xfrm>
              <a:off x="-8301" y="1259826"/>
              <a:ext cx="11315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dirty="0">
                  <a:latin typeface="Myriad Pro"/>
                  <a:cs typeface="Arial" panose="020B0604020202020204" pitchFamily="34" charset="0"/>
                </a:rPr>
                <a:t>IB: PKARI</a:t>
              </a:r>
              <a:r>
                <a:rPr lang="el-GR" sz="1200" dirty="0">
                  <a:latin typeface="Myriad Pro"/>
                  <a:cs typeface="Arial" panose="020B0604020202020204" pitchFamily="34" charset="0"/>
                </a:rPr>
                <a:t>α</a:t>
              </a:r>
              <a:endParaRPr lang="en-GB" sz="1200" dirty="0">
                <a:latin typeface="Myriad Pro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Myriad Pro"/>
                </a:rPr>
                <a:t>Non-reducing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CB563EEA-0ACA-7B8D-056B-52B35D78B2A6}"/>
                </a:ext>
              </a:extLst>
            </p:cNvPr>
            <p:cNvCxnSpPr>
              <a:cxnSpLocks/>
            </p:cNvCxnSpPr>
            <p:nvPr/>
          </p:nvCxnSpPr>
          <p:spPr>
            <a:xfrm>
              <a:off x="1062624" y="945506"/>
              <a:ext cx="102257" cy="0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DC2A4290-3D38-31F4-1713-A81CEFE70FCC}"/>
                </a:ext>
              </a:extLst>
            </p:cNvPr>
            <p:cNvCxnSpPr>
              <a:cxnSpLocks/>
            </p:cNvCxnSpPr>
            <p:nvPr/>
          </p:nvCxnSpPr>
          <p:spPr>
            <a:xfrm>
              <a:off x="1062624" y="1932831"/>
              <a:ext cx="102257" cy="0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41E3D1D-6763-70AC-FE91-882680EEFBA9}"/>
                </a:ext>
              </a:extLst>
            </p:cNvPr>
            <p:cNvSpPr txBox="1"/>
            <p:nvPr/>
          </p:nvSpPr>
          <p:spPr>
            <a:xfrm>
              <a:off x="790704" y="821564"/>
              <a:ext cx="2744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Myriad Pro"/>
                </a:rPr>
                <a:t>D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D4C348D-9AD9-B29A-4B00-4DC2E9344258}"/>
                </a:ext>
              </a:extLst>
            </p:cNvPr>
            <p:cNvSpPr txBox="1"/>
            <p:nvPr/>
          </p:nvSpPr>
          <p:spPr>
            <a:xfrm>
              <a:off x="790704" y="1827757"/>
              <a:ext cx="3000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Myriad Pro"/>
                </a:rPr>
                <a:t>M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8997665C-40DE-00E6-9F29-6AE68AF9CFE6}"/>
                </a:ext>
              </a:extLst>
            </p:cNvPr>
            <p:cNvSpPr txBox="1"/>
            <p:nvPr/>
          </p:nvSpPr>
          <p:spPr>
            <a:xfrm>
              <a:off x="102999" y="2107486"/>
              <a:ext cx="36131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Myriad Pro"/>
                </a:rPr>
                <a:t>H</a:t>
              </a:r>
              <a:r>
                <a:rPr lang="en-GB" sz="1400" baseline="-25000" dirty="0">
                  <a:latin typeface="Myriad Pro"/>
                </a:rPr>
                <a:t>2</a:t>
              </a:r>
              <a:r>
                <a:rPr lang="en-GB" sz="1400" dirty="0">
                  <a:latin typeface="Myriad Pro"/>
                </a:rPr>
                <a:t>O</a:t>
              </a:r>
              <a:r>
                <a:rPr lang="en-GB" sz="1400" baseline="-25000" dirty="0">
                  <a:latin typeface="Myriad Pro"/>
                </a:rPr>
                <a:t>2</a:t>
              </a:r>
              <a:r>
                <a:rPr lang="en-GB" sz="1400" dirty="0">
                  <a:latin typeface="Myriad Pro"/>
                </a:rPr>
                <a:t> (µM)       </a:t>
              </a:r>
              <a:r>
                <a:rPr lang="en-GB" sz="1300" dirty="0">
                  <a:latin typeface="Myriad Pro"/>
                </a:rPr>
                <a:t>0     50    100   200   500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307456F-3878-A2B1-634F-C3536FA802B2}"/>
                </a:ext>
              </a:extLst>
            </p:cNvPr>
            <p:cNvSpPr txBox="1"/>
            <p:nvPr/>
          </p:nvSpPr>
          <p:spPr>
            <a:xfrm>
              <a:off x="3054763" y="813065"/>
              <a:ext cx="4336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GB" sz="10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42A19789-F112-51AD-C18F-B3ABDFB42C62}"/>
                </a:ext>
              </a:extLst>
            </p:cNvPr>
            <p:cNvSpPr txBox="1"/>
            <p:nvPr/>
          </p:nvSpPr>
          <p:spPr>
            <a:xfrm>
              <a:off x="3079815" y="1093066"/>
              <a:ext cx="4460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en-GB" sz="10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D0DF77F-AD41-5DC3-9254-A0D21BBF600F}"/>
                </a:ext>
              </a:extLst>
            </p:cNvPr>
            <p:cNvSpPr txBox="1"/>
            <p:nvPr/>
          </p:nvSpPr>
          <p:spPr>
            <a:xfrm>
              <a:off x="3070488" y="568757"/>
              <a:ext cx="4277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83D35886-FE57-F53C-38EC-1F4F9FFE57CF}"/>
                </a:ext>
              </a:extLst>
            </p:cNvPr>
            <p:cNvSpPr txBox="1"/>
            <p:nvPr/>
          </p:nvSpPr>
          <p:spPr>
            <a:xfrm>
              <a:off x="3080968" y="1741390"/>
              <a:ext cx="4668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GB" sz="10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1AAC8892-611B-3FFD-9279-D72802A6B2CD}"/>
                </a:ext>
              </a:extLst>
            </p:cNvPr>
            <p:cNvGrpSpPr/>
            <p:nvPr/>
          </p:nvGrpSpPr>
          <p:grpSpPr>
            <a:xfrm>
              <a:off x="136518" y="8103371"/>
              <a:ext cx="2740025" cy="2630082"/>
              <a:chOff x="6474454" y="8172031"/>
              <a:chExt cx="2740025" cy="2630082"/>
            </a:xfrm>
          </p:grpSpPr>
          <p:graphicFrame>
            <p:nvGraphicFramePr>
              <p:cNvPr id="34" name="Object 33">
                <a:extLst>
                  <a:ext uri="{FF2B5EF4-FFF2-40B4-BE49-F238E27FC236}">
                    <a16:creationId xmlns:a16="http://schemas.microsoft.com/office/drawing/2014/main" id="{7AE360D6-39BF-917C-932C-C44CEDBE16D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86714067"/>
                  </p:ext>
                </p:extLst>
              </p:nvPr>
            </p:nvGraphicFramePr>
            <p:xfrm>
              <a:off x="6474454" y="8172031"/>
              <a:ext cx="2740025" cy="21844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7" imgW="2739552" imgH="2184694" progId="Prism10.Document">
                      <p:embed/>
                    </p:oleObj>
                  </mc:Choice>
                  <mc:Fallback>
                    <p:oleObj name="Prism 10" r:id="rId17" imgW="2739552" imgH="2184694" progId="Prism10.Document">
                      <p:embed/>
                      <p:pic>
                        <p:nvPicPr>
                          <p:cNvPr id="34" name="Object 33">
                            <a:extLst>
                              <a:ext uri="{FF2B5EF4-FFF2-40B4-BE49-F238E27FC236}">
                                <a16:creationId xmlns:a16="http://schemas.microsoft.com/office/drawing/2014/main" id="{7AE360D6-39BF-917C-932C-C44CEDBE16D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6474454" y="8172031"/>
                            <a:ext cx="2740025" cy="21844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39A5BD68-282E-7CB0-C8DF-35B31FC24CAD}"/>
                  </a:ext>
                </a:extLst>
              </p:cNvPr>
              <p:cNvSpPr txBox="1"/>
              <p:nvPr/>
            </p:nvSpPr>
            <p:spPr>
              <a:xfrm>
                <a:off x="7058719" y="10278893"/>
                <a:ext cx="981359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/>
                  <a:t>Young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B33393A6-199A-DF28-093E-9AED83454415}"/>
                  </a:ext>
                </a:extLst>
              </p:cNvPr>
              <p:cNvSpPr txBox="1"/>
              <p:nvPr/>
            </p:nvSpPr>
            <p:spPr>
              <a:xfrm>
                <a:off x="7944178" y="10278893"/>
                <a:ext cx="1021433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>
                    <a:highlight>
                      <a:srgbClr val="C0C0C0"/>
                    </a:highlight>
                  </a:rPr>
                  <a:t>Mid-aged</a:t>
                </a:r>
              </a:p>
            </p:txBody>
          </p:sp>
        </p:grp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C5FBD5A3-9CE6-569B-EC2F-09C12301A174}"/>
                </a:ext>
              </a:extLst>
            </p:cNvPr>
            <p:cNvGrpSpPr/>
            <p:nvPr/>
          </p:nvGrpSpPr>
          <p:grpSpPr>
            <a:xfrm>
              <a:off x="2696665" y="8103371"/>
              <a:ext cx="2662238" cy="2616014"/>
              <a:chOff x="8865785" y="8186099"/>
              <a:chExt cx="2662238" cy="2616014"/>
            </a:xfrm>
          </p:grpSpPr>
          <p:graphicFrame>
            <p:nvGraphicFramePr>
              <p:cNvPr id="35" name="Object 34">
                <a:extLst>
                  <a:ext uri="{FF2B5EF4-FFF2-40B4-BE49-F238E27FC236}">
                    <a16:creationId xmlns:a16="http://schemas.microsoft.com/office/drawing/2014/main" id="{A6E770C1-57CD-DB07-A0FE-EE211DE14FC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97218495"/>
                  </p:ext>
                </p:extLst>
              </p:nvPr>
            </p:nvGraphicFramePr>
            <p:xfrm>
              <a:off x="8865785" y="8186099"/>
              <a:ext cx="2662238" cy="21844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9" imgW="2661763" imgH="2184694" progId="Prism10.Document">
                      <p:embed/>
                    </p:oleObj>
                  </mc:Choice>
                  <mc:Fallback>
                    <p:oleObj name="Prism 10" r:id="rId19" imgW="2661763" imgH="2184694" progId="Prism10.Document">
                      <p:embed/>
                      <p:pic>
                        <p:nvPicPr>
                          <p:cNvPr id="35" name="Object 34">
                            <a:extLst>
                              <a:ext uri="{FF2B5EF4-FFF2-40B4-BE49-F238E27FC236}">
                                <a16:creationId xmlns:a16="http://schemas.microsoft.com/office/drawing/2014/main" id="{A6E770C1-57CD-DB07-A0FE-EE211DE14FC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8865785" y="8186099"/>
                            <a:ext cx="2662238" cy="21844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2576A7A9-D05E-EEBA-5181-BADA524989F9}"/>
                  </a:ext>
                </a:extLst>
              </p:cNvPr>
              <p:cNvSpPr txBox="1"/>
              <p:nvPr/>
            </p:nvSpPr>
            <p:spPr>
              <a:xfrm>
                <a:off x="9387691" y="10278893"/>
                <a:ext cx="981359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/>
                  <a:t>Young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DE0AE3B4-8193-6D7C-F55F-E69762D6E86A}"/>
                  </a:ext>
                </a:extLst>
              </p:cNvPr>
              <p:cNvSpPr txBox="1"/>
              <p:nvPr/>
            </p:nvSpPr>
            <p:spPr>
              <a:xfrm>
                <a:off x="10280814" y="10278893"/>
                <a:ext cx="1021433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>
                    <a:highlight>
                      <a:srgbClr val="C0C0C0"/>
                    </a:highlight>
                  </a:rPr>
                  <a:t>Mid-aged</a:t>
                </a:r>
              </a:p>
            </p:txBody>
          </p: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14B1D619-27EA-4A37-0ABA-2648A9F5D884}"/>
                </a:ext>
              </a:extLst>
            </p:cNvPr>
            <p:cNvGrpSpPr/>
            <p:nvPr/>
          </p:nvGrpSpPr>
          <p:grpSpPr>
            <a:xfrm>
              <a:off x="5003844" y="8132804"/>
              <a:ext cx="2662237" cy="2600649"/>
              <a:chOff x="11299576" y="8201464"/>
              <a:chExt cx="2662237" cy="2600649"/>
            </a:xfrm>
          </p:grpSpPr>
          <p:graphicFrame>
            <p:nvGraphicFramePr>
              <p:cNvPr id="39" name="Object 38">
                <a:extLst>
                  <a:ext uri="{FF2B5EF4-FFF2-40B4-BE49-F238E27FC236}">
                    <a16:creationId xmlns:a16="http://schemas.microsoft.com/office/drawing/2014/main" id="{D2D1A028-563A-7705-1EBE-B4F7E76F097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591417749"/>
                  </p:ext>
                </p:extLst>
              </p:nvPr>
            </p:nvGraphicFramePr>
            <p:xfrm>
              <a:off x="11299576" y="8201464"/>
              <a:ext cx="2662237" cy="21478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21" imgW="2661763" imgH="2184694" progId="Prism10.Document">
                      <p:embed/>
                    </p:oleObj>
                  </mc:Choice>
                  <mc:Fallback>
                    <p:oleObj name="Prism 10" r:id="rId21" imgW="2661763" imgH="2184694" progId="Prism10.Document">
                      <p:embed/>
                      <p:pic>
                        <p:nvPicPr>
                          <p:cNvPr id="39" name="Object 38">
                            <a:extLst>
                              <a:ext uri="{FF2B5EF4-FFF2-40B4-BE49-F238E27FC236}">
                                <a16:creationId xmlns:a16="http://schemas.microsoft.com/office/drawing/2014/main" id="{D2D1A028-563A-7705-1EBE-B4F7E76F097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11299576" y="8201464"/>
                            <a:ext cx="2662237" cy="21478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B673318D-6B77-0E4B-515B-2C2300209003}"/>
                  </a:ext>
                </a:extLst>
              </p:cNvPr>
              <p:cNvSpPr txBox="1"/>
              <p:nvPr/>
            </p:nvSpPr>
            <p:spPr>
              <a:xfrm>
                <a:off x="11818809" y="10278893"/>
                <a:ext cx="981359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/>
                  <a:t>Young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3097DA7B-76AC-B707-F269-6E682A3EEC7D}"/>
                  </a:ext>
                </a:extLst>
              </p:cNvPr>
              <p:cNvSpPr txBox="1"/>
              <p:nvPr/>
            </p:nvSpPr>
            <p:spPr>
              <a:xfrm>
                <a:off x="12698704" y="10278893"/>
                <a:ext cx="1021433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400" dirty="0"/>
                  <a:t>WT   </a:t>
                </a:r>
                <a:r>
                  <a:rPr lang="en-GB" sz="1400" dirty="0">
                    <a:solidFill>
                      <a:srgbClr val="C00000"/>
                    </a:solidFill>
                  </a:rPr>
                  <a:t>PKA KI</a:t>
                </a:r>
              </a:p>
              <a:p>
                <a:pPr algn="ctr"/>
                <a:r>
                  <a:rPr lang="en-GB" sz="1400" dirty="0">
                    <a:highlight>
                      <a:srgbClr val="C0C0C0"/>
                    </a:highlight>
                  </a:rPr>
                  <a:t>Mid-aged</a:t>
                </a:r>
              </a:p>
            </p:txBody>
          </p:sp>
        </p:grpSp>
        <p:graphicFrame>
          <p:nvGraphicFramePr>
            <p:cNvPr id="79" name="Object 78">
              <a:extLst>
                <a:ext uri="{FF2B5EF4-FFF2-40B4-BE49-F238E27FC236}">
                  <a16:creationId xmlns:a16="http://schemas.microsoft.com/office/drawing/2014/main" id="{FF7B2D4C-7C5D-68DA-421F-2F98BCF756F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52491555"/>
                </p:ext>
              </p:extLst>
            </p:nvPr>
          </p:nvGraphicFramePr>
          <p:xfrm>
            <a:off x="538163" y="2659333"/>
            <a:ext cx="2097087" cy="2185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3" imgW="2096470" imgH="2185522" progId="Prism10.Document">
                    <p:embed/>
                  </p:oleObj>
                </mc:Choice>
                <mc:Fallback>
                  <p:oleObj name="Prism 10" r:id="rId23" imgW="2096470" imgH="2185522" progId="Prism10.Document">
                    <p:embed/>
                    <p:pic>
                      <p:nvPicPr>
                        <p:cNvPr id="79" name="Object 78">
                          <a:extLst>
                            <a:ext uri="{FF2B5EF4-FFF2-40B4-BE49-F238E27FC236}">
                              <a16:creationId xmlns:a16="http://schemas.microsoft.com/office/drawing/2014/main" id="{FF7B2D4C-7C5D-68DA-421F-2F98BCF756F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538163" y="2659333"/>
                          <a:ext cx="2097087" cy="2185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0" name="Object 79">
              <a:extLst>
                <a:ext uri="{FF2B5EF4-FFF2-40B4-BE49-F238E27FC236}">
                  <a16:creationId xmlns:a16="http://schemas.microsoft.com/office/drawing/2014/main" id="{39C64C61-082B-7CE8-3456-0E4F74494CB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0860442"/>
                </p:ext>
              </p:extLst>
            </p:nvPr>
          </p:nvGraphicFramePr>
          <p:xfrm>
            <a:off x="2835275" y="2678383"/>
            <a:ext cx="2097088" cy="2185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5" imgW="2096470" imgH="2185522" progId="Prism10.Document">
                    <p:embed/>
                  </p:oleObj>
                </mc:Choice>
                <mc:Fallback>
                  <p:oleObj name="Prism 10" r:id="rId25" imgW="2096470" imgH="2185522" progId="Prism10.Document">
                    <p:embed/>
                    <p:pic>
                      <p:nvPicPr>
                        <p:cNvPr id="80" name="Object 79">
                          <a:extLst>
                            <a:ext uri="{FF2B5EF4-FFF2-40B4-BE49-F238E27FC236}">
                              <a16:creationId xmlns:a16="http://schemas.microsoft.com/office/drawing/2014/main" id="{39C64C61-082B-7CE8-3456-0E4F74494CB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2835275" y="2678383"/>
                          <a:ext cx="2097088" cy="2185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126850BA-E46D-4DE3-415D-2E3BCE690621}"/>
                </a:ext>
              </a:extLst>
            </p:cNvPr>
            <p:cNvSpPr txBox="1"/>
            <p:nvPr/>
          </p:nvSpPr>
          <p:spPr>
            <a:xfrm>
              <a:off x="1430558" y="4765195"/>
              <a:ext cx="106150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/>
                <a:t>WT    </a:t>
              </a:r>
              <a:r>
                <a:rPr lang="en-GB" sz="1400" dirty="0">
                  <a:solidFill>
                    <a:srgbClr val="C00000"/>
                  </a:solidFill>
                </a:rPr>
                <a:t>PKA KI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D3B49008-895E-9428-4816-771BF7C82CFE}"/>
                </a:ext>
              </a:extLst>
            </p:cNvPr>
            <p:cNvSpPr txBox="1"/>
            <p:nvPr/>
          </p:nvSpPr>
          <p:spPr>
            <a:xfrm>
              <a:off x="3716188" y="4765195"/>
              <a:ext cx="106150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/>
                <a:t>WT    </a:t>
              </a:r>
              <a:r>
                <a:rPr lang="en-GB" sz="1400" dirty="0">
                  <a:solidFill>
                    <a:srgbClr val="C00000"/>
                  </a:solidFill>
                </a:rPr>
                <a:t>PKA KI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1DF5CC0-4EA9-2754-6194-0D057A6F62E3}"/>
                </a:ext>
              </a:extLst>
            </p:cNvPr>
            <p:cNvSpPr txBox="1"/>
            <p:nvPr/>
          </p:nvSpPr>
          <p:spPr>
            <a:xfrm>
              <a:off x="74977" y="7978056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F</a:t>
              </a:r>
              <a:endParaRPr lang="en-GB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CED9B9B-5D61-D484-9137-ACCB58C4250D}"/>
                </a:ext>
              </a:extLst>
            </p:cNvPr>
            <p:cNvSpPr txBox="1"/>
            <p:nvPr/>
          </p:nvSpPr>
          <p:spPr>
            <a:xfrm>
              <a:off x="1702142" y="5138981"/>
              <a:ext cx="2884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i="1" dirty="0">
                  <a:solidFill>
                    <a:srgbClr val="002060"/>
                  </a:solidFill>
                  <a:latin typeface="Myriad Pro"/>
                </a:rPr>
                <a:t>Right Common Carotid Artery flow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940E436-ED9E-8F22-F234-158FA4764EF2}"/>
                </a:ext>
              </a:extLst>
            </p:cNvPr>
            <p:cNvSpPr txBox="1"/>
            <p:nvPr/>
          </p:nvSpPr>
          <p:spPr>
            <a:xfrm>
              <a:off x="6555321" y="5138981"/>
              <a:ext cx="28083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i="1" dirty="0">
                  <a:solidFill>
                    <a:srgbClr val="002060"/>
                  </a:solidFill>
                  <a:latin typeface="Myriad Pro"/>
                </a:rPr>
                <a:t>Left Common Carotid Artery flow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2105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BCEBC89-CD2E-EFA9-081F-63F7DF3AB8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A851BA18-F517-A09A-7D0B-3D0DC0FADC80}"/>
              </a:ext>
            </a:extLst>
          </p:cNvPr>
          <p:cNvGrpSpPr/>
          <p:nvPr/>
        </p:nvGrpSpPr>
        <p:grpSpPr>
          <a:xfrm>
            <a:off x="0" y="88131"/>
            <a:ext cx="14700203" cy="8111654"/>
            <a:chOff x="226012" y="43306"/>
            <a:chExt cx="14700203" cy="8111654"/>
          </a:xfrm>
        </p:grpSpPr>
        <p:sp>
          <p:nvSpPr>
            <p:cNvPr id="455" name="TextBox 454">
              <a:extLst>
                <a:ext uri="{FF2B5EF4-FFF2-40B4-BE49-F238E27FC236}">
                  <a16:creationId xmlns:a16="http://schemas.microsoft.com/office/drawing/2014/main" id="{15FF37B8-B53B-F280-181C-8C2B31830051}"/>
                </a:ext>
              </a:extLst>
            </p:cNvPr>
            <p:cNvSpPr txBox="1"/>
            <p:nvPr/>
          </p:nvSpPr>
          <p:spPr>
            <a:xfrm>
              <a:off x="11655451" y="43306"/>
              <a:ext cx="327076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2</a:t>
              </a:r>
              <a:endParaRPr lang="en-GB" dirty="0"/>
            </a:p>
          </p:txBody>
        </p:sp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CBDA3106-7E24-306C-FCFB-6D8E2D211BE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31052137"/>
                </p:ext>
              </p:extLst>
            </p:nvPr>
          </p:nvGraphicFramePr>
          <p:xfrm>
            <a:off x="3368675" y="4964113"/>
            <a:ext cx="3051175" cy="2720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" imgW="2411750" imgH="2200641" progId="Prism10.Document">
                    <p:embed/>
                  </p:oleObj>
                </mc:Choice>
                <mc:Fallback>
                  <p:oleObj name="Prism 10" r:id="rId3" imgW="2411750" imgH="2200641" progId="Prism10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CBDA3106-7E24-306C-FCFB-6D8E2D211BE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368675" y="4964113"/>
                          <a:ext cx="3051175" cy="2720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BC9DF592-1C23-32CC-1C8B-1D2160A4D9C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6012508"/>
                </p:ext>
              </p:extLst>
            </p:nvPr>
          </p:nvGraphicFramePr>
          <p:xfrm>
            <a:off x="6167438" y="4973472"/>
            <a:ext cx="3089275" cy="27066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5" imgW="2389075" imgH="2200641" progId="Prism10.Document">
                    <p:embed/>
                  </p:oleObj>
                </mc:Choice>
                <mc:Fallback>
                  <p:oleObj name="Prism 10" r:id="rId5" imgW="2389075" imgH="2200641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BC9DF592-1C23-32CC-1C8B-1D2160A4D9C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167438" y="4973472"/>
                          <a:ext cx="3089275" cy="27066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05BE1EF0-6F7D-D094-A079-00CE3D069FA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78519649"/>
                </p:ext>
              </p:extLst>
            </p:nvPr>
          </p:nvGraphicFramePr>
          <p:xfrm>
            <a:off x="454685" y="4934075"/>
            <a:ext cx="2826478" cy="274678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7" imgW="2248687" imgH="2221430" progId="Prism10.Document">
                    <p:embed/>
                  </p:oleObj>
                </mc:Choice>
                <mc:Fallback>
                  <p:oleObj name="Prism 10" r:id="rId7" imgW="2248687" imgH="2221430" progId="Prism10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05BE1EF0-6F7D-D094-A079-00CE3D069FA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54685" y="4934075"/>
                          <a:ext cx="2826478" cy="274678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4B45083-FE4E-72D2-57CF-4894F63A1A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46220" r="77556" b="5258"/>
            <a:stretch/>
          </p:blipFill>
          <p:spPr>
            <a:xfrm>
              <a:off x="11543666" y="1439297"/>
              <a:ext cx="2357790" cy="2704661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5CEAB98-5443-DF4A-F355-FCE116FA2851}"/>
                </a:ext>
              </a:extLst>
            </p:cNvPr>
            <p:cNvSpPr txBox="1"/>
            <p:nvPr/>
          </p:nvSpPr>
          <p:spPr>
            <a:xfrm>
              <a:off x="13283676" y="1521488"/>
              <a:ext cx="3850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</a:rPr>
                <a:t>W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9F6F025-55DC-C52F-039E-2834346BE073}"/>
                </a:ext>
              </a:extLst>
            </p:cNvPr>
            <p:cNvSpPr txBox="1"/>
            <p:nvPr/>
          </p:nvSpPr>
          <p:spPr>
            <a:xfrm>
              <a:off x="13166657" y="2817632"/>
              <a:ext cx="619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solidFill>
                    <a:srgbClr val="FF0000"/>
                  </a:solidFill>
                  <a:latin typeface="Arial" panose="020B0604020202020204" pitchFamily="34" charset="0"/>
                </a:rPr>
                <a:t>PKA KI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64958AC-DFF2-071A-AF6F-E0B98642B2A3}"/>
                </a:ext>
              </a:extLst>
            </p:cNvPr>
            <p:cNvSpPr txBox="1"/>
            <p:nvPr/>
          </p:nvSpPr>
          <p:spPr>
            <a:xfrm>
              <a:off x="12459915" y="2016801"/>
              <a:ext cx="7447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</a:rPr>
                <a:t>AngII</a:t>
              </a:r>
              <a:r>
                <a:rPr lang="en-GB" sz="900" dirty="0">
                  <a:latin typeface="Arial" panose="020B0604020202020204" pitchFamily="34" charset="0"/>
                </a:rPr>
                <a:t>, </a:t>
              </a:r>
            </a:p>
            <a:p>
              <a:r>
                <a:rPr lang="en-GB" sz="900" dirty="0">
                  <a:latin typeface="Arial" panose="020B0604020202020204" pitchFamily="34" charset="0"/>
                </a:rPr>
                <a:t>1</a:t>
              </a:r>
              <a:r>
                <a:rPr lang="el-GR" sz="900" dirty="0">
                  <a:latin typeface="Arial" panose="020B0604020202020204" pitchFamily="34" charset="0"/>
                </a:rPr>
                <a:t>μ</a:t>
              </a:r>
              <a:r>
                <a:rPr lang="en-GB" sz="900" dirty="0">
                  <a:latin typeface="Arial" panose="020B0604020202020204" pitchFamily="34" charset="0"/>
                </a:rPr>
                <a:t>M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B46BD66-097B-911B-BCD8-0096770F877F}"/>
                </a:ext>
              </a:extLst>
            </p:cNvPr>
            <p:cNvSpPr txBox="1"/>
            <p:nvPr/>
          </p:nvSpPr>
          <p:spPr>
            <a:xfrm>
              <a:off x="12415329" y="3277746"/>
              <a:ext cx="7447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</a:rPr>
                <a:t>AngII</a:t>
              </a:r>
              <a:r>
                <a:rPr lang="en-GB" sz="900" dirty="0">
                  <a:latin typeface="Arial" panose="020B0604020202020204" pitchFamily="34" charset="0"/>
                </a:rPr>
                <a:t>, </a:t>
              </a:r>
            </a:p>
            <a:p>
              <a:r>
                <a:rPr lang="en-GB" sz="900" dirty="0">
                  <a:latin typeface="Arial" panose="020B0604020202020204" pitchFamily="34" charset="0"/>
                </a:rPr>
                <a:t>1</a:t>
              </a:r>
              <a:r>
                <a:rPr lang="el-GR" sz="900" dirty="0">
                  <a:latin typeface="Arial" panose="020B0604020202020204" pitchFamily="34" charset="0"/>
                </a:rPr>
                <a:t>μ</a:t>
              </a:r>
              <a:r>
                <a:rPr lang="en-GB" sz="900" dirty="0">
                  <a:latin typeface="Arial" panose="020B0604020202020204" pitchFamily="34" charset="0"/>
                </a:rPr>
                <a:t>M</a:t>
              </a:r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A1486AA0-50D1-0C78-0990-84CCE32CC1EE}"/>
                </a:ext>
              </a:extLst>
            </p:cNvPr>
            <p:cNvCxnSpPr>
              <a:cxnSpLocks/>
            </p:cNvCxnSpPr>
            <p:nvPr/>
          </p:nvCxnSpPr>
          <p:spPr>
            <a:xfrm>
              <a:off x="12796277" y="2329218"/>
              <a:ext cx="72000" cy="180000"/>
            </a:xfrm>
            <a:prstGeom prst="straightConnector1">
              <a:avLst/>
            </a:prstGeom>
            <a:ln w="12700"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05DC442A-AD1D-148F-0025-C1FAB95D2F97}"/>
                </a:ext>
              </a:extLst>
            </p:cNvPr>
            <p:cNvCxnSpPr>
              <a:cxnSpLocks/>
            </p:cNvCxnSpPr>
            <p:nvPr/>
          </p:nvCxnSpPr>
          <p:spPr>
            <a:xfrm>
              <a:off x="12715692" y="3629447"/>
              <a:ext cx="72000" cy="180000"/>
            </a:xfrm>
            <a:prstGeom prst="straightConnector1">
              <a:avLst/>
            </a:prstGeom>
            <a:ln w="12700"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9FC7D778-36EF-32AA-5899-2B563D9971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44539" r="77168" b="5061"/>
            <a:stretch/>
          </p:blipFill>
          <p:spPr>
            <a:xfrm>
              <a:off x="8919344" y="1372007"/>
              <a:ext cx="2376329" cy="2771951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1DCE460-97AC-AB78-728A-13882576F157}"/>
                </a:ext>
              </a:extLst>
            </p:cNvPr>
            <p:cNvSpPr txBox="1"/>
            <p:nvPr/>
          </p:nvSpPr>
          <p:spPr>
            <a:xfrm>
              <a:off x="10620765" y="2750342"/>
              <a:ext cx="3850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</a:rPr>
                <a:t>WT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FC332F6-2413-1E54-3AD7-718F6449C3BF}"/>
                </a:ext>
              </a:extLst>
            </p:cNvPr>
            <p:cNvSpPr txBox="1"/>
            <p:nvPr/>
          </p:nvSpPr>
          <p:spPr>
            <a:xfrm>
              <a:off x="10503746" y="1454198"/>
              <a:ext cx="619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solidFill>
                    <a:srgbClr val="FF0000"/>
                  </a:solidFill>
                  <a:latin typeface="Arial" panose="020B0604020202020204" pitchFamily="34" charset="0"/>
                </a:rPr>
                <a:t>PKA KI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346920C-F6FF-8D6B-4358-C492B0F7B85F}"/>
                </a:ext>
              </a:extLst>
            </p:cNvPr>
            <p:cNvSpPr txBox="1"/>
            <p:nvPr/>
          </p:nvSpPr>
          <p:spPr>
            <a:xfrm>
              <a:off x="9613256" y="2223890"/>
              <a:ext cx="7447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</a:rPr>
                <a:t>AngII</a:t>
              </a:r>
              <a:r>
                <a:rPr lang="en-GB" sz="900" dirty="0">
                  <a:latin typeface="Arial" panose="020B0604020202020204" pitchFamily="34" charset="0"/>
                </a:rPr>
                <a:t>, </a:t>
              </a:r>
            </a:p>
            <a:p>
              <a:r>
                <a:rPr lang="en-GB" sz="900" dirty="0">
                  <a:latin typeface="Arial" panose="020B0604020202020204" pitchFamily="34" charset="0"/>
                </a:rPr>
                <a:t>1</a:t>
              </a:r>
              <a:r>
                <a:rPr lang="el-GR" sz="900" dirty="0">
                  <a:latin typeface="Arial" panose="020B0604020202020204" pitchFamily="34" charset="0"/>
                </a:rPr>
                <a:t>μ</a:t>
              </a:r>
              <a:r>
                <a:rPr lang="en-GB" sz="900" dirty="0">
                  <a:latin typeface="Arial" panose="020B0604020202020204" pitchFamily="34" charset="0"/>
                </a:rPr>
                <a:t>M</a:t>
              </a:r>
            </a:p>
          </p:txBody>
        </p: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CE46BDB9-ABB3-5C6C-120B-B279A564C9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584078" y="2271350"/>
              <a:ext cx="0" cy="478992"/>
            </a:xfrm>
            <a:prstGeom prst="straightConnector1">
              <a:avLst/>
            </a:prstGeom>
            <a:ln w="12700"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A115160-67CA-4F69-56CE-BDB4931097DD}"/>
                </a:ext>
              </a:extLst>
            </p:cNvPr>
            <p:cNvSpPr txBox="1"/>
            <p:nvPr/>
          </p:nvSpPr>
          <p:spPr>
            <a:xfrm>
              <a:off x="9656086" y="3670859"/>
              <a:ext cx="7447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>
                  <a:latin typeface="Arial" panose="020B0604020202020204" pitchFamily="34" charset="0"/>
                </a:rPr>
                <a:t>AngII</a:t>
              </a:r>
              <a:r>
                <a:rPr lang="en-GB" sz="900" dirty="0">
                  <a:latin typeface="Arial" panose="020B0604020202020204" pitchFamily="34" charset="0"/>
                </a:rPr>
                <a:t>, </a:t>
              </a:r>
            </a:p>
            <a:p>
              <a:r>
                <a:rPr lang="en-GB" sz="900" dirty="0">
                  <a:latin typeface="Arial" panose="020B0604020202020204" pitchFamily="34" charset="0"/>
                </a:rPr>
                <a:t>1</a:t>
              </a:r>
              <a:r>
                <a:rPr lang="el-GR" sz="900" dirty="0">
                  <a:latin typeface="Arial" panose="020B0604020202020204" pitchFamily="34" charset="0"/>
                </a:rPr>
                <a:t>μ</a:t>
              </a:r>
              <a:r>
                <a:rPr lang="en-GB" sz="900" dirty="0">
                  <a:latin typeface="Arial" panose="020B0604020202020204" pitchFamily="34" charset="0"/>
                </a:rPr>
                <a:t>M</a:t>
              </a: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6A534198-DE1D-0A50-C48E-CAAF15A3478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620517" y="3753584"/>
              <a:ext cx="92199" cy="184665"/>
            </a:xfrm>
            <a:prstGeom prst="straightConnector1">
              <a:avLst/>
            </a:prstGeom>
            <a:ln w="12700"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3311AE3-00FB-697E-BD60-33E43E9FFC69}"/>
                </a:ext>
              </a:extLst>
            </p:cNvPr>
            <p:cNvSpPr txBox="1"/>
            <p:nvPr/>
          </p:nvSpPr>
          <p:spPr>
            <a:xfrm>
              <a:off x="9491970" y="924158"/>
              <a:ext cx="1630856" cy="328210"/>
            </a:xfrm>
            <a:prstGeom prst="rect">
              <a:avLst/>
            </a:prstGeom>
            <a:noFill/>
          </p:spPr>
          <p:txBody>
            <a:bodyPr wrap="square" lIns="111677" tIns="55838" rIns="111677" bIns="55838" rtlCol="0">
              <a:spAutoFit/>
            </a:bodyPr>
            <a:lstStyle/>
            <a:p>
              <a:r>
                <a:rPr lang="en-GB" sz="1400" i="1" dirty="0">
                  <a:solidFill>
                    <a:srgbClr val="002060"/>
                  </a:solidFill>
                  <a:latin typeface="Myriad Pro"/>
                </a:rPr>
                <a:t>Abdominal aortae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C03EAD0-B544-826B-F14A-174F1E4A3AE8}"/>
                </a:ext>
              </a:extLst>
            </p:cNvPr>
            <p:cNvSpPr txBox="1"/>
            <p:nvPr/>
          </p:nvSpPr>
          <p:spPr>
            <a:xfrm>
              <a:off x="11978777" y="924158"/>
              <a:ext cx="1734987" cy="328210"/>
            </a:xfrm>
            <a:prstGeom prst="rect">
              <a:avLst/>
            </a:prstGeom>
            <a:noFill/>
          </p:spPr>
          <p:txBody>
            <a:bodyPr wrap="square" lIns="111677" tIns="55838" rIns="111677" bIns="55838" rtlCol="0">
              <a:spAutoFit/>
            </a:bodyPr>
            <a:lstStyle/>
            <a:p>
              <a:r>
                <a:rPr lang="en-GB" sz="1400" i="1" dirty="0">
                  <a:solidFill>
                    <a:srgbClr val="002060"/>
                  </a:solidFill>
                  <a:latin typeface="Myriad Pro"/>
                </a:rPr>
                <a:t>Mesenteric arteries 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6BFF7D0-AFCA-E2E6-B983-FEE529D78972}"/>
                </a:ext>
              </a:extLst>
            </p:cNvPr>
            <p:cNvSpPr txBox="1"/>
            <p:nvPr/>
          </p:nvSpPr>
          <p:spPr>
            <a:xfrm>
              <a:off x="551732" y="392825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9681AA15-EFCC-5F46-C07E-79A6277BAD7D}"/>
                </a:ext>
              </a:extLst>
            </p:cNvPr>
            <p:cNvGrpSpPr/>
            <p:nvPr/>
          </p:nvGrpSpPr>
          <p:grpSpPr>
            <a:xfrm>
              <a:off x="364618" y="3057765"/>
              <a:ext cx="3234930" cy="1067182"/>
              <a:chOff x="4854423" y="8128245"/>
              <a:chExt cx="3234930" cy="1061302"/>
            </a:xfrm>
          </p:grpSpPr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0CE62F2-43B0-B3D2-C6BA-42E7D50D50AD}"/>
                  </a:ext>
                </a:extLst>
              </p:cNvPr>
              <p:cNvSpPr txBox="1"/>
              <p:nvPr/>
            </p:nvSpPr>
            <p:spPr>
              <a:xfrm>
                <a:off x="5505616" y="8128245"/>
                <a:ext cx="312906" cy="9182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  <a:p>
                <a:pPr algn="ct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  <a:p>
                <a:pPr algn="ctr"/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CEBA3277-34BF-7BFF-D206-C133C0FB1DCF}"/>
                  </a:ext>
                </a:extLst>
              </p:cNvPr>
              <p:cNvSpPr txBox="1"/>
              <p:nvPr/>
            </p:nvSpPr>
            <p:spPr>
              <a:xfrm>
                <a:off x="4854423" y="8912548"/>
                <a:ext cx="30904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GB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gII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GB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)       0           1         10       100</a:t>
                </a:r>
              </a:p>
            </p:txBody>
          </p:sp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16006B1C-840C-2A78-E1FC-7B3CD74AA7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12472" t="34111" r="34658" b="36218"/>
              <a:stretch/>
            </p:blipFill>
            <p:spPr>
              <a:xfrm>
                <a:off x="5825572" y="8174045"/>
                <a:ext cx="2263781" cy="686800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</p:grpSp>
        <p:graphicFrame>
          <p:nvGraphicFramePr>
            <p:cNvPr id="42" name="Chart 41">
              <a:extLst>
                <a:ext uri="{FF2B5EF4-FFF2-40B4-BE49-F238E27FC236}">
                  <a16:creationId xmlns:a16="http://schemas.microsoft.com/office/drawing/2014/main" id="{B09BD2B4-BD7E-C0C2-4442-C15392E9ECF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34693530"/>
                </p:ext>
              </p:extLst>
            </p:nvPr>
          </p:nvGraphicFramePr>
          <p:xfrm>
            <a:off x="4011700" y="782829"/>
            <a:ext cx="4473181" cy="24571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14EF9501-8884-E5DA-D389-B8D8E749E4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25339" t="46514" r="14392" b="35823"/>
            <a:stretch/>
          </p:blipFill>
          <p:spPr>
            <a:xfrm flipH="1">
              <a:off x="4812685" y="3216916"/>
              <a:ext cx="3366234" cy="706159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graphicFrame>
          <p:nvGraphicFramePr>
            <p:cNvPr id="44" name="Chart 43">
              <a:extLst>
                <a:ext uri="{FF2B5EF4-FFF2-40B4-BE49-F238E27FC236}">
                  <a16:creationId xmlns:a16="http://schemas.microsoft.com/office/drawing/2014/main" id="{8327BAFD-D9D8-AC73-2C9E-33CC7D6220C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62676748"/>
                </p:ext>
              </p:extLst>
            </p:nvPr>
          </p:nvGraphicFramePr>
          <p:xfrm>
            <a:off x="226012" y="624653"/>
            <a:ext cx="3456384" cy="24951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830080B-A5B0-2697-7CFE-A0F0B3F632B8}"/>
                </a:ext>
              </a:extLst>
            </p:cNvPr>
            <p:cNvSpPr txBox="1"/>
            <p:nvPr/>
          </p:nvSpPr>
          <p:spPr>
            <a:xfrm>
              <a:off x="3908282" y="3978144"/>
              <a:ext cx="429797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ngII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l-GR" sz="1200" dirty="0">
                  <a:latin typeface="Arial"/>
                  <a:cs typeface="Arial"/>
                </a:rPr>
                <a:t>μ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M)     0            0         0.01       0.1 .      1          10 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GB" sz="12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GB" sz="1200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M)     0          100         0           0           0           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21725D8-9995-F517-ACAB-9AA0C222DD40}"/>
                </a:ext>
              </a:extLst>
            </p:cNvPr>
            <p:cNvSpPr txBox="1"/>
            <p:nvPr/>
          </p:nvSpPr>
          <p:spPr>
            <a:xfrm>
              <a:off x="8678509" y="392825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8768DD3-CC74-1325-4DEE-9A28B2C9A338}"/>
                </a:ext>
              </a:extLst>
            </p:cNvPr>
            <p:cNvSpPr txBox="1"/>
            <p:nvPr/>
          </p:nvSpPr>
          <p:spPr>
            <a:xfrm>
              <a:off x="551732" y="4592680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1A87EE8-9CFA-C455-D3BA-F929570729DB}"/>
                </a:ext>
              </a:extLst>
            </p:cNvPr>
            <p:cNvSpPr txBox="1"/>
            <p:nvPr/>
          </p:nvSpPr>
          <p:spPr>
            <a:xfrm>
              <a:off x="1620790" y="7570185"/>
              <a:ext cx="132921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600" dirty="0"/>
                <a:t>WT      </a:t>
              </a:r>
              <a:r>
                <a:rPr lang="en-GB" sz="1600" dirty="0">
                  <a:solidFill>
                    <a:srgbClr val="C00000"/>
                  </a:solidFill>
                </a:rPr>
                <a:t>PKA KI</a:t>
              </a:r>
            </a:p>
            <a:p>
              <a:pPr algn="ctr"/>
              <a:r>
                <a:rPr lang="en-GB" sz="1600" dirty="0">
                  <a:highlight>
                    <a:srgbClr val="C0C0C0"/>
                  </a:highlight>
                </a:rPr>
                <a:t>Mid-aged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C8CA39C-6125-F6A3-66BC-E3724E65FD85}"/>
                </a:ext>
              </a:extLst>
            </p:cNvPr>
            <p:cNvSpPr txBox="1"/>
            <p:nvPr/>
          </p:nvSpPr>
          <p:spPr>
            <a:xfrm>
              <a:off x="4545758" y="7570185"/>
              <a:ext cx="1499898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600" dirty="0"/>
                <a:t>WT     Nox2-null</a:t>
              </a:r>
            </a:p>
            <a:p>
              <a:pPr algn="ctr"/>
              <a:r>
                <a:rPr lang="en-GB" sz="1600" dirty="0">
                  <a:highlight>
                    <a:srgbClr val="C0C0C0"/>
                  </a:highlight>
                </a:rPr>
                <a:t>Mid-aged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8117BAC-0240-DA96-1D4B-053CA5D7E8D7}"/>
                </a:ext>
              </a:extLst>
            </p:cNvPr>
            <p:cNvSpPr txBox="1"/>
            <p:nvPr/>
          </p:nvSpPr>
          <p:spPr>
            <a:xfrm>
              <a:off x="7335751" y="7570185"/>
              <a:ext cx="1453410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600" dirty="0"/>
                <a:t>WT    Nox4-null</a:t>
              </a:r>
            </a:p>
            <a:p>
              <a:pPr algn="ctr"/>
              <a:r>
                <a:rPr lang="en-GB" sz="1600" dirty="0">
                  <a:highlight>
                    <a:srgbClr val="C0C0C0"/>
                  </a:highlight>
                </a:rPr>
                <a:t>Mid-aged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6B06F03-F38D-0BEA-A242-2EADF6877DB2}"/>
                </a:ext>
              </a:extLst>
            </p:cNvPr>
            <p:cNvSpPr txBox="1"/>
            <p:nvPr/>
          </p:nvSpPr>
          <p:spPr>
            <a:xfrm>
              <a:off x="3477763" y="4592680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D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097728E-07B3-9E2A-0E5F-CD953C5CACCC}"/>
                </a:ext>
              </a:extLst>
            </p:cNvPr>
            <p:cNvSpPr txBox="1"/>
            <p:nvPr/>
          </p:nvSpPr>
          <p:spPr>
            <a:xfrm>
              <a:off x="6272826" y="4592680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E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A6B7C7A-64C3-1EB2-776C-0C344A691665}"/>
                </a:ext>
              </a:extLst>
            </p:cNvPr>
            <p:cNvSpPr txBox="1"/>
            <p:nvPr/>
          </p:nvSpPr>
          <p:spPr>
            <a:xfrm>
              <a:off x="4499779" y="3216779"/>
              <a:ext cx="312906" cy="923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  <a:p>
              <a:pPr algn="ct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ctr"/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551791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02CAB3-ADF9-F2F4-5738-9A0412D8F36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C723CB1-0708-C4AD-B016-B04ED8DB13F3}"/>
              </a:ext>
            </a:extLst>
          </p:cNvPr>
          <p:cNvGrpSpPr/>
          <p:nvPr/>
        </p:nvGrpSpPr>
        <p:grpSpPr>
          <a:xfrm>
            <a:off x="49043" y="19050"/>
            <a:ext cx="14835570" cy="10285059"/>
            <a:chOff x="49043" y="19050"/>
            <a:chExt cx="14835570" cy="10285059"/>
          </a:xfrm>
        </p:grpSpPr>
        <p:sp>
          <p:nvSpPr>
            <p:cNvPr id="455" name="TextBox 454">
              <a:extLst>
                <a:ext uri="{FF2B5EF4-FFF2-40B4-BE49-F238E27FC236}">
                  <a16:creationId xmlns:a16="http://schemas.microsoft.com/office/drawing/2014/main" id="{5402082B-097F-7B0D-524F-D8C541846D17}"/>
                </a:ext>
              </a:extLst>
            </p:cNvPr>
            <p:cNvSpPr txBox="1"/>
            <p:nvPr/>
          </p:nvSpPr>
          <p:spPr>
            <a:xfrm>
              <a:off x="11613849" y="19050"/>
              <a:ext cx="327076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3</a:t>
              </a:r>
              <a:endParaRPr lang="en-GB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B60BEC5-53DE-45A2-D5D3-CB7DB1BA7339}"/>
                </a:ext>
              </a:extLst>
            </p:cNvPr>
            <p:cNvSpPr txBox="1"/>
            <p:nvPr/>
          </p:nvSpPr>
          <p:spPr>
            <a:xfrm>
              <a:off x="3887458" y="378578"/>
              <a:ext cx="3741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B</a:t>
              </a:r>
              <a:endParaRPr lang="en-GB" sz="1600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9CA6122-980B-B7FB-F91A-A9FC9296F44E}"/>
                </a:ext>
              </a:extLst>
            </p:cNvPr>
            <p:cNvSpPr txBox="1"/>
            <p:nvPr/>
          </p:nvSpPr>
          <p:spPr>
            <a:xfrm>
              <a:off x="49043" y="378578"/>
              <a:ext cx="32092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</a:t>
              </a:r>
              <a:endParaRPr lang="en-GB" sz="1600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B97C39C-CC53-AC33-D572-78FE75750E84}"/>
                </a:ext>
              </a:extLst>
            </p:cNvPr>
            <p:cNvSpPr txBox="1"/>
            <p:nvPr/>
          </p:nvSpPr>
          <p:spPr>
            <a:xfrm>
              <a:off x="49043" y="3783849"/>
              <a:ext cx="3209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D253DE83-FFC1-A183-6B6A-BD1DF7ACDC82}"/>
                </a:ext>
              </a:extLst>
            </p:cNvPr>
            <p:cNvGrpSpPr/>
            <p:nvPr/>
          </p:nvGrpSpPr>
          <p:grpSpPr>
            <a:xfrm>
              <a:off x="275089" y="717132"/>
              <a:ext cx="3860908" cy="2994080"/>
              <a:chOff x="275089" y="469482"/>
              <a:chExt cx="3860908" cy="2994080"/>
            </a:xfrm>
          </p:grpSpPr>
          <p:graphicFrame>
            <p:nvGraphicFramePr>
              <p:cNvPr id="11" name="Object 10">
                <a:extLst>
                  <a:ext uri="{FF2B5EF4-FFF2-40B4-BE49-F238E27FC236}">
                    <a16:creationId xmlns:a16="http://schemas.microsoft.com/office/drawing/2014/main" id="{256B2CD4-F788-C5F6-E86C-536BC0E6F51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4482343"/>
                  </p:ext>
                </p:extLst>
              </p:nvPr>
            </p:nvGraphicFramePr>
            <p:xfrm>
              <a:off x="275089" y="469482"/>
              <a:ext cx="3860908" cy="267286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3" imgW="7502347" imgH="4183549" progId="Prism10.Document">
                      <p:embed/>
                    </p:oleObj>
                  </mc:Choice>
                  <mc:Fallback>
                    <p:oleObj name="Prism 10" r:id="rId3" imgW="7502347" imgH="4183549" progId="Prism10.Document">
                      <p:embed/>
                      <p:pic>
                        <p:nvPicPr>
                          <p:cNvPr id="11" name="Object 10">
                            <a:extLst>
                              <a:ext uri="{FF2B5EF4-FFF2-40B4-BE49-F238E27FC236}">
                                <a16:creationId xmlns:a16="http://schemas.microsoft.com/office/drawing/2014/main" id="{256B2CD4-F788-C5F6-E86C-536BC0E6F51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275089" y="469482"/>
                            <a:ext cx="3860908" cy="267286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B65BF033-8F63-6C9C-F262-F5572547F9C2}"/>
                  </a:ext>
                </a:extLst>
              </p:cNvPr>
              <p:cNvSpPr txBox="1"/>
              <p:nvPr/>
            </p:nvSpPr>
            <p:spPr>
              <a:xfrm>
                <a:off x="1649778" y="3094230"/>
                <a:ext cx="2186817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dirty="0"/>
                  <a:t>WT     		      </a:t>
                </a:r>
                <a:r>
                  <a:rPr lang="en-GB" dirty="0">
                    <a:solidFill>
                      <a:srgbClr val="C00000"/>
                    </a:solidFill>
                  </a:rPr>
                  <a:t>PKA KI   </a:t>
                </a: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8E41D06F-6C3A-9C0E-D9CB-19CE44558F79}"/>
                </a:ext>
              </a:extLst>
            </p:cNvPr>
            <p:cNvGrpSpPr/>
            <p:nvPr/>
          </p:nvGrpSpPr>
          <p:grpSpPr>
            <a:xfrm>
              <a:off x="77207" y="4055107"/>
              <a:ext cx="9044526" cy="5129883"/>
              <a:chOff x="324123" y="-187186"/>
              <a:chExt cx="11953328" cy="6559619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614F730C-98B4-8C38-1046-CEBC41755C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3619" t="48426" r="23581" b="15512"/>
              <a:stretch/>
            </p:blipFill>
            <p:spPr>
              <a:xfrm>
                <a:off x="324123" y="244703"/>
                <a:ext cx="5828905" cy="2880319"/>
              </a:xfrm>
              <a:prstGeom prst="rect">
                <a:avLst/>
              </a:prstGeom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08D043AA-8AA5-3081-5C5E-9B6770C355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30137" t="49045" r="17674" b="15082"/>
              <a:stretch/>
            </p:blipFill>
            <p:spPr>
              <a:xfrm>
                <a:off x="324123" y="3485279"/>
                <a:ext cx="5832648" cy="2887154"/>
              </a:xfrm>
              <a:prstGeom prst="rect">
                <a:avLst/>
              </a:prstGeom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DCF8E5C0-A13C-8AEC-99BB-0C44A976978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12319" t="48995" r="33259" b="17594"/>
              <a:stretch/>
            </p:blipFill>
            <p:spPr>
              <a:xfrm>
                <a:off x="6448546" y="3485279"/>
                <a:ext cx="5828905" cy="2880320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B2AB90B1-A949-933B-660D-91236752F9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9565" t="48868" r="17978" b="15558"/>
              <a:stretch/>
            </p:blipFill>
            <p:spPr>
              <a:xfrm>
                <a:off x="6448546" y="244703"/>
                <a:ext cx="5828905" cy="2880319"/>
              </a:xfrm>
              <a:prstGeom prst="rect">
                <a:avLst/>
              </a:prstGeom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D4B14893-25D9-A13C-4CAD-505E51CE7D6D}"/>
                  </a:ext>
                </a:extLst>
              </p:cNvPr>
              <p:cNvSpPr txBox="1"/>
              <p:nvPr/>
            </p:nvSpPr>
            <p:spPr>
              <a:xfrm>
                <a:off x="8495261" y="-174983"/>
                <a:ext cx="1769069" cy="8264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>
                    <a:solidFill>
                      <a:srgbClr val="C00000"/>
                    </a:solidFill>
                  </a:rPr>
                  <a:t>PKA KI (Veh)</a:t>
                </a:r>
              </a:p>
              <a:p>
                <a:endParaRPr lang="en-GB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6BAFA07B-FC11-D9F9-1D0F-3670BAA7FCAA}"/>
                  </a:ext>
                </a:extLst>
              </p:cNvPr>
              <p:cNvSpPr txBox="1"/>
              <p:nvPr/>
            </p:nvSpPr>
            <p:spPr>
              <a:xfrm>
                <a:off x="2576199" y="-187186"/>
                <a:ext cx="1391968" cy="8264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/>
                  <a:t>WT (Veh)</a:t>
                </a:r>
              </a:p>
              <a:p>
                <a:endParaRPr lang="en-GB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D1D5FCF-B842-DF32-B681-83B17B3ABA60}"/>
                  </a:ext>
                </a:extLst>
              </p:cNvPr>
              <p:cNvSpPr txBox="1"/>
              <p:nvPr/>
            </p:nvSpPr>
            <p:spPr>
              <a:xfrm>
                <a:off x="2624464" y="3095933"/>
                <a:ext cx="1585094" cy="8264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/>
                  <a:t>WT (</a:t>
                </a:r>
                <a:r>
                  <a:rPr lang="en-GB" b="1" dirty="0" err="1"/>
                  <a:t>AngII</a:t>
                </a:r>
                <a:r>
                  <a:rPr lang="en-GB" b="1" dirty="0"/>
                  <a:t>)</a:t>
                </a:r>
              </a:p>
              <a:p>
                <a:endParaRPr lang="en-GB" b="1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7542073-22F3-DA49-D850-105B27F78853}"/>
                  </a:ext>
                </a:extLst>
              </p:cNvPr>
              <p:cNvSpPr txBox="1"/>
              <p:nvPr/>
            </p:nvSpPr>
            <p:spPr>
              <a:xfrm>
                <a:off x="8731181" y="3095933"/>
                <a:ext cx="1989735" cy="8264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>
                    <a:solidFill>
                      <a:srgbClr val="C00000"/>
                    </a:solidFill>
                  </a:rPr>
                  <a:t>PKA KI (</a:t>
                </a:r>
                <a:r>
                  <a:rPr lang="en-GB" b="1" dirty="0" err="1">
                    <a:solidFill>
                      <a:srgbClr val="C00000"/>
                    </a:solidFill>
                  </a:rPr>
                  <a:t>AngII</a:t>
                </a:r>
                <a:r>
                  <a:rPr lang="en-GB" b="1" dirty="0">
                    <a:solidFill>
                      <a:srgbClr val="C00000"/>
                    </a:solidFill>
                  </a:rPr>
                  <a:t>)</a:t>
                </a:r>
              </a:p>
              <a:p>
                <a:endParaRPr lang="en-GB" b="1" dirty="0">
                  <a:solidFill>
                    <a:srgbClr val="C00000"/>
                  </a:solidFill>
                </a:endParaRPr>
              </a:p>
            </p:txBody>
          </p: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8D08CAD-6D9F-DFC3-C4F3-937776315CD0}"/>
                </a:ext>
              </a:extLst>
            </p:cNvPr>
            <p:cNvSpPr txBox="1"/>
            <p:nvPr/>
          </p:nvSpPr>
          <p:spPr>
            <a:xfrm>
              <a:off x="9207271" y="3783849"/>
              <a:ext cx="3074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D</a:t>
              </a:r>
            </a:p>
          </p:txBody>
        </p: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FD7E1A25-CEC5-2FA9-0153-51129587D0CB}"/>
                </a:ext>
              </a:extLst>
            </p:cNvPr>
            <p:cNvGrpSpPr/>
            <p:nvPr/>
          </p:nvGrpSpPr>
          <p:grpSpPr>
            <a:xfrm>
              <a:off x="9336461" y="4287208"/>
              <a:ext cx="2719888" cy="2961428"/>
              <a:chOff x="137083" y="3719193"/>
              <a:chExt cx="2719888" cy="2961428"/>
            </a:xfrm>
          </p:grpSpPr>
          <p:graphicFrame>
            <p:nvGraphicFramePr>
              <p:cNvPr id="13" name="Chart 12">
                <a:extLst>
                  <a:ext uri="{FF2B5EF4-FFF2-40B4-BE49-F238E27FC236}">
                    <a16:creationId xmlns:a16="http://schemas.microsoft.com/office/drawing/2014/main" id="{DB1766A2-A398-7C07-2376-1ECF629DF63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31327594"/>
                  </p:ext>
                </p:extLst>
              </p:nvPr>
            </p:nvGraphicFramePr>
            <p:xfrm>
              <a:off x="137083" y="3719193"/>
              <a:ext cx="2719888" cy="29614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75A337FD-43A7-2945-4FBB-B4E4BCC9BEED}"/>
                  </a:ext>
                </a:extLst>
              </p:cNvPr>
              <p:cNvSpPr/>
              <p:nvPr/>
            </p:nvSpPr>
            <p:spPr>
              <a:xfrm>
                <a:off x="971864" y="3896830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F3088310-DB19-3BB3-F29A-6FC4E08E66E9}"/>
                  </a:ext>
                </a:extLst>
              </p:cNvPr>
              <p:cNvSpPr/>
              <p:nvPr/>
            </p:nvSpPr>
            <p:spPr>
              <a:xfrm>
                <a:off x="971864" y="4021415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7320D95B-89FD-6413-E42A-122D83EFDCA9}"/>
                </a:ext>
              </a:extLst>
            </p:cNvPr>
            <p:cNvGrpSpPr/>
            <p:nvPr/>
          </p:nvGrpSpPr>
          <p:grpSpPr>
            <a:xfrm>
              <a:off x="11832116" y="4221845"/>
              <a:ext cx="2390845" cy="3023476"/>
              <a:chOff x="2632738" y="3653830"/>
              <a:chExt cx="2390845" cy="3023476"/>
            </a:xfrm>
          </p:grpSpPr>
          <p:graphicFrame>
            <p:nvGraphicFramePr>
              <p:cNvPr id="16" name="Chart 15">
                <a:extLst>
                  <a:ext uri="{FF2B5EF4-FFF2-40B4-BE49-F238E27FC236}">
                    <a16:creationId xmlns:a16="http://schemas.microsoft.com/office/drawing/2014/main" id="{A918343F-E549-2534-7D28-A8B87BF702F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9235126"/>
                  </p:ext>
                </p:extLst>
              </p:nvPr>
            </p:nvGraphicFramePr>
            <p:xfrm>
              <a:off x="2632738" y="3653830"/>
              <a:ext cx="2390845" cy="302347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8C4E5888-11E6-04D7-CEB2-AE9ECC60BB3B}"/>
                  </a:ext>
                </a:extLst>
              </p:cNvPr>
              <p:cNvSpPr/>
              <p:nvPr/>
            </p:nvSpPr>
            <p:spPr>
              <a:xfrm>
                <a:off x="3361297" y="3888338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A1DB5A48-0094-8E14-E43B-C2BD6D94E75C}"/>
                  </a:ext>
                </a:extLst>
              </p:cNvPr>
              <p:cNvSpPr/>
              <p:nvPr/>
            </p:nvSpPr>
            <p:spPr>
              <a:xfrm>
                <a:off x="3361297" y="4012923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7EB0E42A-3C11-7512-549A-792E1C5D7233}"/>
                </a:ext>
              </a:extLst>
            </p:cNvPr>
            <p:cNvGrpSpPr/>
            <p:nvPr/>
          </p:nvGrpSpPr>
          <p:grpSpPr>
            <a:xfrm>
              <a:off x="9245385" y="7269969"/>
              <a:ext cx="2719888" cy="3034140"/>
              <a:chOff x="46007" y="6814498"/>
              <a:chExt cx="2719888" cy="3034140"/>
            </a:xfrm>
          </p:grpSpPr>
          <p:graphicFrame>
            <p:nvGraphicFramePr>
              <p:cNvPr id="15" name="Chart 14">
                <a:extLst>
                  <a:ext uri="{FF2B5EF4-FFF2-40B4-BE49-F238E27FC236}">
                    <a16:creationId xmlns:a16="http://schemas.microsoft.com/office/drawing/2014/main" id="{E51D6D3B-6033-99A7-B37D-A60B60D56DD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718471590"/>
                  </p:ext>
                </p:extLst>
              </p:nvPr>
            </p:nvGraphicFramePr>
            <p:xfrm>
              <a:off x="46007" y="6814498"/>
              <a:ext cx="2719888" cy="303414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FEBAF901-24DB-4FCE-C26D-7A6EBD95D71B}"/>
                  </a:ext>
                </a:extLst>
              </p:cNvPr>
              <p:cNvSpPr/>
              <p:nvPr/>
            </p:nvSpPr>
            <p:spPr>
              <a:xfrm>
                <a:off x="776442" y="7015452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371FDFC9-CD4E-6C8F-002F-FAE7FA095B1C}"/>
                  </a:ext>
                </a:extLst>
              </p:cNvPr>
              <p:cNvSpPr/>
              <p:nvPr/>
            </p:nvSpPr>
            <p:spPr>
              <a:xfrm>
                <a:off x="776442" y="7163962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02E2C2B9-EC7D-7EE4-CFF8-8EBCD659A6A6}"/>
                </a:ext>
              </a:extLst>
            </p:cNvPr>
            <p:cNvGrpSpPr/>
            <p:nvPr/>
          </p:nvGrpSpPr>
          <p:grpSpPr>
            <a:xfrm>
              <a:off x="3853694" y="331030"/>
              <a:ext cx="3142808" cy="3517794"/>
              <a:chOff x="3924034" y="83380"/>
              <a:chExt cx="3142808" cy="3517794"/>
            </a:xfrm>
          </p:grpSpPr>
          <p:graphicFrame>
            <p:nvGraphicFramePr>
              <p:cNvPr id="17" name="Chart 16">
                <a:extLst>
                  <a:ext uri="{FF2B5EF4-FFF2-40B4-BE49-F238E27FC236}">
                    <a16:creationId xmlns:a16="http://schemas.microsoft.com/office/drawing/2014/main" id="{6F206A3F-2F30-FA38-735F-D1EFEC48EAD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7884215"/>
                  </p:ext>
                </p:extLst>
              </p:nvPr>
            </p:nvGraphicFramePr>
            <p:xfrm>
              <a:off x="3924034" y="83380"/>
              <a:ext cx="3142808" cy="351779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154324F9-97BA-1D09-0153-32F336FD0984}"/>
                  </a:ext>
                </a:extLst>
              </p:cNvPr>
              <p:cNvSpPr/>
              <p:nvPr/>
            </p:nvSpPr>
            <p:spPr>
              <a:xfrm>
                <a:off x="4891772" y="604414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83865293-23D9-958B-E3D1-215D00CD6F03}"/>
                  </a:ext>
                </a:extLst>
              </p:cNvPr>
              <p:cNvSpPr/>
              <p:nvPr/>
            </p:nvSpPr>
            <p:spPr>
              <a:xfrm>
                <a:off x="4886021" y="775928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BBE8C703-F2A1-3E19-FE67-AAE6F52D87F4}"/>
                </a:ext>
              </a:extLst>
            </p:cNvPr>
            <p:cNvGrpSpPr/>
            <p:nvPr/>
          </p:nvGrpSpPr>
          <p:grpSpPr>
            <a:xfrm>
              <a:off x="6566777" y="471488"/>
              <a:ext cx="3104480" cy="3445295"/>
              <a:chOff x="6580845" y="223838"/>
              <a:chExt cx="3104480" cy="3445295"/>
            </a:xfrm>
          </p:grpSpPr>
          <p:graphicFrame>
            <p:nvGraphicFramePr>
              <p:cNvPr id="18" name="Chart 17">
                <a:extLst>
                  <a:ext uri="{FF2B5EF4-FFF2-40B4-BE49-F238E27FC236}">
                    <a16:creationId xmlns:a16="http://schemas.microsoft.com/office/drawing/2014/main" id="{4664F6E3-039C-0DAF-3C32-124620EBC78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16191096"/>
                  </p:ext>
                </p:extLst>
              </p:nvPr>
            </p:nvGraphicFramePr>
            <p:xfrm>
              <a:off x="6580845" y="223838"/>
              <a:ext cx="3104480" cy="344529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974784F9-4CD2-4571-6D75-697A13C50E32}"/>
                  </a:ext>
                </a:extLst>
              </p:cNvPr>
              <p:cNvSpPr/>
              <p:nvPr/>
            </p:nvSpPr>
            <p:spPr>
              <a:xfrm>
                <a:off x="7378209" y="610165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C9373D36-9DDF-BC6B-E7A5-011F0900678D}"/>
                  </a:ext>
                </a:extLst>
              </p:cNvPr>
              <p:cNvSpPr/>
              <p:nvPr/>
            </p:nvSpPr>
            <p:spPr>
              <a:xfrm>
                <a:off x="7378209" y="758675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C706EBF1-AB28-7FC2-F800-19D3ECDE1EF7}"/>
                </a:ext>
              </a:extLst>
            </p:cNvPr>
            <p:cNvGrpSpPr/>
            <p:nvPr/>
          </p:nvGrpSpPr>
          <p:grpSpPr>
            <a:xfrm>
              <a:off x="9030458" y="378578"/>
              <a:ext cx="3085647" cy="3509249"/>
              <a:chOff x="9044526" y="130928"/>
              <a:chExt cx="3085647" cy="3509249"/>
            </a:xfrm>
          </p:grpSpPr>
          <p:graphicFrame>
            <p:nvGraphicFramePr>
              <p:cNvPr id="21" name="Chart 20">
                <a:extLst>
                  <a:ext uri="{FF2B5EF4-FFF2-40B4-BE49-F238E27FC236}">
                    <a16:creationId xmlns:a16="http://schemas.microsoft.com/office/drawing/2014/main" id="{39B29F1D-5F31-59A2-C1DF-EECA548B90D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27115742"/>
                  </p:ext>
                </p:extLst>
              </p:nvPr>
            </p:nvGraphicFramePr>
            <p:xfrm>
              <a:off x="9044526" y="130928"/>
              <a:ext cx="3085647" cy="350924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0F85FC7F-5FFD-046B-15C4-7DEACA6A9748}"/>
                  </a:ext>
                </a:extLst>
              </p:cNvPr>
              <p:cNvSpPr/>
              <p:nvPr/>
            </p:nvSpPr>
            <p:spPr>
              <a:xfrm>
                <a:off x="9920580" y="592912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C992D4A9-EBB8-DB95-6711-AED419A433DC}"/>
                  </a:ext>
                </a:extLst>
              </p:cNvPr>
              <p:cNvSpPr/>
              <p:nvPr/>
            </p:nvSpPr>
            <p:spPr>
              <a:xfrm>
                <a:off x="9920580" y="747173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25330C93-EEE9-8D4B-BEF3-A4AB251EA491}"/>
                </a:ext>
              </a:extLst>
            </p:cNvPr>
            <p:cNvGrpSpPr/>
            <p:nvPr/>
          </p:nvGrpSpPr>
          <p:grpSpPr>
            <a:xfrm>
              <a:off x="11484948" y="435786"/>
              <a:ext cx="3175649" cy="3363432"/>
              <a:chOff x="11484948" y="188136"/>
              <a:chExt cx="3175649" cy="3363432"/>
            </a:xfrm>
          </p:grpSpPr>
          <p:graphicFrame>
            <p:nvGraphicFramePr>
              <p:cNvPr id="23" name="Chart 22">
                <a:extLst>
                  <a:ext uri="{FF2B5EF4-FFF2-40B4-BE49-F238E27FC236}">
                    <a16:creationId xmlns:a16="http://schemas.microsoft.com/office/drawing/2014/main" id="{719BC05D-DE7F-35D3-4C6C-7C5BFBCC85C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73363970"/>
                  </p:ext>
                </p:extLst>
              </p:nvPr>
            </p:nvGraphicFramePr>
            <p:xfrm>
              <a:off x="11484948" y="188136"/>
              <a:ext cx="3175649" cy="336343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A995CF7F-1A3B-03E1-5A2C-6465E0B63EF3}"/>
                  </a:ext>
                </a:extLst>
              </p:cNvPr>
              <p:cNvSpPr/>
              <p:nvPr/>
            </p:nvSpPr>
            <p:spPr>
              <a:xfrm>
                <a:off x="12428926" y="579328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E919A701-5E7C-5855-AB5E-5F2972536538}"/>
                  </a:ext>
                </a:extLst>
              </p:cNvPr>
              <p:cNvSpPr/>
              <p:nvPr/>
            </p:nvSpPr>
            <p:spPr>
              <a:xfrm>
                <a:off x="12428926" y="727838"/>
                <a:ext cx="68400" cy="684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88955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</TotalTime>
  <Words>316</Words>
  <Application>Microsoft Office PowerPoint</Application>
  <PresentationFormat>Custom</PresentationFormat>
  <Paragraphs>137</Paragraphs>
  <Slides>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Myriad Pro</vt:lpstr>
      <vt:lpstr>Office 2013 - 2022 Theme</vt:lpstr>
      <vt:lpstr>Prism 10</vt:lpstr>
      <vt:lpstr>GraphPad Prism Project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night, Hannah</dc:creator>
  <cp:lastModifiedBy>Olena Rudyk</cp:lastModifiedBy>
  <cp:revision>25</cp:revision>
  <dcterms:created xsi:type="dcterms:W3CDTF">2021-12-21T11:15:09Z</dcterms:created>
  <dcterms:modified xsi:type="dcterms:W3CDTF">2026-03-09T18:45:20Z</dcterms:modified>
</cp:coreProperties>
</file>